
<file path=[Content_Types].xml><?xml version="1.0" encoding="utf-8"?>
<Types xmlns="http://schemas.openxmlformats.org/package/2006/content-types"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E6DC8AE-2302-42EA-A1AA-40268F4D08BC}" v="115" dt="2023-07-19T16:19:30.701"/>
    <p1510:client id="{E1A82C2D-CEA3-4ADD-B72B-8C2A4C688D33}" v="28" dt="2023-07-19T10:57:07.7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7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E1A82C2D-CEA3-4ADD-B72B-8C2A4C688D33}"/>
    <pc:docChg chg="undo redo custSel addSld delSld modSld modMainMaster modNotesMaster">
      <pc:chgData name="JUAN MANUEL LOZANO GIL" userId="618ed11e-cb2c-4b03-8ac9-a8cf52f924c9" providerId="ADAL" clId="{E1A82C2D-CEA3-4ADD-B72B-8C2A4C688D33}" dt="2023-07-19T10:58:11.482" v="367" actId="14100"/>
      <pc:docMkLst>
        <pc:docMk/>
      </pc:docMkLst>
      <pc:sldChg chg="addSp delSp modSp mod modNotes">
        <pc:chgData name="JUAN MANUEL LOZANO GIL" userId="618ed11e-cb2c-4b03-8ac9-a8cf52f924c9" providerId="ADAL" clId="{E1A82C2D-CEA3-4ADD-B72B-8C2A4C688D33}" dt="2023-07-19T10:22:37.401" v="245" actId="1076"/>
        <pc:sldMkLst>
          <pc:docMk/>
          <pc:sldMk cId="3278798907" sldId="256"/>
        </pc:sldMkLst>
        <pc:spChg chg="add mod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9" creationId="{146086C0-B663-8443-F4B7-2719B3DFBC7A}"/>
          </ac:spMkLst>
        </pc:spChg>
        <pc:spChg chg="add mod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21" creationId="{E6FAAC9E-4562-B972-E7DE-16A5145C38A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9" creationId="{6FE0C5C9-EFFF-D8EF-6794-40A8A3B3FDB4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30" creationId="{69A63828-D0E6-C303-7DAB-022683830F6B}"/>
          </ac:spMkLst>
        </pc:spChg>
        <pc:spChg chg="del">
          <ac:chgData name="JUAN MANUEL LOZANO GIL" userId="618ed11e-cb2c-4b03-8ac9-a8cf52f924c9" providerId="ADAL" clId="{E1A82C2D-CEA3-4ADD-B72B-8C2A4C688D33}" dt="2023-07-19T10:04:49.937" v="26" actId="478"/>
          <ac:spMkLst>
            <pc:docMk/>
            <pc:sldMk cId="3278798907" sldId="256"/>
            <ac:spMk id="31" creationId="{EC910EE7-D130-C396-5EB0-59BC79EF144D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2" creationId="{7AACA306-674B-1C70-235C-CCCCACCF8049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3" creationId="{40B58694-FE1E-CCFD-0228-0AA311C76DFA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44" creationId="{BD6261B1-AF8A-600C-86F5-AC0B8B5DEF74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5" creationId="{31A25F3E-6C68-F161-3D0F-F200414B1A3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6" creationId="{3638FD81-EEFB-3605-A26A-B156E0406D02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47" creationId="{BBD7C682-AC1C-3AC2-4AB1-81C157A2132D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8" creationId="{43D45783-35DE-6202-F1E7-93A721736D85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9" creationId="{29E10A20-1F20-FCB7-63FA-D9EDDADD0B1D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50" creationId="{6E9FCBC0-E68F-83A1-B005-C1EF0A517685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1" creationId="{A06224D5-42DC-2220-0691-7BB9BAC19105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2" creationId="{FC76A523-D22C-9CE9-86C0-3291B5E55716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53" creationId="{7F1575BB-08B9-8701-715E-E77B24154E6A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4" creationId="{1865E9DC-E288-5D5B-E8CE-3964A7FF498A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5" creationId="{3340EB4D-D450-3A93-EC03-0A0352BE4422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56" creationId="{48ED9661-A95F-EB2D-3C34-8D798C4666EB}"/>
          </ac:spMkLst>
        </pc:spChg>
        <pc:spChg chg="del">
          <ac:chgData name="JUAN MANUEL LOZANO GIL" userId="618ed11e-cb2c-4b03-8ac9-a8cf52f924c9" providerId="ADAL" clId="{E1A82C2D-CEA3-4ADD-B72B-8C2A4C688D33}" dt="2023-07-19T10:04:43.714" v="22" actId="478"/>
          <ac:spMkLst>
            <pc:docMk/>
            <pc:sldMk cId="3278798907" sldId="256"/>
            <ac:spMk id="57" creationId="{28CA052F-27E2-63EB-F3F6-80FE3D734D00}"/>
          </ac:spMkLst>
        </pc:spChg>
        <pc:spChg chg="del">
          <ac:chgData name="JUAN MANUEL LOZANO GIL" userId="618ed11e-cb2c-4b03-8ac9-a8cf52f924c9" providerId="ADAL" clId="{E1A82C2D-CEA3-4ADD-B72B-8C2A4C688D33}" dt="2023-07-19T10:04:40.730" v="21" actId="478"/>
          <ac:spMkLst>
            <pc:docMk/>
            <pc:sldMk cId="3278798907" sldId="256"/>
            <ac:spMk id="58" creationId="{804C4DA3-BFC8-7599-5D2F-611F69F9E7D6}"/>
          </ac:spMkLst>
        </pc:spChg>
        <pc:spChg chg="del">
          <ac:chgData name="JUAN MANUEL LOZANO GIL" userId="618ed11e-cb2c-4b03-8ac9-a8cf52f924c9" providerId="ADAL" clId="{E1A82C2D-CEA3-4ADD-B72B-8C2A4C688D33}" dt="2023-07-19T10:04:38.970" v="20" actId="478"/>
          <ac:spMkLst>
            <pc:docMk/>
            <pc:sldMk cId="3278798907" sldId="256"/>
            <ac:spMk id="59" creationId="{C16583F2-6CA4-58DD-020E-AF1AA81B75F4}"/>
          </ac:spMkLst>
        </pc:spChg>
        <pc:spChg chg="del">
          <ac:chgData name="JUAN MANUEL LOZANO GIL" userId="618ed11e-cb2c-4b03-8ac9-a8cf52f924c9" providerId="ADAL" clId="{E1A82C2D-CEA3-4ADD-B72B-8C2A4C688D33}" dt="2023-07-19T10:04:45.578" v="23" actId="478"/>
          <ac:spMkLst>
            <pc:docMk/>
            <pc:sldMk cId="3278798907" sldId="256"/>
            <ac:spMk id="62" creationId="{FAEC6570-2D19-B589-D262-D645471A2FA8}"/>
          </ac:spMkLst>
        </pc:spChg>
        <pc:spChg chg="del">
          <ac:chgData name="JUAN MANUEL LOZANO GIL" userId="618ed11e-cb2c-4b03-8ac9-a8cf52f924c9" providerId="ADAL" clId="{E1A82C2D-CEA3-4ADD-B72B-8C2A4C688D33}" dt="2023-07-19T10:04:47.010" v="24" actId="478"/>
          <ac:spMkLst>
            <pc:docMk/>
            <pc:sldMk cId="3278798907" sldId="256"/>
            <ac:spMk id="63" creationId="{A5FAB260-0C17-FE6B-E06E-4D090A964AED}"/>
          </ac:spMkLst>
        </pc:spChg>
        <pc:spChg chg="del">
          <ac:chgData name="JUAN MANUEL LOZANO GIL" userId="618ed11e-cb2c-4b03-8ac9-a8cf52f924c9" providerId="ADAL" clId="{E1A82C2D-CEA3-4ADD-B72B-8C2A4C688D33}" dt="2023-07-19T10:04:48.610" v="25" actId="478"/>
          <ac:spMkLst>
            <pc:docMk/>
            <pc:sldMk cId="3278798907" sldId="256"/>
            <ac:spMk id="64" creationId="{6B5EAE6D-5B4A-9AA1-129A-AAA3DD980E3A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23" creationId="{ADB6E049-3E35-ED91-D48D-5CDE07739EFB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24" creationId="{106C1AF1-94C5-F629-15FD-623F681A8C50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28" creationId="{4DDF8618-B36F-119A-CA7A-EE88C352364F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3" creationId="{F7D03FBE-A81A-6BC4-1C33-3A183B86791D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4" creationId="{913B9BB6-4065-0AE0-54C4-70791E5BB21A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5" creationId="{34F0A8C1-B00F-FC42-FA0E-7F64DFB6A559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6" creationId="{DE770029-C13A-362F-EA6B-452F863DBC8A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9" creationId="{02190607-545A-EAEF-B8B5-30DDD473E609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0" creationId="{71A1120A-ECF7-C944-D0A7-629ED2FD6F5D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1" creationId="{2A665B5F-90E1-1DF7-3916-53928A302641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2" creationId="{0DCE5BAF-A005-6A19-35A8-D034638BD2A3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3" creationId="{9B2CD68D-1162-BD7B-04C0-5EA88A3A3A9E}"/>
          </ac:spMkLst>
        </pc:spChg>
        <pc:spChg chg="del">
          <ac:chgData name="JUAN MANUEL LOZANO GIL" userId="618ed11e-cb2c-4b03-8ac9-a8cf52f924c9" providerId="ADAL" clId="{E1A82C2D-CEA3-4ADD-B72B-8C2A4C688D33}" dt="2023-07-19T10:03:33.114" v="0" actId="478"/>
          <ac:spMkLst>
            <pc:docMk/>
            <pc:sldMk cId="3278798907" sldId="256"/>
            <ac:spMk id="330" creationId="{3B65D7B5-A3E2-577C-C8DD-AA8F8F51F348}"/>
          </ac:spMkLst>
        </pc:spChg>
        <pc:grpChg chg="add mod">
          <ac:chgData name="JUAN MANUEL LOZANO GIL" userId="618ed11e-cb2c-4b03-8ac9-a8cf52f924c9" providerId="ADAL" clId="{E1A82C2D-CEA3-4ADD-B72B-8C2A4C688D33}" dt="2023-07-19T10:22:37.401" v="245" actId="1076"/>
          <ac:grpSpMkLst>
            <pc:docMk/>
            <pc:sldMk cId="3278798907" sldId="256"/>
            <ac:grpSpMk id="7" creationId="{8D97C7FF-949E-1C1F-907C-9204A55EBD96}"/>
          </ac:grpSpMkLst>
        </pc:grpChg>
        <pc:grpChg chg="add mod">
          <ac:chgData name="JUAN MANUEL LOZANO GIL" userId="618ed11e-cb2c-4b03-8ac9-a8cf52f924c9" providerId="ADAL" clId="{E1A82C2D-CEA3-4ADD-B72B-8C2A4C688D33}" dt="2023-07-19T10:08:57.150" v="111" actId="164"/>
          <ac:grpSpMkLst>
            <pc:docMk/>
            <pc:sldMk cId="3278798907" sldId="256"/>
            <ac:grpSpMk id="8" creationId="{0B7F23BE-A6C5-B3EC-2F15-8A0F60252FAF}"/>
          </ac:grpSpMkLst>
        </pc:grpChg>
        <pc:grpChg chg="del">
          <ac:chgData name="JUAN MANUEL LOZANO GIL" userId="618ed11e-cb2c-4b03-8ac9-a8cf52f924c9" providerId="ADAL" clId="{E1A82C2D-CEA3-4ADD-B72B-8C2A4C688D33}" dt="2023-07-19T10:04:07.055" v="13" actId="21"/>
          <ac:grpSpMkLst>
            <pc:docMk/>
            <pc:sldMk cId="3278798907" sldId="256"/>
            <ac:grpSpMk id="12" creationId="{FD2B8B51-4257-7A31-F5BD-6F4E817CE3D7}"/>
          </ac:grpSpMkLst>
        </pc:grpChg>
        <pc:grpChg chg="del mod">
          <ac:chgData name="JUAN MANUEL LOZANO GIL" userId="618ed11e-cb2c-4b03-8ac9-a8cf52f924c9" providerId="ADAL" clId="{E1A82C2D-CEA3-4ADD-B72B-8C2A4C688D33}" dt="2023-07-19T10:07:09.774" v="82" actId="165"/>
          <ac:grpSpMkLst>
            <pc:docMk/>
            <pc:sldMk cId="3278798907" sldId="256"/>
            <ac:grpSpMk id="14" creationId="{A3B00373-ECCE-3F0D-9077-8FAD8A5CD4E7}"/>
          </ac:grpSpMkLst>
        </pc:grpChg>
        <pc:grpChg chg="mod topLvl">
          <ac:chgData name="JUAN MANUEL LOZANO GIL" userId="618ed11e-cb2c-4b03-8ac9-a8cf52f924c9" providerId="ADAL" clId="{E1A82C2D-CEA3-4ADD-B72B-8C2A4C688D33}" dt="2023-07-19T10:22:37.401" v="245" actId="1076"/>
          <ac:grpSpMkLst>
            <pc:docMk/>
            <pc:sldMk cId="3278798907" sldId="256"/>
            <ac:grpSpMk id="20" creationId="{C3D67D48-DBD6-F3C7-14EA-203AA1CEB286}"/>
          </ac:grpSpMkLst>
        </pc:grpChg>
        <pc:grpChg chg="del">
          <ac:chgData name="JUAN MANUEL LOZANO GIL" userId="618ed11e-cb2c-4b03-8ac9-a8cf52f924c9" providerId="ADAL" clId="{E1A82C2D-CEA3-4ADD-B72B-8C2A4C688D33}" dt="2023-07-19T10:03:44.814" v="1" actId="21"/>
          <ac:grpSpMkLst>
            <pc:docMk/>
            <pc:sldMk cId="3278798907" sldId="256"/>
            <ac:grpSpMk id="23" creationId="{C689D05A-6159-D3DD-CE48-3B7FF27422C9}"/>
          </ac:grpSpMkLst>
        </pc:grpChg>
        <pc:grpChg chg="mod">
          <ac:chgData name="JUAN MANUEL LOZANO GIL" userId="618ed11e-cb2c-4b03-8ac9-a8cf52f924c9" providerId="ADAL" clId="{E1A82C2D-CEA3-4ADD-B72B-8C2A4C688D33}" dt="2023-07-19T10:08:57.717" v="113"/>
          <ac:grpSpMkLst>
            <pc:docMk/>
            <pc:sldMk cId="3278798907" sldId="256"/>
            <ac:grpSpMk id="32" creationId="{5121F8BE-6AAD-93AE-7F46-DD245EED2E35}"/>
          </ac:grpSpMkLst>
        </pc:grpChg>
        <pc:grpChg chg="mod topLvl">
          <ac:chgData name="JUAN MANUEL LOZANO GIL" userId="618ed11e-cb2c-4b03-8ac9-a8cf52f924c9" providerId="ADAL" clId="{E1A82C2D-CEA3-4ADD-B72B-8C2A4C688D33}" dt="2023-07-19T10:22:37.401" v="245" actId="1076"/>
          <ac:grpSpMkLst>
            <pc:docMk/>
            <pc:sldMk cId="3278798907" sldId="256"/>
            <ac:grpSpMk id="65" creationId="{A5E5CDB5-C751-0E14-2CF2-8CD6EEB4673D}"/>
          </ac:grpSpMkLst>
        </pc:grpChg>
        <pc:grpChg chg="mod topLvl">
          <ac:chgData name="JUAN MANUEL LOZANO GIL" userId="618ed11e-cb2c-4b03-8ac9-a8cf52f924c9" providerId="ADAL" clId="{E1A82C2D-CEA3-4ADD-B72B-8C2A4C688D33}" dt="2023-07-19T10:08:57.717" v="113"/>
          <ac:grpSpMkLst>
            <pc:docMk/>
            <pc:sldMk cId="3278798907" sldId="256"/>
            <ac:grpSpMk id="204" creationId="{8ACC7B1E-E575-A5C9-001D-648B9DED9431}"/>
          </ac:grpSpMkLst>
        </pc:grpChg>
        <pc:grpChg chg="del mod topLvl">
          <ac:chgData name="JUAN MANUEL LOZANO GIL" userId="618ed11e-cb2c-4b03-8ac9-a8cf52f924c9" providerId="ADAL" clId="{E1A82C2D-CEA3-4ADD-B72B-8C2A4C688D33}" dt="2023-07-19T10:07:20.387" v="83" actId="165"/>
          <ac:grpSpMkLst>
            <pc:docMk/>
            <pc:sldMk cId="3278798907" sldId="256"/>
            <ac:grpSpMk id="219" creationId="{30313194-4B88-D4FC-5F98-5FAD5B936A2E}"/>
          </ac:grpSpMkLst>
        </pc:grpChg>
        <pc:picChg chg="mod topLvl modCrop">
          <ac:chgData name="JUAN MANUEL LOZANO GIL" userId="618ed11e-cb2c-4b03-8ac9-a8cf52f924c9" providerId="ADAL" clId="{E1A82C2D-CEA3-4ADD-B72B-8C2A4C688D33}" dt="2023-07-19T10:22:37.401" v="245" actId="1076"/>
          <ac:picMkLst>
            <pc:docMk/>
            <pc:sldMk cId="3278798907" sldId="256"/>
            <ac:picMk id="13" creationId="{A3918CB1-7E0E-12FB-DEA9-93F0D716FC59}"/>
          </ac:picMkLst>
        </pc:picChg>
        <pc:picChg chg="mod topLvl modCrop">
          <ac:chgData name="JUAN MANUEL LOZANO GIL" userId="618ed11e-cb2c-4b03-8ac9-a8cf52f924c9" providerId="ADAL" clId="{E1A82C2D-CEA3-4ADD-B72B-8C2A4C688D33}" dt="2023-07-19T10:08:57.717" v="113"/>
          <ac:picMkLst>
            <pc:docMk/>
            <pc:sldMk cId="3278798907" sldId="256"/>
            <ac:picMk id="218" creationId="{79CCC012-5C18-36BB-7BFB-CDF561A3F513}"/>
          </ac:picMkLst>
        </pc:pic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5" creationId="{129E63B4-C489-BEB8-4402-11F892A8CF0B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6" creationId="{2BD03A2C-A553-B425-123C-509BB86E89A9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7" creationId="{E9A25BB7-3C06-F81F-C768-BB81B8DBCCCA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8" creationId="{78C4AB6F-D797-1CFE-3B4A-E15CBF255F8B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9" creationId="{8ED8A38E-CC84-360C-366C-FA96E46AE39E}"/>
          </ac:cxnSpMkLst>
        </pc:cxnChg>
        <pc:cxnChg chg="mod topLvl">
          <ac:chgData name="JUAN MANUEL LOZANO GIL" userId="618ed11e-cb2c-4b03-8ac9-a8cf52f924c9" providerId="ADAL" clId="{E1A82C2D-CEA3-4ADD-B72B-8C2A4C688D33}" dt="2023-07-19T10:22:37.401" v="245" actId="1076"/>
          <ac:cxnSpMkLst>
            <pc:docMk/>
            <pc:sldMk cId="3278798907" sldId="256"/>
            <ac:cxnSpMk id="127" creationId="{8839E733-E7A2-2B25-2A5F-F486A05DED28}"/>
          </ac:cxnSpMkLst>
        </pc:cxnChg>
        <pc:cxnChg chg="mod">
          <ac:chgData name="JUAN MANUEL LOZANO GIL" userId="618ed11e-cb2c-4b03-8ac9-a8cf52f924c9" providerId="ADAL" clId="{E1A82C2D-CEA3-4ADD-B72B-8C2A4C688D33}" dt="2023-07-19T10:04:07.055" v="13" actId="21"/>
          <ac:cxnSpMkLst>
            <pc:docMk/>
            <pc:sldMk cId="3278798907" sldId="256"/>
            <ac:cxnSpMk id="183" creationId="{26892D6D-7238-9454-402A-4E8F4570AED3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5" creationId="{740BA44F-D247-349E-363F-65A0FDBE4E40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6" creationId="{7078B968-C719-5F90-98A2-8D1838D02E9A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7" creationId="{4EBF6361-0149-0467-B190-B5CD93833555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8" creationId="{9EF16A84-0776-03ED-FF8A-4557944FE18D}"/>
          </ac:cxnSpMkLst>
        </pc:cxnChg>
      </pc:sldChg>
      <pc:sldChg chg="addSp delSp modSp new del mod">
        <pc:chgData name="JUAN MANUEL LOZANO GIL" userId="618ed11e-cb2c-4b03-8ac9-a8cf52f924c9" providerId="ADAL" clId="{E1A82C2D-CEA3-4ADD-B72B-8C2A4C688D33}" dt="2023-07-19T10:04:27.409" v="19" actId="47"/>
        <pc:sldMkLst>
          <pc:docMk/>
          <pc:sldMk cId="657655474" sldId="257"/>
        </pc:sldMkLst>
        <pc:spChg chg="del">
          <ac:chgData name="JUAN MANUEL LOZANO GIL" userId="618ed11e-cb2c-4b03-8ac9-a8cf52f924c9" providerId="ADAL" clId="{E1A82C2D-CEA3-4ADD-B72B-8C2A4C688D33}" dt="2023-07-19T10:03:47.634" v="3" actId="478"/>
          <ac:spMkLst>
            <pc:docMk/>
            <pc:sldMk cId="657655474" sldId="257"/>
            <ac:spMk id="2" creationId="{800A1122-484B-2A3C-C0CE-768AEFDB229F}"/>
          </ac:spMkLst>
        </pc:spChg>
        <pc:spChg chg="del">
          <ac:chgData name="JUAN MANUEL LOZANO GIL" userId="618ed11e-cb2c-4b03-8ac9-a8cf52f924c9" providerId="ADAL" clId="{E1A82C2D-CEA3-4ADD-B72B-8C2A4C688D33}" dt="2023-07-19T10:03:47.634" v="3" actId="478"/>
          <ac:spMkLst>
            <pc:docMk/>
            <pc:sldMk cId="657655474" sldId="257"/>
            <ac:spMk id="3" creationId="{8983F845-CDCB-E8E2-5481-70C4C4DE771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8" creationId="{13B95DF6-AC6E-32A6-E0CF-80764C83780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4" creationId="{64296D20-BC9E-AC68-7173-7AC8718B7B5E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5" creationId="{6F38B3DE-1E9D-7CC0-651F-B1BB5C1B1A71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6" creationId="{DB8C024E-C177-7355-4492-D71C1CBCBEBB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7" creationId="{2356E297-0235-1843-7B95-6D2320B6ECEB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8" creationId="{919AF038-5971-659C-BB5B-0CD22769FBD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9" creationId="{87E25859-5B28-A8CA-A5D6-B081ED71438D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0" creationId="{AD817CB9-7FBC-57C2-4EF9-FDB0B3D0FDD5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1" creationId="{12DB9528-A010-8B73-8D3D-A1F9B8A435F0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2" creationId="{68737114-D9C9-932C-0B3D-86BC7C67970B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3" creationId="{8558E92D-4995-5D1F-6B6A-12C74644B288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4" creationId="{A6A5E9A4-12A2-91E8-6A13-DAFDA2B77A64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5" creationId="{5B8D7973-C0A6-1DB8-618B-DC624357553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6" creationId="{60A8C35C-71D0-45FC-3ACA-EABA480B63DF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7" creationId="{25006787-46F7-BA6B-5E21-73986F464DC5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8" creationId="{16B8B580-665A-8687-A8B0-97ECF5B70AE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9" creationId="{375B7161-F1EF-DD00-39BD-03D388AD4CD8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0" creationId="{FF00E615-99D3-D640-C607-6738790ED6B7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1" creationId="{2A663975-9145-1DFC-AE48-962A36D14AD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2" creationId="{30C68098-6199-2A55-D301-BDA0940A4F2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3" creationId="{923D6D64-DD6B-9827-DA42-7857F191863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4" creationId="{22A971D7-CDF5-AA83-E53B-8FC57BAE2F8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5" creationId="{FBB9DC96-86E5-1CD0-78D5-316DD8AB9F51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6" creationId="{82779C37-7345-0D8C-863C-6A32EBC8306A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7" creationId="{0FC4A4F2-4FC8-C06A-822D-9C29E16B9125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8" creationId="{F28D6A8F-0C1D-4714-95CB-6E00E6DB6184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9" creationId="{F3480020-B9D7-6F4B-4F3A-B9374205E81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0" creationId="{9A3C3AE8-51BC-A892-6361-F1F05BACC0AA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1" creationId="{767BECB2-FE5E-007E-21A8-124E872CDC0E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2" creationId="{53D78F58-A0B5-B747-CA26-2743B804B4F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3" creationId="{D6E81EB4-8973-7F85-EDE7-18C00069439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4" creationId="{AFDAB819-70B8-963C-66B1-A0CEB4140177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5" creationId="{5CF7CDF4-728A-1C4A-E14E-C7E6A5B61428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6" creationId="{58486834-BE79-0D37-1263-F208E1F6B27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7" creationId="{3A348ABF-8C97-0DD9-E5ED-8C9CD50D880A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8" creationId="{09798B4B-6B67-EBA6-B63C-015680777ABE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9" creationId="{8BDDE868-9749-CBC7-6110-6CB0091BCF3D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0" creationId="{863EEE31-DA9F-FAE2-7A47-66ACC7076F7F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1" creationId="{A362B612-6642-4317-4598-E92B26504FC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2" creationId="{CBC005AC-B79C-D69F-CFDB-799E8F1D66C7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3" creationId="{42A25EC2-C884-C457-EDF5-F6C9E2C1E94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4" creationId="{A208FDB5-5894-61E2-68E1-BCE3356C2040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5" creationId="{4DEDB3A3-4ABB-C974-0C09-B3AA27AEC27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6" creationId="{DA0C6D4E-860B-1550-6137-511809214A3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7" creationId="{E4D56B3E-E89C-DB84-9E21-A589E7BFD44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8" creationId="{E6801279-A728-51EB-88BA-CE9476C82B7C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9" creationId="{168D749A-BB4D-9F45-9B0E-7A125878023C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60" creationId="{09EF38BC-9F80-3C2E-D744-BD5007A5B81F}"/>
          </ac:spMkLst>
        </pc:spChg>
        <pc:grpChg chg="add del mod">
          <ac:chgData name="JUAN MANUEL LOZANO GIL" userId="618ed11e-cb2c-4b03-8ac9-a8cf52f924c9" providerId="ADAL" clId="{E1A82C2D-CEA3-4ADD-B72B-8C2A4C688D33}" dt="2023-07-19T10:04:25.042" v="18" actId="478"/>
          <ac:grpSpMkLst>
            <pc:docMk/>
            <pc:sldMk cId="657655474" sldId="257"/>
            <ac:grpSpMk id="4" creationId="{076C00F7-FD69-5186-B803-20280C92CA1B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5" creationId="{DAE0C129-EF7D-EAD6-1326-A35EE88CC140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7" creationId="{DDAB57F5-FADF-95AE-FEB1-64DEF7BAF674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9" creationId="{A45F0C8D-7AE3-7BF7-0DF2-4B72858E2BC9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10" creationId="{D5332EE4-85D6-3CC8-256A-B6DF748C77B0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11" creationId="{837EFC31-E307-5819-4048-9EC2952E37CF}"/>
          </ac:grpSpMkLst>
        </pc:grpChg>
        <pc:picChg chg="mod">
          <ac:chgData name="JUAN MANUEL LOZANO GIL" userId="618ed11e-cb2c-4b03-8ac9-a8cf52f924c9" providerId="ADAL" clId="{E1A82C2D-CEA3-4ADD-B72B-8C2A4C688D33}" dt="2023-07-19T10:03:48.505" v="4"/>
          <ac:picMkLst>
            <pc:docMk/>
            <pc:sldMk cId="657655474" sldId="257"/>
            <ac:picMk id="6" creationId="{BE2BC3B9-6081-10D0-1670-7FE44754AA15}"/>
          </ac:picMkLst>
        </pc:picChg>
        <pc:cxnChg chg="mod">
          <ac:chgData name="JUAN MANUEL LOZANO GIL" userId="618ed11e-cb2c-4b03-8ac9-a8cf52f924c9" providerId="ADAL" clId="{E1A82C2D-CEA3-4ADD-B72B-8C2A4C688D33}" dt="2023-07-19T10:03:48.505" v="4"/>
          <ac:cxnSpMkLst>
            <pc:docMk/>
            <pc:sldMk cId="657655474" sldId="257"/>
            <ac:cxnSpMk id="12" creationId="{85A79910-A1F8-F4E4-2B64-55271DF270E3}"/>
          </ac:cxnSpMkLst>
        </pc:cxnChg>
        <pc:cxnChg chg="mod">
          <ac:chgData name="JUAN MANUEL LOZANO GIL" userId="618ed11e-cb2c-4b03-8ac9-a8cf52f924c9" providerId="ADAL" clId="{E1A82C2D-CEA3-4ADD-B72B-8C2A4C688D33}" dt="2023-07-19T10:03:48.505" v="4"/>
          <ac:cxnSpMkLst>
            <pc:docMk/>
            <pc:sldMk cId="657655474" sldId="257"/>
            <ac:cxnSpMk id="13" creationId="{F4187C01-CD97-ABFD-340A-6D7C0167F857}"/>
          </ac:cxnSpMkLst>
        </pc:cxnChg>
      </pc:sldChg>
      <pc:sldChg chg="addSp delSp modSp new mod">
        <pc:chgData name="JUAN MANUEL LOZANO GIL" userId="618ed11e-cb2c-4b03-8ac9-a8cf52f924c9" providerId="ADAL" clId="{E1A82C2D-CEA3-4ADD-B72B-8C2A4C688D33}" dt="2023-07-19T10:58:11.482" v="367" actId="14100"/>
        <pc:sldMkLst>
          <pc:docMk/>
          <pc:sldMk cId="2860491393" sldId="258"/>
        </pc:sldMkLst>
        <pc:spChg chg="del">
          <ac:chgData name="JUAN MANUEL LOZANO GIL" userId="618ed11e-cb2c-4b03-8ac9-a8cf52f924c9" providerId="ADAL" clId="{E1A82C2D-CEA3-4ADD-B72B-8C2A4C688D33}" dt="2023-07-19T10:04:11.161" v="15" actId="478"/>
          <ac:spMkLst>
            <pc:docMk/>
            <pc:sldMk cId="2860491393" sldId="258"/>
            <ac:spMk id="2" creationId="{5E41A4A5-BA38-A7C0-732D-177ECF774E7F}"/>
          </ac:spMkLst>
        </pc:spChg>
        <pc:spChg chg="add mod">
          <ac:chgData name="JUAN MANUEL LOZANO GIL" userId="618ed11e-cb2c-4b03-8ac9-a8cf52f924c9" providerId="ADAL" clId="{E1A82C2D-CEA3-4ADD-B72B-8C2A4C688D33}" dt="2023-07-19T10:56:30.955" v="247" actId="1076"/>
          <ac:spMkLst>
            <pc:docMk/>
            <pc:sldMk cId="2860491393" sldId="258"/>
            <ac:spMk id="2" creationId="{F9D90965-11B9-B89A-CD49-86E9DC7AC05E}"/>
          </ac:spMkLst>
        </pc:spChg>
        <pc:spChg chg="add mod">
          <ac:chgData name="JUAN MANUEL LOZANO GIL" userId="618ed11e-cb2c-4b03-8ac9-a8cf52f924c9" providerId="ADAL" clId="{E1A82C2D-CEA3-4ADD-B72B-8C2A4C688D33}" dt="2023-07-19T10:56:30.955" v="247" actId="1076"/>
          <ac:spMkLst>
            <pc:docMk/>
            <pc:sldMk cId="2860491393" sldId="258"/>
            <ac:spMk id="3" creationId="{79A126E4-6F4C-074D-2CDC-4BD9DF390A42}"/>
          </ac:spMkLst>
        </pc:spChg>
        <pc:spChg chg="del">
          <ac:chgData name="JUAN MANUEL LOZANO GIL" userId="618ed11e-cb2c-4b03-8ac9-a8cf52f924c9" providerId="ADAL" clId="{E1A82C2D-CEA3-4ADD-B72B-8C2A4C688D33}" dt="2023-07-19T10:04:11.161" v="15" actId="478"/>
          <ac:spMkLst>
            <pc:docMk/>
            <pc:sldMk cId="2860491393" sldId="258"/>
            <ac:spMk id="3" creationId="{CCCAEE68-9E15-A899-76F6-6D9A524823ED}"/>
          </ac:spMkLst>
        </pc:spChg>
        <pc:spChg chg="add mod">
          <ac:chgData name="JUAN MANUEL LOZANO GIL" userId="618ed11e-cb2c-4b03-8ac9-a8cf52f924c9" providerId="ADAL" clId="{E1A82C2D-CEA3-4ADD-B72B-8C2A4C688D33}" dt="2023-07-19T10:56:36.425" v="248" actId="1076"/>
          <ac:spMkLst>
            <pc:docMk/>
            <pc:sldMk cId="2860491393" sldId="258"/>
            <ac:spMk id="4" creationId="{1B8E72D8-1892-3747-D63B-9CEE1596979D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6" creationId="{87336119-D584-C803-7DA7-B285C21A5862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7" creationId="{DFC1C928-B58C-5B39-6A36-94B095AF7742}"/>
          </ac:spMkLst>
        </pc:spChg>
        <pc:spChg chg="add mod">
          <ac:chgData name="JUAN MANUEL LOZANO GIL" userId="618ed11e-cb2c-4b03-8ac9-a8cf52f924c9" providerId="ADAL" clId="{E1A82C2D-CEA3-4ADD-B72B-8C2A4C688D33}" dt="2023-07-19T10:57:35.250" v="363" actId="20577"/>
          <ac:spMkLst>
            <pc:docMk/>
            <pc:sldMk cId="2860491393" sldId="258"/>
            <ac:spMk id="8" creationId="{5773C4E2-C6E0-2569-F388-9FC50316B98D}"/>
          </ac:spMkLst>
        </pc:spChg>
        <pc:spChg chg="del mod">
          <ac:chgData name="JUAN MANUEL LOZANO GIL" userId="618ed11e-cb2c-4b03-8ac9-a8cf52f924c9" providerId="ADAL" clId="{E1A82C2D-CEA3-4ADD-B72B-8C2A4C688D33}" dt="2023-07-19T10:09:26.561" v="123" actId="478"/>
          <ac:spMkLst>
            <pc:docMk/>
            <pc:sldMk cId="2860491393" sldId="258"/>
            <ac:spMk id="8" creationId="{98E41257-3ED5-73D0-F8C2-6A17DF48BA45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9" creationId="{212ED726-7A90-A745-4B8C-A235A7C7A7AD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0" creationId="{ED2B8D90-DDC0-18CA-4ADE-49ED80D89D0C}"/>
          </ac:spMkLst>
        </pc:spChg>
        <pc:spChg chg="del mod">
          <ac:chgData name="JUAN MANUEL LOZANO GIL" userId="618ed11e-cb2c-4b03-8ac9-a8cf52f924c9" providerId="ADAL" clId="{E1A82C2D-CEA3-4ADD-B72B-8C2A4C688D33}" dt="2023-07-19T10:09:27.961" v="124" actId="478"/>
          <ac:spMkLst>
            <pc:docMk/>
            <pc:sldMk cId="2860491393" sldId="258"/>
            <ac:spMk id="11" creationId="{C8A953EE-EF13-F88B-401B-B0F5F029A744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2" creationId="{1901EB10-0267-51F1-3E8E-B92CA8345349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3" creationId="{89944078-0670-9E61-4EE3-C9F0F12D0445}"/>
          </ac:spMkLst>
        </pc:spChg>
        <pc:spChg chg="del mod">
          <ac:chgData name="JUAN MANUEL LOZANO GIL" userId="618ed11e-cb2c-4b03-8ac9-a8cf52f924c9" providerId="ADAL" clId="{E1A82C2D-CEA3-4ADD-B72B-8C2A4C688D33}" dt="2023-07-19T10:09:29.523" v="125" actId="478"/>
          <ac:spMkLst>
            <pc:docMk/>
            <pc:sldMk cId="2860491393" sldId="258"/>
            <ac:spMk id="14" creationId="{4E370508-864A-64BD-90B4-F64BEB8BDD36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5" creationId="{111DD018-B35B-46AF-D271-B4D5562EB4EC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6" creationId="{EF85D84E-9936-A6B4-8EB3-4B8746D40B27}"/>
          </ac:spMkLst>
        </pc:spChg>
        <pc:spChg chg="del mod">
          <ac:chgData name="JUAN MANUEL LOZANO GIL" userId="618ed11e-cb2c-4b03-8ac9-a8cf52f924c9" providerId="ADAL" clId="{E1A82C2D-CEA3-4ADD-B72B-8C2A4C688D33}" dt="2023-07-19T10:09:30.898" v="126" actId="478"/>
          <ac:spMkLst>
            <pc:docMk/>
            <pc:sldMk cId="2860491393" sldId="258"/>
            <ac:spMk id="17" creationId="{0080B20F-9FAA-A4DD-840A-AB071DE95046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8" creationId="{6F29A7E9-B002-6434-C9AC-4FB140B133D5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9" creationId="{14C537EF-4122-C74C-20BE-787C651BFE3F}"/>
          </ac:spMkLst>
        </pc:spChg>
        <pc:spChg chg="del mod">
          <ac:chgData name="JUAN MANUEL LOZANO GIL" userId="618ed11e-cb2c-4b03-8ac9-a8cf52f924c9" providerId="ADAL" clId="{E1A82C2D-CEA3-4ADD-B72B-8C2A4C688D33}" dt="2023-07-19T10:09:32.994" v="127" actId="478"/>
          <ac:spMkLst>
            <pc:docMk/>
            <pc:sldMk cId="2860491393" sldId="258"/>
            <ac:spMk id="20" creationId="{2A97856B-FA77-4C3C-A340-BBDB0F4EE837}"/>
          </ac:spMkLst>
        </pc:spChg>
        <pc:spChg chg="del mod">
          <ac:chgData name="JUAN MANUEL LOZANO GIL" userId="618ed11e-cb2c-4b03-8ac9-a8cf52f924c9" providerId="ADAL" clId="{E1A82C2D-CEA3-4ADD-B72B-8C2A4C688D33}" dt="2023-07-19T10:09:19.242" v="117" actId="478"/>
          <ac:spMkLst>
            <pc:docMk/>
            <pc:sldMk cId="2860491393" sldId="258"/>
            <ac:spMk id="21" creationId="{C6C043D2-62FE-FC07-4845-6B8D27368A44}"/>
          </ac:spMkLst>
        </pc:spChg>
        <pc:spChg chg="del mod">
          <ac:chgData name="JUAN MANUEL LOZANO GIL" userId="618ed11e-cb2c-4b03-8ac9-a8cf52f924c9" providerId="ADAL" clId="{E1A82C2D-CEA3-4ADD-B72B-8C2A4C688D33}" dt="2023-07-19T10:09:17.817" v="116" actId="478"/>
          <ac:spMkLst>
            <pc:docMk/>
            <pc:sldMk cId="2860491393" sldId="258"/>
            <ac:spMk id="22" creationId="{32B4C6D8-0C95-D7DC-6C75-E53776D1CEF1}"/>
          </ac:spMkLst>
        </pc:spChg>
        <pc:spChg chg="del mod">
          <ac:chgData name="JUAN MANUEL LOZANO GIL" userId="618ed11e-cb2c-4b03-8ac9-a8cf52f924c9" providerId="ADAL" clId="{E1A82C2D-CEA3-4ADD-B72B-8C2A4C688D33}" dt="2023-07-19T10:09:15.913" v="115" actId="478"/>
          <ac:spMkLst>
            <pc:docMk/>
            <pc:sldMk cId="2860491393" sldId="258"/>
            <ac:spMk id="23" creationId="{4958475B-2CC1-4546-9427-8DA29BB3618C}"/>
          </ac:spMkLst>
        </pc:spChg>
        <pc:spChg chg="del mod">
          <ac:chgData name="JUAN MANUEL LOZANO GIL" userId="618ed11e-cb2c-4b03-8ac9-a8cf52f924c9" providerId="ADAL" clId="{E1A82C2D-CEA3-4ADD-B72B-8C2A4C688D33}" dt="2023-07-19T10:09:21.922" v="119" actId="478"/>
          <ac:spMkLst>
            <pc:docMk/>
            <pc:sldMk cId="2860491393" sldId="258"/>
            <ac:spMk id="24" creationId="{5FAF6B05-8EE4-0CF5-53EF-829995739CE5}"/>
          </ac:spMkLst>
        </pc:spChg>
        <pc:spChg chg="del mod">
          <ac:chgData name="JUAN MANUEL LOZANO GIL" userId="618ed11e-cb2c-4b03-8ac9-a8cf52f924c9" providerId="ADAL" clId="{E1A82C2D-CEA3-4ADD-B72B-8C2A4C688D33}" dt="2023-07-19T10:09:20.409" v="118" actId="478"/>
          <ac:spMkLst>
            <pc:docMk/>
            <pc:sldMk cId="2860491393" sldId="258"/>
            <ac:spMk id="25" creationId="{027B4904-E349-D199-F83F-FB02D5CBE2F1}"/>
          </ac:spMkLst>
        </pc:spChg>
        <pc:spChg chg="del mod">
          <ac:chgData name="JUAN MANUEL LOZANO GIL" userId="618ed11e-cb2c-4b03-8ac9-a8cf52f924c9" providerId="ADAL" clId="{E1A82C2D-CEA3-4ADD-B72B-8C2A4C688D33}" dt="2023-07-19T10:09:23.849" v="121" actId="478"/>
          <ac:spMkLst>
            <pc:docMk/>
            <pc:sldMk cId="2860491393" sldId="258"/>
            <ac:spMk id="26" creationId="{7F15FCC1-DF59-7A57-A28F-77ADE8DB256D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28" creationId="{0C3DE269-C139-498D-2E2F-B9880FAF1A5B}"/>
          </ac:spMkLst>
        </pc:spChg>
        <pc:spChg chg="mod topLvl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29" creationId="{D3DB174C-10F2-F6E0-AA63-4002509948D3}"/>
          </ac:spMkLst>
        </pc:spChg>
        <pc:spChg chg="mod topLvl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32" creationId="{0DDAFD28-20F1-385F-18AB-284038AAE9B0}"/>
          </ac:spMkLst>
        </pc:spChg>
        <pc:spChg chg="mod topLvl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36" creationId="{7B5E06C9-E8AC-F79B-49C0-62474A6786F2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38" creationId="{00188FDE-CA41-410D-E08E-E8D3367643A5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39" creationId="{DC21415E-6453-1A82-1604-603DC3D60727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0" creationId="{FA2C3190-C79E-9910-7663-4976DD6A2BF0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1" creationId="{5FE59B0F-AA69-2091-5CA8-90EDDF1F6632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2" creationId="{EB15988B-5F2B-820D-ADE2-D46AEA7E8F56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7" creationId="{B8994DA2-EAD8-5FD1-0F50-BFAD4C5113B9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8" creationId="{F411CD92-9E55-61B7-7816-75760D40E348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9" creationId="{BF76BA7C-92C5-C1F6-B293-AEED1A1599D3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53" creationId="{B841DFBC-3206-9213-1131-051CE9803F4A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54" creationId="{1EFF6E1B-BCF1-9006-0458-C202BFC32981}"/>
          </ac:spMkLst>
        </pc:spChg>
        <pc:spChg chg="del mod">
          <ac:chgData name="JUAN MANUEL LOZANO GIL" userId="618ed11e-cb2c-4b03-8ac9-a8cf52f924c9" providerId="ADAL" clId="{E1A82C2D-CEA3-4ADD-B72B-8C2A4C688D33}" dt="2023-07-19T10:09:25.265" v="122" actId="478"/>
          <ac:spMkLst>
            <pc:docMk/>
            <pc:sldMk cId="2860491393" sldId="258"/>
            <ac:spMk id="55" creationId="{01AE80C0-4C9E-F924-D075-C7F1B1B925EC}"/>
          </ac:spMkLst>
        </pc:spChg>
        <pc:spChg chg="add mod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58" creationId="{DA9C0367-C746-1F75-B0CD-30C330BFC6E4}"/>
          </ac:spMkLst>
        </pc:spChg>
        <pc:spChg chg="add mod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59" creationId="{828D087D-B454-4477-E550-E31F2A808496}"/>
          </ac:spMkLst>
        </pc:spChg>
        <pc:spChg chg="add mod">
          <ac:chgData name="JUAN MANUEL LOZANO GIL" userId="618ed11e-cb2c-4b03-8ac9-a8cf52f924c9" providerId="ADAL" clId="{E1A82C2D-CEA3-4ADD-B72B-8C2A4C688D33}" dt="2023-07-19T10:13:27.635" v="187" actId="164"/>
          <ac:spMkLst>
            <pc:docMk/>
            <pc:sldMk cId="2860491393" sldId="258"/>
            <ac:spMk id="62" creationId="{1BD1084E-A646-D01B-7C11-3C05FA8364BC}"/>
          </ac:spMkLst>
        </pc:spChg>
        <pc:spChg chg="add mod">
          <ac:chgData name="JUAN MANUEL LOZANO GIL" userId="618ed11e-cb2c-4b03-8ac9-a8cf52f924c9" providerId="ADAL" clId="{E1A82C2D-CEA3-4ADD-B72B-8C2A4C688D33}" dt="2023-07-19T10:13:27.635" v="187" actId="164"/>
          <ac:spMkLst>
            <pc:docMk/>
            <pc:sldMk cId="2860491393" sldId="258"/>
            <ac:spMk id="63" creationId="{11C42550-096C-B696-7B08-DF1AC037E0CF}"/>
          </ac:spMkLst>
        </pc:spChg>
        <pc:spChg chg="add mod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65" creationId="{F064E958-1712-56DF-238F-E2F035C4367C}"/>
          </ac:spMkLst>
        </pc:spChg>
        <pc:spChg chg="add mod">
          <ac:chgData name="JUAN MANUEL LOZANO GIL" userId="618ed11e-cb2c-4b03-8ac9-a8cf52f924c9" providerId="ADAL" clId="{E1A82C2D-CEA3-4ADD-B72B-8C2A4C688D33}" dt="2023-07-19T10:58:11.482" v="367" actId="14100"/>
          <ac:spMkLst>
            <pc:docMk/>
            <pc:sldMk cId="2860491393" sldId="258"/>
            <ac:spMk id="66" creationId="{F4FF40EB-946E-3A6B-20C7-F4FD333134CA}"/>
          </ac:spMkLst>
        </pc:spChg>
        <pc:spChg chg="add mod">
          <ac:chgData name="JUAN MANUEL LOZANO GIL" userId="618ed11e-cb2c-4b03-8ac9-a8cf52f924c9" providerId="ADAL" clId="{E1A82C2D-CEA3-4ADD-B72B-8C2A4C688D33}" dt="2023-07-19T10:58:07.490" v="366" actId="14100"/>
          <ac:spMkLst>
            <pc:docMk/>
            <pc:sldMk cId="2860491393" sldId="258"/>
            <ac:spMk id="67" creationId="{7F152798-73F4-22FF-0EE5-BFD03457299F}"/>
          </ac:spMkLst>
        </pc:spChg>
        <pc:grpChg chg="add del mod">
          <ac:chgData name="JUAN MANUEL LOZANO GIL" userId="618ed11e-cb2c-4b03-8ac9-a8cf52f924c9" providerId="ADAL" clId="{E1A82C2D-CEA3-4ADD-B72B-8C2A4C688D33}" dt="2023-07-19T10:13:49.085" v="198" actId="165"/>
          <ac:grpSpMkLst>
            <pc:docMk/>
            <pc:sldMk cId="2860491393" sldId="258"/>
            <ac:grpSpMk id="4" creationId="{D2FFFCF0-8474-A914-5171-7A2F11C0393C}"/>
          </ac:grpSpMkLst>
        </pc:grpChg>
        <pc:grpChg chg="mod topLvl">
          <ac:chgData name="JUAN MANUEL LOZANO GIL" userId="618ed11e-cb2c-4b03-8ac9-a8cf52f924c9" providerId="ADAL" clId="{E1A82C2D-CEA3-4ADD-B72B-8C2A4C688D33}" dt="2023-07-19T10:22:04.569" v="242" actId="164"/>
          <ac:grpSpMkLst>
            <pc:docMk/>
            <pc:sldMk cId="2860491393" sldId="258"/>
            <ac:grpSpMk id="5" creationId="{CC8D6B1B-11E6-E58F-DB82-3C3805254A4C}"/>
          </ac:grpSpMkLst>
        </pc:grpChg>
        <pc:grpChg chg="mod topLvl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31" creationId="{E2CAE058-47B3-DC66-5560-FA2CD01F9303}"/>
          </ac:grpSpMkLst>
        </pc:grpChg>
        <pc:grpChg chg="mod topLvl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33" creationId="{20BDCBC8-51D1-41FD-88D5-43AEEA46DA21}"/>
          </ac:grpSpMkLst>
        </pc:grpChg>
        <pc:grpChg chg="mod">
          <ac:chgData name="JUAN MANUEL LOZANO GIL" userId="618ed11e-cb2c-4b03-8ac9-a8cf52f924c9" providerId="ADAL" clId="{E1A82C2D-CEA3-4ADD-B72B-8C2A4C688D33}" dt="2023-07-19T10:13:49.085" v="198" actId="165"/>
          <ac:grpSpMkLst>
            <pc:docMk/>
            <pc:sldMk cId="2860491393" sldId="258"/>
            <ac:grpSpMk id="37" creationId="{05507EE9-8901-FE84-2A55-94756AAE124F}"/>
          </ac:grpSpMkLst>
        </pc:grpChg>
        <pc:grpChg chg="mod">
          <ac:chgData name="JUAN MANUEL LOZANO GIL" userId="618ed11e-cb2c-4b03-8ac9-a8cf52f924c9" providerId="ADAL" clId="{E1A82C2D-CEA3-4ADD-B72B-8C2A4C688D33}" dt="2023-07-19T10:13:49.085" v="198" actId="165"/>
          <ac:grpSpMkLst>
            <pc:docMk/>
            <pc:sldMk cId="2860491393" sldId="258"/>
            <ac:grpSpMk id="46" creationId="{7136ED82-5400-9726-CB49-085643C6F2B8}"/>
          </ac:grpSpMkLst>
        </pc:grpChg>
        <pc:grpChg chg="add mod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64" creationId="{A6FE1016-2A3F-AC26-ED41-361693AB8198}"/>
          </ac:grpSpMkLst>
        </pc:grpChg>
        <pc:grpChg chg="add mod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68" creationId="{EDE8E204-7F0E-208F-EB7A-81EFD0FE618B}"/>
          </ac:grpSpMkLst>
        </pc:grpChg>
        <pc:picChg chg="mod topLvl modCrop">
          <ac:chgData name="JUAN MANUEL LOZANO GIL" userId="618ed11e-cb2c-4b03-8ac9-a8cf52f924c9" providerId="ADAL" clId="{E1A82C2D-CEA3-4ADD-B72B-8C2A4C688D33}" dt="2023-07-19T10:57:56.171" v="364" actId="732"/>
          <ac:picMkLst>
            <pc:docMk/>
            <pc:sldMk cId="2860491393" sldId="258"/>
            <ac:picMk id="30" creationId="{CC5382B6-4F70-EC2E-215A-07B1AC046252}"/>
          </ac:picMkLst>
        </pc:picChg>
        <pc:picChg chg="mod topLvl modCrop">
          <ac:chgData name="JUAN MANUEL LOZANO GIL" userId="618ed11e-cb2c-4b03-8ac9-a8cf52f924c9" providerId="ADAL" clId="{E1A82C2D-CEA3-4ADD-B72B-8C2A4C688D33}" dt="2023-07-19T10:22:33.210" v="244" actId="1076"/>
          <ac:picMkLst>
            <pc:docMk/>
            <pc:sldMk cId="2860491393" sldId="258"/>
            <ac:picMk id="34" creationId="{92ECEA78-A2D2-3378-562F-27F11BF467A7}"/>
          </ac:picMkLst>
        </pc:picChg>
        <pc:picChg chg="mod topLvl modCrop">
          <ac:chgData name="JUAN MANUEL LOZANO GIL" userId="618ed11e-cb2c-4b03-8ac9-a8cf52f924c9" providerId="ADAL" clId="{E1A82C2D-CEA3-4ADD-B72B-8C2A4C688D33}" dt="2023-07-19T10:58:03.234" v="365" actId="732"/>
          <ac:picMkLst>
            <pc:docMk/>
            <pc:sldMk cId="2860491393" sldId="258"/>
            <ac:picMk id="35" creationId="{BE0F3318-E226-9648-0369-3F5D1C87D6F4}"/>
          </ac:picMkLst>
        </pc:picChg>
        <pc:cxnChg chg="add mod">
          <ac:chgData name="JUAN MANUEL LOZANO GIL" userId="618ed11e-cb2c-4b03-8ac9-a8cf52f924c9" providerId="ADAL" clId="{E1A82C2D-CEA3-4ADD-B72B-8C2A4C688D33}" dt="2023-07-19T10:57:06.275" v="256" actId="1036"/>
          <ac:cxnSpMkLst>
            <pc:docMk/>
            <pc:sldMk cId="2860491393" sldId="258"/>
            <ac:cxnSpMk id="11" creationId="{9D73E918-DCA0-2DF1-ED2B-404242F0910A}"/>
          </ac:cxnSpMkLst>
        </pc:cxnChg>
        <pc:cxnChg chg="add mod">
          <ac:chgData name="JUAN MANUEL LOZANO GIL" userId="618ed11e-cb2c-4b03-8ac9-a8cf52f924c9" providerId="ADAL" clId="{E1A82C2D-CEA3-4ADD-B72B-8C2A4C688D33}" dt="2023-07-19T10:57:06.275" v="256" actId="1036"/>
          <ac:cxnSpMkLst>
            <pc:docMk/>
            <pc:sldMk cId="2860491393" sldId="258"/>
            <ac:cxnSpMk id="14" creationId="{9F48C4E8-6221-156B-0F41-51A23DD54686}"/>
          </ac:cxnSpMkLst>
        </pc:cxnChg>
        <pc:cxnChg chg="add mod">
          <ac:chgData name="JUAN MANUEL LOZANO GIL" userId="618ed11e-cb2c-4b03-8ac9-a8cf52f924c9" providerId="ADAL" clId="{E1A82C2D-CEA3-4ADD-B72B-8C2A4C688D33}" dt="2023-07-19T10:57:21.155" v="296" actId="1036"/>
          <ac:cxnSpMkLst>
            <pc:docMk/>
            <pc:sldMk cId="2860491393" sldId="258"/>
            <ac:cxnSpMk id="17" creationId="{7470D822-AB04-7F40-7F52-468FF9E0B50F}"/>
          </ac:cxnSpMkLst>
        </pc:cxnChg>
        <pc:cxnChg chg="add mod">
          <ac:chgData name="JUAN MANUEL LOZANO GIL" userId="618ed11e-cb2c-4b03-8ac9-a8cf52f924c9" providerId="ADAL" clId="{E1A82C2D-CEA3-4ADD-B72B-8C2A4C688D33}" dt="2023-07-19T10:57:30.395" v="361" actId="1036"/>
          <ac:cxnSpMkLst>
            <pc:docMk/>
            <pc:sldMk cId="2860491393" sldId="258"/>
            <ac:cxnSpMk id="20" creationId="{1EFDB093-4404-6E5A-ACE2-0A12877D5822}"/>
          </ac:cxnSpMkLst>
        </pc:cxnChg>
        <pc:cxnChg chg="mod topLvl">
          <ac:chgData name="JUAN MANUEL LOZANO GIL" userId="618ed11e-cb2c-4b03-8ac9-a8cf52f924c9" providerId="ADAL" clId="{E1A82C2D-CEA3-4ADD-B72B-8C2A4C688D33}" dt="2023-07-19T10:22:04.569" v="242" actId="164"/>
          <ac:cxnSpMkLst>
            <pc:docMk/>
            <pc:sldMk cId="2860491393" sldId="258"/>
            <ac:cxnSpMk id="27" creationId="{186F89D3-D222-0730-62F8-0B6F3E9908AC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43" creationId="{E3AB3F25-4D10-4C3D-C0DE-CD23D0F63C10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44" creationId="{D7F45660-667C-46A6-C412-CE619C680D4A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45" creationId="{4722DD0C-E762-4059-8AB1-E60316CF1F81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50" creationId="{EE321CE7-6324-8E19-B0BB-818ACE86D567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51" creationId="{BE8F1F3D-25CF-C932-C5CD-8027BC0C7650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52" creationId="{1D5337B2-EE45-01E8-0E83-7C7E11C4505C}"/>
          </ac:cxnSpMkLst>
        </pc:cxnChg>
        <pc:cxnChg chg="add mod">
          <ac:chgData name="JUAN MANUEL LOZANO GIL" userId="618ed11e-cb2c-4b03-8ac9-a8cf52f924c9" providerId="ADAL" clId="{E1A82C2D-CEA3-4ADD-B72B-8C2A4C688D33}" dt="2023-07-19T10:22:33.210" v="244" actId="1076"/>
          <ac:cxnSpMkLst>
            <pc:docMk/>
            <pc:sldMk cId="2860491393" sldId="258"/>
            <ac:cxnSpMk id="56" creationId="{F58A9D6E-16BB-2EB5-1515-F0583110A374}"/>
          </ac:cxnSpMkLst>
        </pc:cxnChg>
        <pc:cxnChg chg="add mod">
          <ac:chgData name="JUAN MANUEL LOZANO GIL" userId="618ed11e-cb2c-4b03-8ac9-a8cf52f924c9" providerId="ADAL" clId="{E1A82C2D-CEA3-4ADD-B72B-8C2A4C688D33}" dt="2023-07-19T10:22:33.210" v="244" actId="1076"/>
          <ac:cxnSpMkLst>
            <pc:docMk/>
            <pc:sldMk cId="2860491393" sldId="258"/>
            <ac:cxnSpMk id="57" creationId="{68460041-6498-1223-9006-01C8ADFE6EB9}"/>
          </ac:cxnSpMkLst>
        </pc:cxnChg>
        <pc:cxnChg chg="add mod">
          <ac:chgData name="JUAN MANUEL LOZANO GIL" userId="618ed11e-cb2c-4b03-8ac9-a8cf52f924c9" providerId="ADAL" clId="{E1A82C2D-CEA3-4ADD-B72B-8C2A4C688D33}" dt="2023-07-19T10:13:27.635" v="187" actId="164"/>
          <ac:cxnSpMkLst>
            <pc:docMk/>
            <pc:sldMk cId="2860491393" sldId="258"/>
            <ac:cxnSpMk id="60" creationId="{9CDADBC7-925D-21BE-C3DE-DAAD8599AD49}"/>
          </ac:cxnSpMkLst>
        </pc:cxnChg>
        <pc:cxnChg chg="add mod">
          <ac:chgData name="JUAN MANUEL LOZANO GIL" userId="618ed11e-cb2c-4b03-8ac9-a8cf52f924c9" providerId="ADAL" clId="{E1A82C2D-CEA3-4ADD-B72B-8C2A4C688D33}" dt="2023-07-19T10:13:27.635" v="187" actId="164"/>
          <ac:cxnSpMkLst>
            <pc:docMk/>
            <pc:sldMk cId="2860491393" sldId="258"/>
            <ac:cxnSpMk id="61" creationId="{3F57266D-F57A-985B-D335-622D8C902424}"/>
          </ac:cxnSpMkLst>
        </pc:cxnChg>
      </pc:sldChg>
      <pc:sldMasterChg chg="modSp modSldLayout">
        <pc:chgData name="JUAN MANUEL LOZANO GIL" userId="618ed11e-cb2c-4b03-8ac9-a8cf52f924c9" providerId="ADAL" clId="{E1A82C2D-CEA3-4ADD-B72B-8C2A4C688D33}" dt="2023-07-19T10:05:43.142" v="40"/>
        <pc:sldMasterMkLst>
          <pc:docMk/>
          <pc:sldMasterMk cId="3039592353" sldId="2147483648"/>
        </pc:sldMasterMkLst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2" creationId="{D0640B11-C415-060F-5D32-F6A7C4019A33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3" creationId="{7D356EEB-5460-227F-04F9-AABC1DDB00A7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4" creationId="{A009BE39-3D56-CD14-9C93-3EC8EA39D8C4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5" creationId="{9518854D-24CD-9798-5DA5-EDAF1903338F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6" creationId="{146665AB-1EE8-A0BE-8552-352FD853ED2D}"/>
          </ac:spMkLst>
        </pc:sp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3013913324" sldId="2147483649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013913324" sldId="2147483649"/>
              <ac:spMk id="2" creationId="{B953659A-3084-BAC3-9841-B815F0690E2C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013913324" sldId="2147483649"/>
              <ac:spMk id="3" creationId="{2AEB07D3-C99D-82ED-CAB1-A424FD192119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109533071" sldId="2147483651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109533071" sldId="2147483651"/>
              <ac:spMk id="2" creationId="{D404A9DA-EA0B-382E-3095-DC0880AD2CC1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109533071" sldId="2147483651"/>
              <ac:spMk id="3" creationId="{F9883091-E81C-B2AD-8BF9-758DFA5C75BE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3786158922" sldId="2147483652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786158922" sldId="2147483652"/>
              <ac:spMk id="3" creationId="{6C3E7F25-F036-D4DC-FDD9-5C89596AA334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786158922" sldId="2147483652"/>
              <ac:spMk id="4" creationId="{ED705EEA-E05F-ACE8-CD22-84072E570E23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3503595258" sldId="2147483653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2" creationId="{BA14E5FF-E825-B1FF-F325-28E1E868CBF9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3" creationId="{BBB2797D-8219-B72D-5B5D-FA7853C2DA5F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4" creationId="{769191C9-8368-CA14-27E2-D11080490B50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5" creationId="{FDD55E15-1EA3-8442-131B-AD61AE9BF700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6" creationId="{78A75DBE-964B-4ECC-5C1B-2C4D0F04DEE5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298067336" sldId="2147483656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98067336" sldId="2147483656"/>
              <ac:spMk id="2" creationId="{868C1FFA-E667-44D4-42C0-B6EAC0B3CC7B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98067336" sldId="2147483656"/>
              <ac:spMk id="3" creationId="{0A8DED82-2E5E-22CA-72AF-6070552A09EA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98067336" sldId="2147483656"/>
              <ac:spMk id="4" creationId="{252E4A58-963D-A2CC-6745-24332F6BED55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2726528857" sldId="2147483657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26528857" sldId="2147483657"/>
              <ac:spMk id="2" creationId="{11532E81-C183-8360-F5CF-809076B8F5F8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26528857" sldId="2147483657"/>
              <ac:spMk id="3" creationId="{F25D7820-9E80-65A8-AACC-68C96DEA2996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26528857" sldId="2147483657"/>
              <ac:spMk id="4" creationId="{D3A3D3C3-A12C-FA91-361C-530ABAFF040D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2792281560" sldId="2147483659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92281560" sldId="2147483659"/>
              <ac:spMk id="2" creationId="{0CAFFAB5-12E6-631A-DBB5-3EDADB204613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92281560" sldId="2147483659"/>
              <ac:spMk id="3" creationId="{4BC6DC10-7FD9-B031-D83F-E463E3807EA6}"/>
            </ac:spMkLst>
          </pc:spChg>
        </pc:sldLayoutChg>
      </pc:sldMasterChg>
      <pc:sldMasterChg chg="modSp modSldLayout">
        <pc:chgData name="JUAN MANUEL LOZANO GIL" userId="618ed11e-cb2c-4b03-8ac9-a8cf52f924c9" providerId="ADAL" clId="{E1A82C2D-CEA3-4ADD-B72B-8C2A4C688D33}" dt="2023-07-19T10:08:57.717" v="113"/>
        <pc:sldMasterMkLst>
          <pc:docMk/>
          <pc:sldMasterMk cId="3108211256" sldId="2147483660"/>
        </pc:sldMasterMkLst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2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3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4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5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6" creationId="{00000000-0000-0000-0000-000000000000}"/>
          </ac:spMkLst>
        </pc:sp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1478480377" sldId="2147483661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478480377" sldId="2147483661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478480377" sldId="2147483661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3044350121" sldId="2147483663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3044350121" sldId="2147483663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3044350121" sldId="2147483663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682965052" sldId="2147483664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82965052" sldId="2147483664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82965052" sldId="2147483664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2225490895" sldId="2147483665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4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5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6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633576424" sldId="2147483668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33576424" sldId="2147483668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33576424" sldId="2147483668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33576424" sldId="2147483668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1138390491" sldId="2147483669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138390491" sldId="2147483669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138390491" sldId="2147483669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138390491" sldId="2147483669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1203963660" sldId="2147483671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203963660" sldId="2147483671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203963660" sldId="2147483671"/>
              <ac:spMk id="3" creationId="{00000000-0000-0000-0000-000000000000}"/>
            </ac:spMkLst>
          </pc:spChg>
        </pc:sldLayoutChg>
      </pc:sldMasterChg>
      <pc:sldMasterChg chg="modSp modSldLayout">
        <pc:chgData name="JUAN MANUEL LOZANO GIL" userId="618ed11e-cb2c-4b03-8ac9-a8cf52f924c9" providerId="ADAL" clId="{E1A82C2D-CEA3-4ADD-B72B-8C2A4C688D33}" dt="2023-07-19T10:08:57.481" v="112"/>
        <pc:sldMasterMkLst>
          <pc:docMk/>
          <pc:sldMasterMk cId="2488454685" sldId="2147483672"/>
        </pc:sldMasterMkLst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2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3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4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5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6" creationId="{00000000-0000-0000-0000-000000000000}"/>
          </ac:spMkLst>
        </pc:sp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280496838" sldId="2147483673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280496838" sldId="2147483673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280496838" sldId="2147483673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603214847" sldId="2147483675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03214847" sldId="2147483675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03214847" sldId="2147483675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3938553646" sldId="2147483676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3938553646" sldId="2147483676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3938553646" sldId="2147483676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75467544" sldId="2147483677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4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5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6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441035540" sldId="2147483680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441035540" sldId="2147483680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441035540" sldId="2147483680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441035540" sldId="2147483680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678088751" sldId="2147483681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78088751" sldId="2147483681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78088751" sldId="2147483681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78088751" sldId="2147483681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4120903828" sldId="2147483683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4120903828" sldId="2147483683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4120903828" sldId="2147483683"/>
              <ac:spMk id="3" creationId="{00000000-0000-0000-0000-000000000000}"/>
            </ac:spMkLst>
          </pc:spChg>
        </pc:sldLayoutChg>
      </pc:sldMasterChg>
    </pc:docChg>
  </pc:docChgLst>
  <pc:docChgLst>
    <pc:chgData name="JUAN MANUEL LOZANO GIL" userId="618ed11e-cb2c-4b03-8ac9-a8cf52f924c9" providerId="ADAL" clId="{AE6DC8AE-2302-42EA-A1AA-40268F4D08BC}"/>
    <pc:docChg chg="custSel addSld delSld modSld">
      <pc:chgData name="JUAN MANUEL LOZANO GIL" userId="618ed11e-cb2c-4b03-8ac9-a8cf52f924c9" providerId="ADAL" clId="{AE6DC8AE-2302-42EA-A1AA-40268F4D08BC}" dt="2023-07-19T16:19:33.810" v="402" actId="1076"/>
      <pc:docMkLst>
        <pc:docMk/>
      </pc:docMkLst>
      <pc:sldChg chg="addSp delSp modSp mod">
        <pc:chgData name="JUAN MANUEL LOZANO GIL" userId="618ed11e-cb2c-4b03-8ac9-a8cf52f924c9" providerId="ADAL" clId="{AE6DC8AE-2302-42EA-A1AA-40268F4D08BC}" dt="2023-07-19T11:20:23.247" v="262" actId="113"/>
        <pc:sldMkLst>
          <pc:docMk/>
          <pc:sldMk cId="3278798907" sldId="256"/>
        </pc:sldMkLst>
        <pc:spChg chg="mod">
          <ac:chgData name="JUAN MANUEL LOZANO GIL" userId="618ed11e-cb2c-4b03-8ac9-a8cf52f924c9" providerId="ADAL" clId="{AE6DC8AE-2302-42EA-A1AA-40268F4D08BC}" dt="2023-07-19T11:04:04.622" v="52"/>
          <ac:spMkLst>
            <pc:docMk/>
            <pc:sldMk cId="3278798907" sldId="256"/>
            <ac:spMk id="3" creationId="{2449F1DD-CECE-3598-AF4C-0848DDC690F8}"/>
          </ac:spMkLst>
        </pc:spChg>
        <pc:spChg chg="mod">
          <ac:chgData name="JUAN MANUEL LOZANO GIL" userId="618ed11e-cb2c-4b03-8ac9-a8cf52f924c9" providerId="ADAL" clId="{AE6DC8AE-2302-42EA-A1AA-40268F4D08BC}" dt="2023-07-19T11:04:04.622" v="52"/>
          <ac:spMkLst>
            <pc:docMk/>
            <pc:sldMk cId="3278798907" sldId="256"/>
            <ac:spMk id="4" creationId="{1FB04A87-AF0E-0D46-4E69-1951635CAFCE}"/>
          </ac:spMkLst>
        </pc:spChg>
        <pc:spChg chg="mod">
          <ac:chgData name="JUAN MANUEL LOZANO GIL" userId="618ed11e-cb2c-4b03-8ac9-a8cf52f924c9" providerId="ADAL" clId="{AE6DC8AE-2302-42EA-A1AA-40268F4D08BC}" dt="2023-07-19T11:04:04.622" v="52"/>
          <ac:spMkLst>
            <pc:docMk/>
            <pc:sldMk cId="3278798907" sldId="256"/>
            <ac:spMk id="5" creationId="{4576F8D6-3239-5101-0049-56FEB64BC72E}"/>
          </ac:spMkLst>
        </pc:spChg>
        <pc:spChg chg="mod">
          <ac:chgData name="JUAN MANUEL LOZANO GIL" userId="618ed11e-cb2c-4b03-8ac9-a8cf52f924c9" providerId="ADAL" clId="{AE6DC8AE-2302-42EA-A1AA-40268F4D08BC}" dt="2023-07-19T11:04:04.622" v="52"/>
          <ac:spMkLst>
            <pc:docMk/>
            <pc:sldMk cId="3278798907" sldId="256"/>
            <ac:spMk id="6" creationId="{2BE4D7E7-4A36-82CA-F6A2-9DB24E5F032A}"/>
          </ac:spMkLst>
        </pc:spChg>
        <pc:spChg chg="add mod">
          <ac:chgData name="JUAN MANUEL LOZANO GIL" userId="618ed11e-cb2c-4b03-8ac9-a8cf52f924c9" providerId="ADAL" clId="{AE6DC8AE-2302-42EA-A1AA-40268F4D08BC}" dt="2023-07-19T11:19:28.078" v="251" actId="14100"/>
          <ac:spMkLst>
            <pc:docMk/>
            <pc:sldMk cId="3278798907" sldId="256"/>
            <ac:spMk id="7" creationId="{D58F52B1-25D4-4FD1-9952-03F0C4AE1DA0}"/>
          </ac:spMkLst>
        </pc:spChg>
        <pc:spChg chg="add mod">
          <ac:chgData name="JUAN MANUEL LOZANO GIL" userId="618ed11e-cb2c-4b03-8ac9-a8cf52f924c9" providerId="ADAL" clId="{AE6DC8AE-2302-42EA-A1AA-40268F4D08BC}" dt="2023-07-19T11:19:32.759" v="253" actId="1076"/>
          <ac:spMkLst>
            <pc:docMk/>
            <pc:sldMk cId="3278798907" sldId="256"/>
            <ac:spMk id="8" creationId="{B29970A1-692B-1C31-9F2A-493FC1B48498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9" creationId="{146086C0-B663-8443-F4B7-2719B3DFBC7A}"/>
          </ac:spMkLst>
        </pc:spChg>
        <pc:spChg chg="mod">
          <ac:chgData name="JUAN MANUEL LOZANO GIL" userId="618ed11e-cb2c-4b03-8ac9-a8cf52f924c9" providerId="ADAL" clId="{AE6DC8AE-2302-42EA-A1AA-40268F4D08BC}" dt="2023-07-19T11:05:50.712" v="80" actId="1036"/>
          <ac:spMkLst>
            <pc:docMk/>
            <pc:sldMk cId="3278798907" sldId="256"/>
            <ac:spMk id="14" creationId="{47BD6571-2757-D96F-6834-65C8E84335E6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21" creationId="{E6FAAC9E-4562-B972-E7DE-16A5145C38A0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2" creationId="{588D2D9C-C17A-09EB-F3DC-5A5790C5C1F6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3" creationId="{60378545-1721-7E35-DBE1-510F713F4B33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4" creationId="{00026D50-AB2B-CBB2-166B-AEC4F5271D20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5" creationId="{6BE43327-C2C8-B486-E4B2-04A2AC0CA231}"/>
          </ac:spMkLst>
        </pc:spChg>
        <pc:spChg chg="mod">
          <ac:chgData name="JUAN MANUEL LOZANO GIL" userId="618ed11e-cb2c-4b03-8ac9-a8cf52f924c9" providerId="ADAL" clId="{AE6DC8AE-2302-42EA-A1AA-40268F4D08BC}" dt="2023-07-19T11:05:37.528" v="72"/>
          <ac:spMkLst>
            <pc:docMk/>
            <pc:sldMk cId="3278798907" sldId="256"/>
            <ac:spMk id="26" creationId="{139A7994-DF7F-AFB9-FA6A-A8D0B054E40B}"/>
          </ac:spMkLst>
        </pc:spChg>
        <pc:spChg chg="del mod">
          <ac:chgData name="JUAN MANUEL LOZANO GIL" userId="618ed11e-cb2c-4b03-8ac9-a8cf52f924c9" providerId="ADAL" clId="{AE6DC8AE-2302-42EA-A1AA-40268F4D08BC}" dt="2023-07-19T11:05:55.777" v="81" actId="478"/>
          <ac:spMkLst>
            <pc:docMk/>
            <pc:sldMk cId="3278798907" sldId="256"/>
            <ac:spMk id="27" creationId="{1369DFDF-6AAF-0595-1B4E-97D8A01BDFE3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0" creationId="{5D51998A-8FAF-CEE2-A74A-368C8EF9265B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3" creationId="{99F7541D-9967-ED2B-09DC-E2DAA8B05FC5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6" creationId="{D18CCFD7-E3E3-0C50-C6E9-0B0D1095284E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7" creationId="{E702AD9D-EE90-AE7D-F771-EA6B46729DF9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8" creationId="{A96EDE9E-A0F9-6EAE-0196-CD461473CB31}"/>
          </ac:spMkLst>
        </pc:spChg>
        <pc:spChg chg="mod">
          <ac:chgData name="JUAN MANUEL LOZANO GIL" userId="618ed11e-cb2c-4b03-8ac9-a8cf52f924c9" providerId="ADAL" clId="{AE6DC8AE-2302-42EA-A1AA-40268F4D08BC}" dt="2023-07-19T11:07:15.463" v="118"/>
          <ac:spMkLst>
            <pc:docMk/>
            <pc:sldMk cId="3278798907" sldId="256"/>
            <ac:spMk id="59" creationId="{C10F2C02-E4CB-FA78-A1AE-B5E3AA26FE86}"/>
          </ac:spMkLst>
        </pc:spChg>
        <pc:spChg chg="add mod">
          <ac:chgData name="JUAN MANUEL LOZANO GIL" userId="618ed11e-cb2c-4b03-8ac9-a8cf52f924c9" providerId="ADAL" clId="{AE6DC8AE-2302-42EA-A1AA-40268F4D08BC}" dt="2023-07-19T11:15:34.519" v="187" actId="1076"/>
          <ac:spMkLst>
            <pc:docMk/>
            <pc:sldMk cId="3278798907" sldId="256"/>
            <ac:spMk id="67" creationId="{9F4214D0-BC19-637D-2C47-40F6FE1592AF}"/>
          </ac:spMkLst>
        </pc:spChg>
        <pc:spChg chg="add mod">
          <ac:chgData name="JUAN MANUEL LOZANO GIL" userId="618ed11e-cb2c-4b03-8ac9-a8cf52f924c9" providerId="ADAL" clId="{AE6DC8AE-2302-42EA-A1AA-40268F4D08BC}" dt="2023-07-19T11:15:34.519" v="187" actId="1076"/>
          <ac:spMkLst>
            <pc:docMk/>
            <pc:sldMk cId="3278798907" sldId="256"/>
            <ac:spMk id="68" creationId="{BEAB7F0B-25D9-0ADB-6C9A-95DD5C1EA3A5}"/>
          </ac:spMkLst>
        </pc:spChg>
        <pc:spChg chg="add mod">
          <ac:chgData name="JUAN MANUEL LOZANO GIL" userId="618ed11e-cb2c-4b03-8ac9-a8cf52f924c9" providerId="ADAL" clId="{AE6DC8AE-2302-42EA-A1AA-40268F4D08BC}" dt="2023-07-19T11:20:23.247" v="262" actId="113"/>
          <ac:spMkLst>
            <pc:docMk/>
            <pc:sldMk cId="3278798907" sldId="256"/>
            <ac:spMk id="69" creationId="{6D478024-2D28-33B7-F3AA-225E5E6E2820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23" creationId="{ADB6E049-3E35-ED91-D48D-5CDE07739EFB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24" creationId="{106C1AF1-94C5-F629-15FD-623F681A8C50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28" creationId="{4DDF8618-B36F-119A-CA7A-EE88C352364F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3" creationId="{F7D03FBE-A81A-6BC4-1C33-3A183B86791D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4" creationId="{913B9BB6-4065-0AE0-54C4-70791E5BB21A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5" creationId="{34F0A8C1-B00F-FC42-FA0E-7F64DFB6A559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6" creationId="{DE770029-C13A-362F-EA6B-452F863DBC8A}"/>
          </ac:spMkLst>
        </pc:spChg>
        <pc:spChg chg="del">
          <ac:chgData name="JUAN MANUEL LOZANO GIL" userId="618ed11e-cb2c-4b03-8ac9-a8cf52f924c9" providerId="ADAL" clId="{AE6DC8AE-2302-42EA-A1AA-40268F4D08BC}" dt="2023-07-19T11:01:38.794" v="0" actId="478"/>
          <ac:spMkLst>
            <pc:docMk/>
            <pc:sldMk cId="3278798907" sldId="256"/>
            <ac:spMk id="139" creationId="{02190607-545A-EAEF-B8B5-30DDD473E609}"/>
          </ac:spMkLst>
        </pc:spChg>
        <pc:grpChg chg="add mod">
          <ac:chgData name="JUAN MANUEL LOZANO GIL" userId="618ed11e-cb2c-4b03-8ac9-a8cf52f924c9" providerId="ADAL" clId="{AE6DC8AE-2302-42EA-A1AA-40268F4D08BC}" dt="2023-07-19T11:15:34.519" v="187" actId="1076"/>
          <ac:grpSpMkLst>
            <pc:docMk/>
            <pc:sldMk cId="3278798907" sldId="256"/>
            <ac:grpSpMk id="2" creationId="{DA79CEE9-4154-4345-0082-E0FDD816AC9F}"/>
          </ac:grpSpMkLst>
        </pc:grpChg>
        <pc:grpChg chg="del">
          <ac:chgData name="JUAN MANUEL LOZANO GIL" userId="618ed11e-cb2c-4b03-8ac9-a8cf52f924c9" providerId="ADAL" clId="{AE6DC8AE-2302-42EA-A1AA-40268F4D08BC}" dt="2023-07-19T11:01:38.794" v="0" actId="478"/>
          <ac:grpSpMkLst>
            <pc:docMk/>
            <pc:sldMk cId="3278798907" sldId="256"/>
            <ac:grpSpMk id="7" creationId="{8D97C7FF-949E-1C1F-907C-9204A55EBD96}"/>
          </ac:grpSpMkLst>
        </pc:grpChg>
        <pc:grpChg chg="add mod">
          <ac:chgData name="JUAN MANUEL LOZANO GIL" userId="618ed11e-cb2c-4b03-8ac9-a8cf52f924c9" providerId="ADAL" clId="{AE6DC8AE-2302-42EA-A1AA-40268F4D08BC}" dt="2023-07-19T11:15:34.519" v="187" actId="1076"/>
          <ac:grpSpMkLst>
            <pc:docMk/>
            <pc:sldMk cId="3278798907" sldId="256"/>
            <ac:grpSpMk id="11" creationId="{C11BA16E-4008-DBF6-8E1B-61B0AAEB43C3}"/>
          </ac:grpSpMkLst>
        </pc:grpChg>
        <pc:grpChg chg="mod">
          <ac:chgData name="JUAN MANUEL LOZANO GIL" userId="618ed11e-cb2c-4b03-8ac9-a8cf52f924c9" providerId="ADAL" clId="{AE6DC8AE-2302-42EA-A1AA-40268F4D08BC}" dt="2023-07-19T11:05:37.528" v="72"/>
          <ac:grpSpMkLst>
            <pc:docMk/>
            <pc:sldMk cId="3278798907" sldId="256"/>
            <ac:grpSpMk id="12" creationId="{4318F879-FA0F-8A3C-E63B-6E1BB93BD855}"/>
          </ac:grpSpMkLst>
        </pc:grpChg>
        <pc:grpChg chg="del">
          <ac:chgData name="JUAN MANUEL LOZANO GIL" userId="618ed11e-cb2c-4b03-8ac9-a8cf52f924c9" providerId="ADAL" clId="{AE6DC8AE-2302-42EA-A1AA-40268F4D08BC}" dt="2023-07-19T11:01:38.794" v="0" actId="478"/>
          <ac:grpSpMkLst>
            <pc:docMk/>
            <pc:sldMk cId="3278798907" sldId="256"/>
            <ac:grpSpMk id="20" creationId="{C3D67D48-DBD6-F3C7-14EA-203AA1CEB286}"/>
          </ac:grpSpMkLst>
        </pc:grpChg>
        <pc:grpChg chg="add mod">
          <ac:chgData name="JUAN MANUEL LOZANO GIL" userId="618ed11e-cb2c-4b03-8ac9-a8cf52f924c9" providerId="ADAL" clId="{AE6DC8AE-2302-42EA-A1AA-40268F4D08BC}" dt="2023-07-19T11:15:34.519" v="187" actId="1076"/>
          <ac:grpSpMkLst>
            <pc:docMk/>
            <pc:sldMk cId="3278798907" sldId="256"/>
            <ac:grpSpMk id="44" creationId="{A9D05679-6A73-8700-4564-4570AB89C06A}"/>
          </ac:grpSpMkLst>
        </pc:grpChg>
        <pc:grpChg chg="mod">
          <ac:chgData name="JUAN MANUEL LOZANO GIL" userId="618ed11e-cb2c-4b03-8ac9-a8cf52f924c9" providerId="ADAL" clId="{AE6DC8AE-2302-42EA-A1AA-40268F4D08BC}" dt="2023-07-19T11:07:15.463" v="118"/>
          <ac:grpSpMkLst>
            <pc:docMk/>
            <pc:sldMk cId="3278798907" sldId="256"/>
            <ac:grpSpMk id="47" creationId="{7D63D47F-D66B-0966-D19E-11C108B2B7CE}"/>
          </ac:grpSpMkLst>
        </pc:grpChg>
        <pc:grpChg chg="del">
          <ac:chgData name="JUAN MANUEL LOZANO GIL" userId="618ed11e-cb2c-4b03-8ac9-a8cf52f924c9" providerId="ADAL" clId="{AE6DC8AE-2302-42EA-A1AA-40268F4D08BC}" dt="2023-07-19T11:01:38.794" v="0" actId="478"/>
          <ac:grpSpMkLst>
            <pc:docMk/>
            <pc:sldMk cId="3278798907" sldId="256"/>
            <ac:grpSpMk id="65" creationId="{A5E5CDB5-C751-0E14-2CF2-8CD6EEB4673D}"/>
          </ac:grpSpMkLst>
        </pc:grpChg>
        <pc:picChg chg="add del mod ord modCrop">
          <ac:chgData name="JUAN MANUEL LOZANO GIL" userId="618ed11e-cb2c-4b03-8ac9-a8cf52f924c9" providerId="ADAL" clId="{AE6DC8AE-2302-42EA-A1AA-40268F4D08BC}" dt="2023-07-19T11:06:02.817" v="83" actId="478"/>
          <ac:picMkLst>
            <pc:docMk/>
            <pc:sldMk cId="3278798907" sldId="256"/>
            <ac:picMk id="8" creationId="{42EE143D-13FD-1690-DA4A-7B42D4077087}"/>
          </ac:picMkLst>
        </pc:picChg>
        <pc:picChg chg="add mod modCrop">
          <ac:chgData name="JUAN MANUEL LOZANO GIL" userId="618ed11e-cb2c-4b03-8ac9-a8cf52f924c9" providerId="ADAL" clId="{AE6DC8AE-2302-42EA-A1AA-40268F4D08BC}" dt="2023-07-19T11:15:34.519" v="187" actId="1076"/>
          <ac:picMkLst>
            <pc:docMk/>
            <pc:sldMk cId="3278798907" sldId="256"/>
            <ac:picMk id="10" creationId="{5C61654F-30BF-8BC9-C723-0517D33C19C6}"/>
          </ac:picMkLst>
        </pc:picChg>
        <pc:picChg chg="del">
          <ac:chgData name="JUAN MANUEL LOZANO GIL" userId="618ed11e-cb2c-4b03-8ac9-a8cf52f924c9" providerId="ADAL" clId="{AE6DC8AE-2302-42EA-A1AA-40268F4D08BC}" dt="2023-07-19T11:01:38.794" v="0" actId="478"/>
          <ac:picMkLst>
            <pc:docMk/>
            <pc:sldMk cId="3278798907" sldId="256"/>
            <ac:picMk id="13" creationId="{A3918CB1-7E0E-12FB-DEA9-93F0D716FC59}"/>
          </ac:picMkLst>
        </pc:picChg>
        <pc:picChg chg="add mod modCrop">
          <ac:chgData name="JUAN MANUEL LOZANO GIL" userId="618ed11e-cb2c-4b03-8ac9-a8cf52f924c9" providerId="ADAL" clId="{AE6DC8AE-2302-42EA-A1AA-40268F4D08BC}" dt="2023-07-19T11:15:34.519" v="187" actId="1076"/>
          <ac:picMkLst>
            <pc:docMk/>
            <pc:sldMk cId="3278798907" sldId="256"/>
            <ac:picMk id="39" creationId="{E8B83790-B132-40A1-2C16-C45DD1B212E7}"/>
          </ac:picMkLst>
        </pc:picChg>
        <pc:picChg chg="add del mod modCrop">
          <ac:chgData name="JUAN MANUEL LOZANO GIL" userId="618ed11e-cb2c-4b03-8ac9-a8cf52f924c9" providerId="ADAL" clId="{AE6DC8AE-2302-42EA-A1AA-40268F4D08BC}" dt="2023-07-19T11:07:35.360" v="123" actId="478"/>
          <ac:picMkLst>
            <pc:docMk/>
            <pc:sldMk cId="3278798907" sldId="256"/>
            <ac:picMk id="41" creationId="{4165E640-FF2A-E42D-78E1-D62BA876E298}"/>
          </ac:picMkLst>
        </pc:picChg>
        <pc:cxnChg chg="mod">
          <ac:chgData name="JUAN MANUEL LOZANO GIL" userId="618ed11e-cb2c-4b03-8ac9-a8cf52f924c9" providerId="ADAL" clId="{AE6DC8AE-2302-42EA-A1AA-40268F4D08BC}" dt="2023-07-19T11:05:50.712" v="80" actId="1036"/>
          <ac:cxnSpMkLst>
            <pc:docMk/>
            <pc:sldMk cId="3278798907" sldId="256"/>
            <ac:cxnSpMk id="28" creationId="{43262B23-BAF6-51EE-5C06-DBC0D422674E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1" creationId="{97980C53-1FC6-BD12-B589-389F629DF590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3" creationId="{E22E2640-9D8C-7063-0358-6C20D6171561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4" creationId="{69D1E20C-8247-0918-11B1-B305D9792723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5" creationId="{B398A1FB-251C-09C3-C802-10BB3834E733}"/>
          </ac:cxnSpMkLst>
        </pc:cxnChg>
        <pc:cxnChg chg="mod">
          <ac:chgData name="JUAN MANUEL LOZANO GIL" userId="618ed11e-cb2c-4b03-8ac9-a8cf52f924c9" providerId="ADAL" clId="{AE6DC8AE-2302-42EA-A1AA-40268F4D08BC}" dt="2023-07-19T11:05:37.528" v="72"/>
          <ac:cxnSpMkLst>
            <pc:docMk/>
            <pc:sldMk cId="3278798907" sldId="256"/>
            <ac:cxnSpMk id="36" creationId="{F5DA832A-91F2-CDEF-DBAA-415440F53E40}"/>
          </ac:cxnSpMkLst>
        </pc:cxnChg>
        <pc:cxnChg chg="del mod">
          <ac:chgData name="JUAN MANUEL LOZANO GIL" userId="618ed11e-cb2c-4b03-8ac9-a8cf52f924c9" providerId="ADAL" clId="{AE6DC8AE-2302-42EA-A1AA-40268F4D08BC}" dt="2023-07-19T11:05:55.777" v="81" actId="478"/>
          <ac:cxnSpMkLst>
            <pc:docMk/>
            <pc:sldMk cId="3278798907" sldId="256"/>
            <ac:cxnSpMk id="37" creationId="{6E379257-4928-C326-A4B3-5F58512A7763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0" creationId="{FE7CE5E2-37FE-E845-F95A-CFDFDDD8F7DF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1" creationId="{28B656FE-E2BC-A269-FDDB-2C22180E7E87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2" creationId="{ABA294BD-FEAB-8FFD-F477-36193F97B2E1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3" creationId="{B2164A84-3EB7-528D-C5B6-62C0F8A2E95A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4" creationId="{13E73494-4E2E-D764-798B-A4C8C0A8F153}"/>
          </ac:cxnSpMkLst>
        </pc:cxnChg>
        <pc:cxnChg chg="mod">
          <ac:chgData name="JUAN MANUEL LOZANO GIL" userId="618ed11e-cb2c-4b03-8ac9-a8cf52f924c9" providerId="ADAL" clId="{AE6DC8AE-2302-42EA-A1AA-40268F4D08BC}" dt="2023-07-19T11:07:15.463" v="118"/>
          <ac:cxnSpMkLst>
            <pc:docMk/>
            <pc:sldMk cId="3278798907" sldId="256"/>
            <ac:cxnSpMk id="66" creationId="{67EB34F5-EB20-22B9-08CB-096816D4ACBA}"/>
          </ac:cxnSpMkLst>
        </pc:cxnChg>
        <pc:cxnChg chg="del mod">
          <ac:chgData name="JUAN MANUEL LOZANO GIL" userId="618ed11e-cb2c-4b03-8ac9-a8cf52f924c9" providerId="ADAL" clId="{AE6DC8AE-2302-42EA-A1AA-40268F4D08BC}" dt="2023-07-19T11:01:38.794" v="0" actId="478"/>
          <ac:cxnSpMkLst>
            <pc:docMk/>
            <pc:sldMk cId="3278798907" sldId="256"/>
            <ac:cxnSpMk id="127" creationId="{8839E733-E7A2-2B25-2A5F-F486A05DED28}"/>
          </ac:cxnSpMkLst>
        </pc:cxnChg>
      </pc:sldChg>
      <pc:sldChg chg="addSp delSp modSp add mod">
        <pc:chgData name="JUAN MANUEL LOZANO GIL" userId="618ed11e-cb2c-4b03-8ac9-a8cf52f924c9" providerId="ADAL" clId="{AE6DC8AE-2302-42EA-A1AA-40268F4D08BC}" dt="2023-07-19T16:19:33.810" v="402" actId="1076"/>
        <pc:sldMkLst>
          <pc:docMk/>
          <pc:sldMk cId="387500787" sldId="257"/>
        </pc:sldMkLst>
        <pc:spChg chg="add mod">
          <ac:chgData name="JUAN MANUEL LOZANO GIL" userId="618ed11e-cb2c-4b03-8ac9-a8cf52f924c9" providerId="ADAL" clId="{AE6DC8AE-2302-42EA-A1AA-40268F4D08BC}" dt="2023-07-19T16:16:29.733" v="267" actId="1076"/>
          <ac:spMkLst>
            <pc:docMk/>
            <pc:sldMk cId="387500787" sldId="257"/>
            <ac:spMk id="7" creationId="{4DE8302F-A29C-1C6F-7B39-B1A46263E36A}"/>
          </ac:spMkLst>
        </pc:spChg>
        <pc:spChg chg="add mod">
          <ac:chgData name="JUAN MANUEL LOZANO GIL" userId="618ed11e-cb2c-4b03-8ac9-a8cf52f924c9" providerId="ADAL" clId="{AE6DC8AE-2302-42EA-A1AA-40268F4D08BC}" dt="2023-07-19T16:16:29.733" v="267" actId="1076"/>
          <ac:spMkLst>
            <pc:docMk/>
            <pc:sldMk cId="387500787" sldId="257"/>
            <ac:spMk id="9" creationId="{756BD238-0BB0-8F35-B8FE-CFB8CA92B50B}"/>
          </ac:spMkLst>
        </pc:spChg>
        <pc:spChg chg="del mod">
          <ac:chgData name="JUAN MANUEL LOZANO GIL" userId="618ed11e-cb2c-4b03-8ac9-a8cf52f924c9" providerId="ADAL" clId="{AE6DC8AE-2302-42EA-A1AA-40268F4D08BC}" dt="2023-07-19T16:19:18.500" v="392" actId="478"/>
          <ac:spMkLst>
            <pc:docMk/>
            <pc:sldMk cId="387500787" sldId="257"/>
            <ac:spMk id="19" creationId="{28CCA99D-413E-E495-7568-BDBED5F5FBD2}"/>
          </ac:spMkLst>
        </pc:spChg>
        <pc:spChg chg="del mod">
          <ac:chgData name="JUAN MANUEL LOZANO GIL" userId="618ed11e-cb2c-4b03-8ac9-a8cf52f924c9" providerId="ADAL" clId="{AE6DC8AE-2302-42EA-A1AA-40268F4D08BC}" dt="2023-07-19T16:19:12.798" v="390" actId="478"/>
          <ac:spMkLst>
            <pc:docMk/>
            <pc:sldMk cId="387500787" sldId="257"/>
            <ac:spMk id="20" creationId="{DBB793AA-CA93-2D56-931C-92639EE41648}"/>
          </ac:spMkLst>
        </pc:spChg>
        <pc:spChg chg="mod">
          <ac:chgData name="JUAN MANUEL LOZANO GIL" userId="618ed11e-cb2c-4b03-8ac9-a8cf52f924c9" providerId="ADAL" clId="{AE6DC8AE-2302-42EA-A1AA-40268F4D08BC}" dt="2023-07-19T16:18:50.942" v="378"/>
          <ac:spMkLst>
            <pc:docMk/>
            <pc:sldMk cId="387500787" sldId="257"/>
            <ac:spMk id="21" creationId="{726F36D2-5E65-7FB6-60AC-137176448A07}"/>
          </ac:spMkLst>
        </pc:spChg>
        <pc:spChg chg="mod">
          <ac:chgData name="JUAN MANUEL LOZANO GIL" userId="618ed11e-cb2c-4b03-8ac9-a8cf52f924c9" providerId="ADAL" clId="{AE6DC8AE-2302-42EA-A1AA-40268F4D08BC}" dt="2023-07-19T16:18:50.942" v="378"/>
          <ac:spMkLst>
            <pc:docMk/>
            <pc:sldMk cId="387500787" sldId="257"/>
            <ac:spMk id="27" creationId="{B34A3CFC-6781-AD69-46D1-863FBEC0A5AF}"/>
          </ac:spMkLst>
        </pc:spChg>
        <pc:spChg chg="mod">
          <ac:chgData name="JUAN MANUEL LOZANO GIL" userId="618ed11e-cb2c-4b03-8ac9-a8cf52f924c9" providerId="ADAL" clId="{AE6DC8AE-2302-42EA-A1AA-40268F4D08BC}" dt="2023-07-19T16:18:50.942" v="378"/>
          <ac:spMkLst>
            <pc:docMk/>
            <pc:sldMk cId="387500787" sldId="257"/>
            <ac:spMk id="29" creationId="{56253F1E-0ABE-4ABA-D75E-BF16764FAA6C}"/>
          </ac:spMkLst>
        </pc:spChg>
        <pc:spChg chg="mod">
          <ac:chgData name="JUAN MANUEL LOZANO GIL" userId="618ed11e-cb2c-4b03-8ac9-a8cf52f924c9" providerId="ADAL" clId="{AE6DC8AE-2302-42EA-A1AA-40268F4D08BC}" dt="2023-07-19T16:18:50.942" v="378"/>
          <ac:spMkLst>
            <pc:docMk/>
            <pc:sldMk cId="387500787" sldId="257"/>
            <ac:spMk id="30" creationId="{22B5B19C-86D7-D88E-5B91-EF93FEF5B546}"/>
          </ac:spMkLst>
        </pc:spChg>
        <pc:spChg chg="add mod">
          <ac:chgData name="JUAN MANUEL LOZANO GIL" userId="618ed11e-cb2c-4b03-8ac9-a8cf52f924c9" providerId="ADAL" clId="{AE6DC8AE-2302-42EA-A1AA-40268F4D08BC}" dt="2023-07-19T16:19:27.533" v="400" actId="20577"/>
          <ac:spMkLst>
            <pc:docMk/>
            <pc:sldMk cId="387500787" sldId="257"/>
            <ac:spMk id="42" creationId="{3E6FE829-1637-7C47-6CF3-0A31830D65E7}"/>
          </ac:spMkLst>
        </pc:spChg>
        <pc:spChg chg="add mod">
          <ac:chgData name="JUAN MANUEL LOZANO GIL" userId="618ed11e-cb2c-4b03-8ac9-a8cf52f924c9" providerId="ADAL" clId="{AE6DC8AE-2302-42EA-A1AA-40268F4D08BC}" dt="2023-07-19T16:19:33.810" v="402" actId="1076"/>
          <ac:spMkLst>
            <pc:docMk/>
            <pc:sldMk cId="387500787" sldId="257"/>
            <ac:spMk id="43" creationId="{E12D15C7-7A9B-5896-94E4-6BE71DD7360F}"/>
          </ac:spMkLst>
        </pc:spChg>
        <pc:spChg chg="mod">
          <ac:chgData name="JUAN MANUEL LOZANO GIL" userId="618ed11e-cb2c-4b03-8ac9-a8cf52f924c9" providerId="ADAL" clId="{AE6DC8AE-2302-42EA-A1AA-40268F4D08BC}" dt="2023-07-19T16:16:29.733" v="267" actId="1076"/>
          <ac:spMkLst>
            <pc:docMk/>
            <pc:sldMk cId="387500787" sldId="257"/>
            <ac:spMk id="67" creationId="{9F4214D0-BC19-637D-2C47-40F6FE1592AF}"/>
          </ac:spMkLst>
        </pc:spChg>
        <pc:spChg chg="mod">
          <ac:chgData name="JUAN MANUEL LOZANO GIL" userId="618ed11e-cb2c-4b03-8ac9-a8cf52f924c9" providerId="ADAL" clId="{AE6DC8AE-2302-42EA-A1AA-40268F4D08BC}" dt="2023-07-19T16:16:29.733" v="267" actId="1076"/>
          <ac:spMkLst>
            <pc:docMk/>
            <pc:sldMk cId="387500787" sldId="257"/>
            <ac:spMk id="68" creationId="{BEAB7F0B-25D9-0ADB-6C9A-95DD5C1EA3A5}"/>
          </ac:spMkLst>
        </pc:spChg>
        <pc:spChg chg="mod">
          <ac:chgData name="JUAN MANUEL LOZANO GIL" userId="618ed11e-cb2c-4b03-8ac9-a8cf52f924c9" providerId="ADAL" clId="{AE6DC8AE-2302-42EA-A1AA-40268F4D08BC}" dt="2023-07-19T16:16:29.733" v="267" actId="1076"/>
          <ac:spMkLst>
            <pc:docMk/>
            <pc:sldMk cId="387500787" sldId="257"/>
            <ac:spMk id="69" creationId="{6D478024-2D28-33B7-F3AA-225E5E6E2820}"/>
          </ac:spMkLst>
        </pc:spChg>
        <pc:grpChg chg="mod">
          <ac:chgData name="JUAN MANUEL LOZANO GIL" userId="618ed11e-cb2c-4b03-8ac9-a8cf52f924c9" providerId="ADAL" clId="{AE6DC8AE-2302-42EA-A1AA-40268F4D08BC}" dt="2023-07-19T16:16:29.733" v="267" actId="1076"/>
          <ac:grpSpMkLst>
            <pc:docMk/>
            <pc:sldMk cId="387500787" sldId="257"/>
            <ac:grpSpMk id="2" creationId="{DA79CEE9-4154-4345-0082-E0FDD816AC9F}"/>
          </ac:grpSpMkLst>
        </pc:grpChg>
        <pc:grpChg chg="mod">
          <ac:chgData name="JUAN MANUEL LOZANO GIL" userId="618ed11e-cb2c-4b03-8ac9-a8cf52f924c9" providerId="ADAL" clId="{AE6DC8AE-2302-42EA-A1AA-40268F4D08BC}" dt="2023-07-19T16:16:29.733" v="267" actId="1076"/>
          <ac:grpSpMkLst>
            <pc:docMk/>
            <pc:sldMk cId="387500787" sldId="257"/>
            <ac:grpSpMk id="11" creationId="{C11BA16E-4008-DBF6-8E1B-61B0AAEB43C3}"/>
          </ac:grpSpMkLst>
        </pc:grpChg>
        <pc:grpChg chg="add mod">
          <ac:chgData name="JUAN MANUEL LOZANO GIL" userId="618ed11e-cb2c-4b03-8ac9-a8cf52f924c9" providerId="ADAL" clId="{AE6DC8AE-2302-42EA-A1AA-40268F4D08BC}" dt="2023-07-19T16:19:07.412" v="388" actId="1035"/>
          <ac:grpSpMkLst>
            <pc:docMk/>
            <pc:sldMk cId="387500787" sldId="257"/>
            <ac:grpSpMk id="17" creationId="{BCF028EB-DAFC-EFC1-3DBF-27FE8C91643E}"/>
          </ac:grpSpMkLst>
        </pc:grpChg>
        <pc:grpChg chg="mod">
          <ac:chgData name="JUAN MANUEL LOZANO GIL" userId="618ed11e-cb2c-4b03-8ac9-a8cf52f924c9" providerId="ADAL" clId="{AE6DC8AE-2302-42EA-A1AA-40268F4D08BC}" dt="2023-07-19T16:18:50.942" v="378"/>
          <ac:grpSpMkLst>
            <pc:docMk/>
            <pc:sldMk cId="387500787" sldId="257"/>
            <ac:grpSpMk id="18" creationId="{6910A6F7-196C-EE88-5573-A0BEF8D58392}"/>
          </ac:grpSpMkLst>
        </pc:grpChg>
        <pc:grpChg chg="mod">
          <ac:chgData name="JUAN MANUEL LOZANO GIL" userId="618ed11e-cb2c-4b03-8ac9-a8cf52f924c9" providerId="ADAL" clId="{AE6DC8AE-2302-42EA-A1AA-40268F4D08BC}" dt="2023-07-19T16:16:29.733" v="267" actId="1076"/>
          <ac:grpSpMkLst>
            <pc:docMk/>
            <pc:sldMk cId="387500787" sldId="257"/>
            <ac:grpSpMk id="44" creationId="{A9D05679-6A73-8700-4564-4570AB89C06A}"/>
          </ac:grpSpMkLst>
        </pc:grpChg>
        <pc:picChg chg="add mod modCrop">
          <ac:chgData name="JUAN MANUEL LOZANO GIL" userId="618ed11e-cb2c-4b03-8ac9-a8cf52f924c9" providerId="ADAL" clId="{AE6DC8AE-2302-42EA-A1AA-40268F4D08BC}" dt="2023-07-19T16:16:29.733" v="267" actId="1076"/>
          <ac:picMkLst>
            <pc:docMk/>
            <pc:sldMk cId="387500787" sldId="257"/>
            <ac:picMk id="8" creationId="{6CD42F57-D85A-3418-84F4-E4C2E275FE2D}"/>
          </ac:picMkLst>
        </pc:picChg>
        <pc:picChg chg="del">
          <ac:chgData name="JUAN MANUEL LOZANO GIL" userId="618ed11e-cb2c-4b03-8ac9-a8cf52f924c9" providerId="ADAL" clId="{AE6DC8AE-2302-42EA-A1AA-40268F4D08BC}" dt="2023-07-19T11:17:48.479" v="244" actId="478"/>
          <ac:picMkLst>
            <pc:docMk/>
            <pc:sldMk cId="387500787" sldId="257"/>
            <ac:picMk id="10" creationId="{5C61654F-30BF-8BC9-C723-0517D33C19C6}"/>
          </ac:picMkLst>
        </pc:picChg>
        <pc:picChg chg="add mod modCrop">
          <ac:chgData name="JUAN MANUEL LOZANO GIL" userId="618ed11e-cb2c-4b03-8ac9-a8cf52f924c9" providerId="ADAL" clId="{AE6DC8AE-2302-42EA-A1AA-40268F4D08BC}" dt="2023-07-19T16:16:29.733" v="267" actId="1076"/>
          <ac:picMkLst>
            <pc:docMk/>
            <pc:sldMk cId="387500787" sldId="257"/>
            <ac:picMk id="13" creationId="{FAF2C1DA-ABEC-7D7E-DB00-41F0798A037E}"/>
          </ac:picMkLst>
        </pc:picChg>
        <pc:picChg chg="add del mod">
          <ac:chgData name="JUAN MANUEL LOZANO GIL" userId="618ed11e-cb2c-4b03-8ac9-a8cf52f924c9" providerId="ADAL" clId="{AE6DC8AE-2302-42EA-A1AA-40268F4D08BC}" dt="2023-07-19T16:17:09.093" v="364" actId="478"/>
          <ac:picMkLst>
            <pc:docMk/>
            <pc:sldMk cId="387500787" sldId="257"/>
            <ac:picMk id="15" creationId="{F323BDA1-F823-1D14-C48F-238CF3F5E8AB}"/>
          </ac:picMkLst>
        </pc:picChg>
        <pc:picChg chg="add mod modCrop">
          <ac:chgData name="JUAN MANUEL LOZANO GIL" userId="618ed11e-cb2c-4b03-8ac9-a8cf52f924c9" providerId="ADAL" clId="{AE6DC8AE-2302-42EA-A1AA-40268F4D08BC}" dt="2023-07-19T16:18:47.303" v="377" actId="18131"/>
          <ac:picMkLst>
            <pc:docMk/>
            <pc:sldMk cId="387500787" sldId="257"/>
            <ac:picMk id="16" creationId="{D32079AA-14D2-706C-D158-6701211CC9F2}"/>
          </ac:picMkLst>
        </pc:picChg>
        <pc:picChg chg="del">
          <ac:chgData name="JUAN MANUEL LOZANO GIL" userId="618ed11e-cb2c-4b03-8ac9-a8cf52f924c9" providerId="ADAL" clId="{AE6DC8AE-2302-42EA-A1AA-40268F4D08BC}" dt="2023-07-19T11:16:49.574" v="227" actId="478"/>
          <ac:picMkLst>
            <pc:docMk/>
            <pc:sldMk cId="387500787" sldId="257"/>
            <ac:picMk id="39" creationId="{E8B83790-B132-40A1-2C16-C45DD1B212E7}"/>
          </ac:picMkLst>
        </pc:picChg>
        <pc:cxnChg chg="del mod">
          <ac:chgData name="JUAN MANUEL LOZANO GIL" userId="618ed11e-cb2c-4b03-8ac9-a8cf52f924c9" providerId="ADAL" clId="{AE6DC8AE-2302-42EA-A1AA-40268F4D08BC}" dt="2023-07-19T16:19:15.938" v="391" actId="478"/>
          <ac:cxnSpMkLst>
            <pc:docMk/>
            <pc:sldMk cId="387500787" sldId="257"/>
            <ac:cxnSpMk id="32" creationId="{DCA6A179-AECC-8C2E-8A62-8665EEA9875B}"/>
          </ac:cxnSpMkLst>
        </pc:cxnChg>
        <pc:cxnChg chg="del mod">
          <ac:chgData name="JUAN MANUEL LOZANO GIL" userId="618ed11e-cb2c-4b03-8ac9-a8cf52f924c9" providerId="ADAL" clId="{AE6DC8AE-2302-42EA-A1AA-40268F4D08BC}" dt="2023-07-19T16:19:10.829" v="389" actId="478"/>
          <ac:cxnSpMkLst>
            <pc:docMk/>
            <pc:sldMk cId="387500787" sldId="257"/>
            <ac:cxnSpMk id="37" creationId="{AD8D1F5A-2DE9-AAB7-4700-9AD5229D0A2C}"/>
          </ac:cxnSpMkLst>
        </pc:cxnChg>
        <pc:cxnChg chg="mod">
          <ac:chgData name="JUAN MANUEL LOZANO GIL" userId="618ed11e-cb2c-4b03-8ac9-a8cf52f924c9" providerId="ADAL" clId="{AE6DC8AE-2302-42EA-A1AA-40268F4D08BC}" dt="2023-07-19T16:18:50.942" v="378"/>
          <ac:cxnSpMkLst>
            <pc:docMk/>
            <pc:sldMk cId="387500787" sldId="257"/>
            <ac:cxnSpMk id="38" creationId="{AF70B35C-4EE0-E8F9-D671-5868EF7C2A91}"/>
          </ac:cxnSpMkLst>
        </pc:cxnChg>
        <pc:cxnChg chg="mod">
          <ac:chgData name="JUAN MANUEL LOZANO GIL" userId="618ed11e-cb2c-4b03-8ac9-a8cf52f924c9" providerId="ADAL" clId="{AE6DC8AE-2302-42EA-A1AA-40268F4D08BC}" dt="2023-07-19T16:18:50.942" v="378"/>
          <ac:cxnSpMkLst>
            <pc:docMk/>
            <pc:sldMk cId="387500787" sldId="257"/>
            <ac:cxnSpMk id="39" creationId="{09C1BE32-BAEC-A6E8-7E03-1663659CC8F8}"/>
          </ac:cxnSpMkLst>
        </pc:cxnChg>
        <pc:cxnChg chg="mod">
          <ac:chgData name="JUAN MANUEL LOZANO GIL" userId="618ed11e-cb2c-4b03-8ac9-a8cf52f924c9" providerId="ADAL" clId="{AE6DC8AE-2302-42EA-A1AA-40268F4D08BC}" dt="2023-07-19T16:18:50.942" v="378"/>
          <ac:cxnSpMkLst>
            <pc:docMk/>
            <pc:sldMk cId="387500787" sldId="257"/>
            <ac:cxnSpMk id="40" creationId="{11360832-570B-4FA9-4B9E-ED21D5414C90}"/>
          </ac:cxnSpMkLst>
        </pc:cxnChg>
        <pc:cxnChg chg="mod">
          <ac:chgData name="JUAN MANUEL LOZANO GIL" userId="618ed11e-cb2c-4b03-8ac9-a8cf52f924c9" providerId="ADAL" clId="{AE6DC8AE-2302-42EA-A1AA-40268F4D08BC}" dt="2023-07-19T16:18:50.942" v="378"/>
          <ac:cxnSpMkLst>
            <pc:docMk/>
            <pc:sldMk cId="387500787" sldId="257"/>
            <ac:cxnSpMk id="41" creationId="{4FE8D7A6-9148-23E1-3FD4-6053848A3B92}"/>
          </ac:cxnSpMkLst>
        </pc:cxnChg>
      </pc:sldChg>
      <pc:sldChg chg="addSp delSp modSp del mod">
        <pc:chgData name="JUAN MANUEL LOZANO GIL" userId="618ed11e-cb2c-4b03-8ac9-a8cf52f924c9" providerId="ADAL" clId="{AE6DC8AE-2302-42EA-A1AA-40268F4D08BC}" dt="2023-07-19T11:05:23.118" v="71" actId="47"/>
        <pc:sldMkLst>
          <pc:docMk/>
          <pc:sldMk cId="2860491393" sldId="258"/>
        </pc:sldMkLst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2" creationId="{F9D90965-11B9-B89A-CD49-86E9DC7AC05E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3" creationId="{79A126E4-6F4C-074D-2CDC-4BD9DF390A42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4" creationId="{1B8E72D8-1892-3747-D63B-9CEE1596979D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8" creationId="{5773C4E2-C6E0-2569-F388-9FC50316B98D}"/>
          </ac:spMkLst>
        </pc:spChg>
        <pc:spChg chg="add mod">
          <ac:chgData name="JUAN MANUEL LOZANO GIL" userId="618ed11e-cb2c-4b03-8ac9-a8cf52f924c9" providerId="ADAL" clId="{AE6DC8AE-2302-42EA-A1AA-40268F4D08BC}" dt="2023-07-19T11:02:45.760" v="6" actId="1076"/>
          <ac:spMkLst>
            <pc:docMk/>
            <pc:sldMk cId="2860491393" sldId="258"/>
            <ac:spMk id="21" creationId="{4C5A4A2D-54FF-F9E7-7EDC-25FB3CFA6240}"/>
          </ac:spMkLst>
        </pc:spChg>
        <pc:spChg chg="add mod">
          <ac:chgData name="JUAN MANUEL LOZANO GIL" userId="618ed11e-cb2c-4b03-8ac9-a8cf52f924c9" providerId="ADAL" clId="{AE6DC8AE-2302-42EA-A1AA-40268F4D08BC}" dt="2023-07-19T11:02:33.542" v="3" actId="164"/>
          <ac:spMkLst>
            <pc:docMk/>
            <pc:sldMk cId="2860491393" sldId="258"/>
            <ac:spMk id="22" creationId="{11B3D120-CFB2-8BA0-1939-4B9EDBADB7EA}"/>
          </ac:spMkLst>
        </pc:spChg>
        <pc:spChg chg="add del mod">
          <ac:chgData name="JUAN MANUEL LOZANO GIL" userId="618ed11e-cb2c-4b03-8ac9-a8cf52f924c9" providerId="ADAL" clId="{AE6DC8AE-2302-42EA-A1AA-40268F4D08BC}" dt="2023-07-19T11:02:42.529" v="5" actId="478"/>
          <ac:spMkLst>
            <pc:docMk/>
            <pc:sldMk cId="2860491393" sldId="258"/>
            <ac:spMk id="23" creationId="{62FB5B80-C421-5DA1-C44E-1007D56B255E}"/>
          </ac:spMkLst>
        </pc:spChg>
        <pc:spChg chg="add mod">
          <ac:chgData name="JUAN MANUEL LOZANO GIL" userId="618ed11e-cb2c-4b03-8ac9-a8cf52f924c9" providerId="ADAL" clId="{AE6DC8AE-2302-42EA-A1AA-40268F4D08BC}" dt="2023-07-19T11:03:37.576" v="25" actId="1037"/>
          <ac:spMkLst>
            <pc:docMk/>
            <pc:sldMk cId="2860491393" sldId="258"/>
            <ac:spMk id="24" creationId="{BC14517D-1FC6-44A9-A0FB-A0B4B743B82B}"/>
          </ac:spMkLst>
        </pc:spChg>
        <pc:spChg chg="add mod">
          <ac:chgData name="JUAN MANUEL LOZANO GIL" userId="618ed11e-cb2c-4b03-8ac9-a8cf52f924c9" providerId="ADAL" clId="{AE6DC8AE-2302-42EA-A1AA-40268F4D08BC}" dt="2023-07-19T11:02:33.542" v="3" actId="164"/>
          <ac:spMkLst>
            <pc:docMk/>
            <pc:sldMk cId="2860491393" sldId="258"/>
            <ac:spMk id="25" creationId="{4E4AB24D-E33E-E1AF-FB0E-70127ADE7546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29" creationId="{D3DB174C-10F2-F6E0-AA63-4002509948D3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32" creationId="{0DDAFD28-20F1-385F-18AB-284038AAE9B0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36" creationId="{7B5E06C9-E8AC-F79B-49C0-62474A6786F2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58" creationId="{DA9C0367-C746-1F75-B0CD-30C330BFC6E4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59" creationId="{828D087D-B454-4477-E550-E31F2A808496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65" creationId="{F064E958-1712-56DF-238F-E2F035C4367C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66" creationId="{F4FF40EB-946E-3A6B-20C7-F4FD333134CA}"/>
          </ac:spMkLst>
        </pc:spChg>
        <pc:spChg chg="del">
          <ac:chgData name="JUAN MANUEL LOZANO GIL" userId="618ed11e-cb2c-4b03-8ac9-a8cf52f924c9" providerId="ADAL" clId="{AE6DC8AE-2302-42EA-A1AA-40268F4D08BC}" dt="2023-07-19T11:01:40.435" v="1" actId="478"/>
          <ac:spMkLst>
            <pc:docMk/>
            <pc:sldMk cId="2860491393" sldId="258"/>
            <ac:spMk id="67" creationId="{7F152798-73F4-22FF-0EE5-BFD03457299F}"/>
          </ac:spMkLst>
        </pc:spChg>
        <pc:grpChg chg="add mod">
          <ac:chgData name="JUAN MANUEL LOZANO GIL" userId="618ed11e-cb2c-4b03-8ac9-a8cf52f924c9" providerId="ADAL" clId="{AE6DC8AE-2302-42EA-A1AA-40268F4D08BC}" dt="2023-07-19T11:03:34.762" v="19" actId="14100"/>
          <ac:grpSpMkLst>
            <pc:docMk/>
            <pc:sldMk cId="2860491393" sldId="258"/>
            <ac:grpSpMk id="26" creationId="{36351254-087F-8B50-57A1-D07ADCCCA381}"/>
          </ac:grpSpMkLst>
        </pc:grpChg>
        <pc:grpChg chg="del">
          <ac:chgData name="JUAN MANUEL LOZANO GIL" userId="618ed11e-cb2c-4b03-8ac9-a8cf52f924c9" providerId="ADAL" clId="{AE6DC8AE-2302-42EA-A1AA-40268F4D08BC}" dt="2023-07-19T11:01:40.435" v="1" actId="478"/>
          <ac:grpSpMkLst>
            <pc:docMk/>
            <pc:sldMk cId="2860491393" sldId="258"/>
            <ac:grpSpMk id="31" creationId="{E2CAE058-47B3-DC66-5560-FA2CD01F9303}"/>
          </ac:grpSpMkLst>
        </pc:grpChg>
        <pc:grpChg chg="del">
          <ac:chgData name="JUAN MANUEL LOZANO GIL" userId="618ed11e-cb2c-4b03-8ac9-a8cf52f924c9" providerId="ADAL" clId="{AE6DC8AE-2302-42EA-A1AA-40268F4D08BC}" dt="2023-07-19T11:01:40.435" v="1" actId="478"/>
          <ac:grpSpMkLst>
            <pc:docMk/>
            <pc:sldMk cId="2860491393" sldId="258"/>
            <ac:grpSpMk id="33" creationId="{20BDCBC8-51D1-41FD-88D5-43AEEA46DA21}"/>
          </ac:grpSpMkLst>
        </pc:grpChg>
        <pc:grpChg chg="del">
          <ac:chgData name="JUAN MANUEL LOZANO GIL" userId="618ed11e-cb2c-4b03-8ac9-a8cf52f924c9" providerId="ADAL" clId="{AE6DC8AE-2302-42EA-A1AA-40268F4D08BC}" dt="2023-07-19T11:01:40.435" v="1" actId="478"/>
          <ac:grpSpMkLst>
            <pc:docMk/>
            <pc:sldMk cId="2860491393" sldId="258"/>
            <ac:grpSpMk id="64" creationId="{A6FE1016-2A3F-AC26-ED41-361693AB8198}"/>
          </ac:grpSpMkLst>
        </pc:grpChg>
        <pc:grpChg chg="del">
          <ac:chgData name="JUAN MANUEL LOZANO GIL" userId="618ed11e-cb2c-4b03-8ac9-a8cf52f924c9" providerId="ADAL" clId="{AE6DC8AE-2302-42EA-A1AA-40268F4D08BC}" dt="2023-07-19T11:01:40.435" v="1" actId="478"/>
          <ac:grpSpMkLst>
            <pc:docMk/>
            <pc:sldMk cId="2860491393" sldId="258"/>
            <ac:grpSpMk id="68" creationId="{EDE8E204-7F0E-208F-EB7A-81EFD0FE618B}"/>
          </ac:grpSpMkLst>
        </pc:grpChg>
        <pc:picChg chg="del">
          <ac:chgData name="JUAN MANUEL LOZANO GIL" userId="618ed11e-cb2c-4b03-8ac9-a8cf52f924c9" providerId="ADAL" clId="{AE6DC8AE-2302-42EA-A1AA-40268F4D08BC}" dt="2023-07-19T11:01:40.435" v="1" actId="478"/>
          <ac:picMkLst>
            <pc:docMk/>
            <pc:sldMk cId="2860491393" sldId="258"/>
            <ac:picMk id="30" creationId="{CC5382B6-4F70-EC2E-215A-07B1AC046252}"/>
          </ac:picMkLst>
        </pc:picChg>
        <pc:picChg chg="del">
          <ac:chgData name="JUAN MANUEL LOZANO GIL" userId="618ed11e-cb2c-4b03-8ac9-a8cf52f924c9" providerId="ADAL" clId="{AE6DC8AE-2302-42EA-A1AA-40268F4D08BC}" dt="2023-07-19T11:01:40.435" v="1" actId="478"/>
          <ac:picMkLst>
            <pc:docMk/>
            <pc:sldMk cId="2860491393" sldId="258"/>
            <ac:picMk id="34" creationId="{92ECEA78-A2D2-3378-562F-27F11BF467A7}"/>
          </ac:picMkLst>
        </pc:picChg>
        <pc:picChg chg="del">
          <ac:chgData name="JUAN MANUEL LOZANO GIL" userId="618ed11e-cb2c-4b03-8ac9-a8cf52f924c9" providerId="ADAL" clId="{AE6DC8AE-2302-42EA-A1AA-40268F4D08BC}" dt="2023-07-19T11:01:40.435" v="1" actId="478"/>
          <ac:picMkLst>
            <pc:docMk/>
            <pc:sldMk cId="2860491393" sldId="258"/>
            <ac:picMk id="35" creationId="{BE0F3318-E226-9648-0369-3F5D1C87D6F4}"/>
          </ac:picMkLst>
        </pc:picChg>
        <pc:picChg chg="add mod modCrop">
          <ac:chgData name="JUAN MANUEL LOZANO GIL" userId="618ed11e-cb2c-4b03-8ac9-a8cf52f924c9" providerId="ADAL" clId="{AE6DC8AE-2302-42EA-A1AA-40268F4D08BC}" dt="2023-07-19T11:03:56.720" v="51" actId="732"/>
          <ac:picMkLst>
            <pc:docMk/>
            <pc:sldMk cId="2860491393" sldId="258"/>
            <ac:picMk id="69" creationId="{A82BC5BA-94A5-957E-6226-EACC77E38221}"/>
          </ac:picMkLst>
        </pc:picChg>
        <pc:picChg chg="add mod modCrop">
          <ac:chgData name="JUAN MANUEL LOZANO GIL" userId="618ed11e-cb2c-4b03-8ac9-a8cf52f924c9" providerId="ADAL" clId="{AE6DC8AE-2302-42EA-A1AA-40268F4D08BC}" dt="2023-07-19T11:03:45.889" v="26" actId="732"/>
          <ac:picMkLst>
            <pc:docMk/>
            <pc:sldMk cId="2860491393" sldId="258"/>
            <ac:picMk id="71" creationId="{C7B9EBFF-FB3E-7984-48C5-90C72A11CBF0}"/>
          </ac:picMkLst>
        </pc:pic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11" creationId="{9D73E918-DCA0-2DF1-ED2B-404242F0910A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14" creationId="{9F48C4E8-6221-156B-0F41-51A23DD54686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17" creationId="{7470D822-AB04-7F40-7F52-468FF9E0B50F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20" creationId="{1EFDB093-4404-6E5A-ACE2-0A12877D5822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56" creationId="{F58A9D6E-16BB-2EB5-1515-F0583110A374}"/>
          </ac:cxnSpMkLst>
        </pc:cxnChg>
        <pc:cxnChg chg="del">
          <ac:chgData name="JUAN MANUEL LOZANO GIL" userId="618ed11e-cb2c-4b03-8ac9-a8cf52f924c9" providerId="ADAL" clId="{AE6DC8AE-2302-42EA-A1AA-40268F4D08BC}" dt="2023-07-19T11:01:40.435" v="1" actId="478"/>
          <ac:cxnSpMkLst>
            <pc:docMk/>
            <pc:sldMk cId="2860491393" sldId="258"/>
            <ac:cxnSpMk id="57" creationId="{68460041-6498-1223-9006-01C8ADFE6EB9}"/>
          </ac:cxnSpMkLst>
        </pc:cxnChg>
      </pc:sldChg>
      <pc:sldChg chg="add del">
        <pc:chgData name="JUAN MANUEL LOZANO GIL" userId="618ed11e-cb2c-4b03-8ac9-a8cf52f924c9" providerId="ADAL" clId="{AE6DC8AE-2302-42EA-A1AA-40268F4D08BC}" dt="2023-07-19T11:19:37.002" v="255" actId="47"/>
        <pc:sldMkLst>
          <pc:docMk/>
          <pc:sldMk cId="3613694079" sldId="258"/>
        </pc:sldMkLst>
      </pc:sldChg>
    </pc:docChg>
  </pc:docChgLst>
  <pc:docChgLst>
    <pc:chgData name="JUAN MANUEL LOZANO GIL" userId="618ed11e-cb2c-4b03-8ac9-a8cf52f924c9" providerId="ADAL" clId="{386DC46B-41D5-40B2-A6A2-885422854031}"/>
    <pc:docChg chg="undo redo custSel modSld">
      <pc:chgData name="JUAN MANUEL LOZANO GIL" userId="618ed11e-cb2c-4b03-8ac9-a8cf52f924c9" providerId="ADAL" clId="{386DC46B-41D5-40B2-A6A2-885422854031}" dt="2022-10-24T11:18:15.923" v="393" actId="20577"/>
      <pc:docMkLst>
        <pc:docMk/>
      </pc:docMkLst>
      <pc:sldChg chg="addSp delSp modSp mod">
        <pc:chgData name="JUAN MANUEL LOZANO GIL" userId="618ed11e-cb2c-4b03-8ac9-a8cf52f924c9" providerId="ADAL" clId="{386DC46B-41D5-40B2-A6A2-885422854031}" dt="2022-10-24T11:18:15.923" v="393" actId="20577"/>
        <pc:sldMkLst>
          <pc:docMk/>
          <pc:sldMk cId="3278798907" sldId="256"/>
        </pc:sldMkLst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" creationId="{9B2CD68D-1162-BD7B-04C0-5EA88A3A3A9E}"/>
          </ac:spMkLst>
        </pc:spChg>
        <pc:spChg chg="mod">
          <ac:chgData name="JUAN MANUEL LOZANO GIL" userId="618ed11e-cb2c-4b03-8ac9-a8cf52f924c9" providerId="ADAL" clId="{386DC46B-41D5-40B2-A6A2-885422854031}" dt="2022-10-24T11:16:37.550" v="331" actId="1076"/>
          <ac:spMkLst>
            <pc:docMk/>
            <pc:sldMk cId="3278798907" sldId="256"/>
            <ac:spMk id="11" creationId="{77509BA6-8B87-6BEF-46F0-E18A14B39EB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28" creationId="{6FE0C5C9-EFFF-D8EF-6794-40A8A3B3FDB4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3" creationId="{69A63828-D0E6-C303-7DAB-022683830F6B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4" creationId="{EC910EE7-D130-C396-5EB0-59BC79EF144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6" creationId="{7AACA306-674B-1C70-235C-CCCCACCF8049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7" creationId="{40B58694-FE1E-CCFD-0228-0AA311C76DF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8" creationId="{BD6261B1-AF8A-600C-86F5-AC0B8B5DEF74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9" creationId="{31A25F3E-6C68-F161-3D0F-F200414B1A30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40" creationId="{3638FD81-EEFB-3605-A26A-B156E0406D02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41" creationId="{BBD7C682-AC1C-3AC2-4AB1-81C157A2132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60" creationId="{43D45783-35DE-6202-F1E7-93A721736D85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61" creationId="{29E10A20-1F20-FCB7-63FA-D9EDDADD0B1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66" creationId="{6E9FCBC0-E68F-83A1-B005-C1EF0A517685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15" creationId="{A06224D5-42DC-2220-0691-7BB9BAC19105}"/>
          </ac:spMkLst>
        </pc:spChg>
        <pc:spChg chg="mod">
          <ac:chgData name="JUAN MANUEL LOZANO GIL" userId="618ed11e-cb2c-4b03-8ac9-a8cf52f924c9" providerId="ADAL" clId="{386DC46B-41D5-40B2-A6A2-885422854031}" dt="2022-10-24T11:18:11.089" v="387" actId="20577"/>
          <ac:spMkLst>
            <pc:docMk/>
            <pc:sldMk cId="3278798907" sldId="256"/>
            <ac:spMk id="118" creationId="{4E9B62DF-D897-38D9-F600-2AB133946753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21" creationId="{FC76A523-D22C-9CE9-86C0-3291B5E55716}"/>
          </ac:spMkLst>
        </pc:spChg>
        <pc:spChg chg="mod">
          <ac:chgData name="JUAN MANUEL LOZANO GIL" userId="618ed11e-cb2c-4b03-8ac9-a8cf52f924c9" providerId="ADAL" clId="{386DC46B-41D5-40B2-A6A2-885422854031}" dt="2022-10-24T11:18:15.923" v="393" actId="20577"/>
          <ac:spMkLst>
            <pc:docMk/>
            <pc:sldMk cId="3278798907" sldId="256"/>
            <ac:spMk id="123" creationId="{ADB6E049-3E35-ED91-D48D-5CDE07739EFB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25" creationId="{ADB6E049-3E35-ED91-D48D-5CDE07739EFB}"/>
          </ac:spMkLst>
        </pc:spChg>
        <pc:spChg chg="mod">
          <ac:chgData name="JUAN MANUEL LOZANO GIL" userId="618ed11e-cb2c-4b03-8ac9-a8cf52f924c9" providerId="ADAL" clId="{386DC46B-41D5-40B2-A6A2-885422854031}" dt="2022-10-24T11:18:02.974" v="382" actId="20577"/>
          <ac:spMkLst>
            <pc:docMk/>
            <pc:sldMk cId="3278798907" sldId="256"/>
            <ac:spMk id="128" creationId="{4DDF8618-B36F-119A-CA7A-EE88C352364F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29" creationId="{7F1575BB-08B9-8701-715E-E77B24154E6A}"/>
          </ac:spMkLst>
        </pc:spChg>
        <pc:spChg chg="mod topLvl">
          <ac:chgData name="JUAN MANUEL LOZANO GIL" userId="618ed11e-cb2c-4b03-8ac9-a8cf52f924c9" providerId="ADAL" clId="{386DC46B-41D5-40B2-A6A2-885422854031}" dt="2022-10-20T14:22:15.187" v="260" actId="1076"/>
          <ac:spMkLst>
            <pc:docMk/>
            <pc:sldMk cId="3278798907" sldId="256"/>
            <ac:spMk id="130" creationId="{106C1AF1-94C5-F629-15FD-623F681A8C50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31" creationId="{1865E9DC-E288-5D5B-E8CE-3964A7FF498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32" creationId="{3340EB4D-D450-3A93-EC03-0A0352BE4422}"/>
          </ac:spMkLst>
        </pc:spChg>
        <pc:spChg chg="del mod topLvl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137" creationId="{390F851F-D000-3AC9-06B7-0086914887CC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37" creationId="{48ED9661-A95F-EB2D-3C34-8D798C4666EB}"/>
          </ac:spMkLst>
        </pc:spChg>
        <pc:spChg chg="del mod topLvl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138" creationId="{9B8EB6DE-BB15-39CA-5B0F-0224CBC5D349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40" creationId="{28CA052F-27E2-63EB-F3F6-80FE3D734D00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42" creationId="{4DDF8618-B36F-119A-CA7A-EE88C352364F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43" creationId="{804C4DA3-BFC8-7599-5D2F-611F69F9E7D6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55" creationId="{C16583F2-6CA4-58DD-020E-AF1AA81B75F4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88" creationId="{F7D03FBE-A81A-6BC4-1C33-3A183B86791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0" creationId="{FAEC6570-2D19-B589-D262-D645471A2FA8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1" creationId="{913B9BB6-4065-0AE0-54C4-70791E5BB21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3" creationId="{A5FAB260-0C17-FE6B-E06E-4D090A964AED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4" creationId="{34F0A8C1-B00F-FC42-FA0E-7F64DFB6A559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6" creationId="{6B5EAE6D-5B4A-9AA1-129A-AAA3DD980E3A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7" creationId="{DE770029-C13A-362F-EA6B-452F863DBC8A}"/>
          </ac:spMkLst>
        </pc:spChg>
        <pc:spChg chg="add del mod">
          <ac:chgData name="JUAN MANUEL LOZANO GIL" userId="618ed11e-cb2c-4b03-8ac9-a8cf52f924c9" providerId="ADAL" clId="{386DC46B-41D5-40B2-A6A2-885422854031}" dt="2022-10-20T14:20:01.245" v="186" actId="478"/>
          <ac:spMkLst>
            <pc:docMk/>
            <pc:sldMk cId="3278798907" sldId="256"/>
            <ac:spMk id="199" creationId="{A7AD7E3A-B856-9E64-DF0B-E6A0B322067C}"/>
          </ac:spMkLst>
        </pc:spChg>
        <pc:spChg chg="add del mod">
          <ac:chgData name="JUAN MANUEL LOZANO GIL" userId="618ed11e-cb2c-4b03-8ac9-a8cf52f924c9" providerId="ADAL" clId="{386DC46B-41D5-40B2-A6A2-885422854031}" dt="2022-10-20T14:20:13.054" v="188" actId="478"/>
          <ac:spMkLst>
            <pc:docMk/>
            <pc:sldMk cId="3278798907" sldId="256"/>
            <ac:spMk id="200" creationId="{537282EA-837B-E7EF-E08B-02EE580A566C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201" creationId="{02190607-545A-EAEF-B8B5-30DDD473E609}"/>
          </ac:spMkLst>
        </pc:spChg>
        <pc:spChg chg="add del mod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201" creationId="{218272E8-6C89-A228-9D53-1F700DFE446A}"/>
          </ac:spMkLst>
        </pc:spChg>
        <pc:spChg chg="add del mod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202" creationId="{21713EA9-4EE6-F30C-8A08-973F58C66B40}"/>
          </ac:spMkLst>
        </pc:spChg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02" creationId="{71A1120A-ECF7-C944-D0A7-629ED2FD6F5D}"/>
          </ac:spMkLst>
        </pc:spChg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03" creationId="{2A665B5F-90E1-1DF7-3916-53928A302641}"/>
          </ac:spMkLst>
        </pc:spChg>
        <pc:spChg chg="add del mod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203" creationId="{9B959AB3-A4D4-970E-F7C7-767207857FDA}"/>
          </ac:spMkLst>
        </pc:spChg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09" creationId="{0DCE5BAF-A005-6A19-35A8-D034638BD2A3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4" creationId="{096E130A-A6D5-3C57-16B3-BA6468B18430}"/>
          </ac:spMkLst>
        </pc:spChg>
        <pc:spChg chg="add del mod">
          <ac:chgData name="JUAN MANUEL LOZANO GIL" userId="618ed11e-cb2c-4b03-8ac9-a8cf52f924c9" providerId="ADAL" clId="{386DC46B-41D5-40B2-A6A2-885422854031}" dt="2022-10-20T14:21:22.265" v="234" actId="478"/>
          <ac:spMkLst>
            <pc:docMk/>
            <pc:sldMk cId="3278798907" sldId="256"/>
            <ac:spMk id="214" creationId="{0FF539EF-A098-4B9E-EAA1-B311F8B58E57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5" creationId="{6A5A3F08-CABA-0898-E275-1EF13EB458E9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6" creationId="{CC171BF4-3923-93D0-A2B7-A84907FFD4E7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7" creationId="{CE97B7D1-5542-35A6-3C5A-6E5AEB1C1B24}"/>
          </ac:spMkLst>
        </pc:spChg>
        <pc:spChg chg="mod">
          <ac:chgData name="JUAN MANUEL LOZANO GIL" userId="618ed11e-cb2c-4b03-8ac9-a8cf52f924c9" providerId="ADAL" clId="{386DC46B-41D5-40B2-A6A2-885422854031}" dt="2022-10-24T11:16:54.150" v="335" actId="1076"/>
          <ac:spMkLst>
            <pc:docMk/>
            <pc:sldMk cId="3278798907" sldId="256"/>
            <ac:spMk id="223" creationId="{2DE36C91-C97D-8322-64DF-0E5FE2EDE9A9}"/>
          </ac:spMkLst>
        </pc:spChg>
        <pc:spChg chg="mod">
          <ac:chgData name="JUAN MANUEL LOZANO GIL" userId="618ed11e-cb2c-4b03-8ac9-a8cf52f924c9" providerId="ADAL" clId="{386DC46B-41D5-40B2-A6A2-885422854031}" dt="2022-10-24T11:16:52.422" v="334" actId="1076"/>
          <ac:spMkLst>
            <pc:docMk/>
            <pc:sldMk cId="3278798907" sldId="256"/>
            <ac:spMk id="224" creationId="{503574D0-7BC7-B436-928C-75A3B1B06FF9}"/>
          </ac:spMkLst>
        </pc:spChg>
        <pc:spChg chg="mod">
          <ac:chgData name="JUAN MANUEL LOZANO GIL" userId="618ed11e-cb2c-4b03-8ac9-a8cf52f924c9" providerId="ADAL" clId="{386DC46B-41D5-40B2-A6A2-885422854031}" dt="2022-10-24T11:16:55.822" v="336" actId="1076"/>
          <ac:spMkLst>
            <pc:docMk/>
            <pc:sldMk cId="3278798907" sldId="256"/>
            <ac:spMk id="225" creationId="{71CD88CA-8D55-15DC-E634-2F94E77AA54E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26" creationId="{37181708-2CFA-36F6-E5C6-076FD5BBA641}"/>
          </ac:spMkLst>
        </pc:spChg>
        <pc:spChg chg="del mod">
          <ac:chgData name="JUAN MANUEL LOZANO GIL" userId="618ed11e-cb2c-4b03-8ac9-a8cf52f924c9" providerId="ADAL" clId="{386DC46B-41D5-40B2-A6A2-885422854031}" dt="2022-10-20T14:23:36.350" v="322" actId="478"/>
          <ac:spMkLst>
            <pc:docMk/>
            <pc:sldMk cId="3278798907" sldId="256"/>
            <ac:spMk id="226" creationId="{7CE19FDC-6765-7356-80A2-3A7989E270FD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30" creationId="{D21C704E-B1F3-C166-FDBA-FB8F1A731670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33" creationId="{8A38D3C8-C0E0-5381-3C57-739D236EE3FF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35" creationId="{26B41E0A-C7CD-8586-90D4-F0E3A6F906C7}"/>
          </ac:spMkLst>
        </pc:spChg>
        <pc:spChg chg="mod">
          <ac:chgData name="JUAN MANUEL LOZANO GIL" userId="618ed11e-cb2c-4b03-8ac9-a8cf52f924c9" providerId="ADAL" clId="{386DC46B-41D5-40B2-A6A2-885422854031}" dt="2022-10-20T14:00:58.511" v="120" actId="14100"/>
          <ac:spMkLst>
            <pc:docMk/>
            <pc:sldMk cId="3278798907" sldId="256"/>
            <ac:spMk id="237" creationId="{ADC8A64C-7A54-ED6F-28BB-0B538EC26499}"/>
          </ac:spMkLst>
        </pc:spChg>
        <pc:spChg chg="mod">
          <ac:chgData name="JUAN MANUEL LOZANO GIL" userId="618ed11e-cb2c-4b03-8ac9-a8cf52f924c9" providerId="ADAL" clId="{386DC46B-41D5-40B2-A6A2-885422854031}" dt="2022-10-20T14:23:01.313" v="272"/>
          <ac:spMkLst>
            <pc:docMk/>
            <pc:sldMk cId="3278798907" sldId="256"/>
            <ac:spMk id="238" creationId="{2DE36C91-C97D-8322-64DF-0E5FE2EDE9A9}"/>
          </ac:spMkLst>
        </pc:spChg>
        <pc:spChg chg="mod">
          <ac:chgData name="JUAN MANUEL LOZANO GIL" userId="618ed11e-cb2c-4b03-8ac9-a8cf52f924c9" providerId="ADAL" clId="{386DC46B-41D5-40B2-A6A2-885422854031}" dt="2022-10-20T14:00:58.511" v="120" actId="14100"/>
          <ac:spMkLst>
            <pc:docMk/>
            <pc:sldMk cId="3278798907" sldId="256"/>
            <ac:spMk id="239" creationId="{AAE3D7B6-9C43-9684-18F2-26E8D2B95261}"/>
          </ac:spMkLst>
        </pc:spChg>
        <pc:spChg chg="mod">
          <ac:chgData name="JUAN MANUEL LOZANO GIL" userId="618ed11e-cb2c-4b03-8ac9-a8cf52f924c9" providerId="ADAL" clId="{386DC46B-41D5-40B2-A6A2-885422854031}" dt="2022-10-20T14:23:01.313" v="272"/>
          <ac:spMkLst>
            <pc:docMk/>
            <pc:sldMk cId="3278798907" sldId="256"/>
            <ac:spMk id="240" creationId="{503574D0-7BC7-B436-928C-75A3B1B06FF9}"/>
          </ac:spMkLst>
        </pc:spChg>
        <pc:spChg chg="mod">
          <ac:chgData name="JUAN MANUEL LOZANO GIL" userId="618ed11e-cb2c-4b03-8ac9-a8cf52f924c9" providerId="ADAL" clId="{386DC46B-41D5-40B2-A6A2-885422854031}" dt="2022-10-20T14:00:58.511" v="120" actId="14100"/>
          <ac:spMkLst>
            <pc:docMk/>
            <pc:sldMk cId="3278798907" sldId="256"/>
            <ac:spMk id="241" creationId="{1785CE50-920E-0E03-5AAF-BC6BB3907611}"/>
          </ac:spMkLst>
        </pc:spChg>
        <pc:spChg chg="mod">
          <ac:chgData name="JUAN MANUEL LOZANO GIL" userId="618ed11e-cb2c-4b03-8ac9-a8cf52f924c9" providerId="ADAL" clId="{386DC46B-41D5-40B2-A6A2-885422854031}" dt="2022-10-20T14:23:01.313" v="272"/>
          <ac:spMkLst>
            <pc:docMk/>
            <pc:sldMk cId="3278798907" sldId="256"/>
            <ac:spMk id="242" creationId="{71CD88CA-8D55-15DC-E634-2F94E77AA54E}"/>
          </ac:spMkLst>
        </pc:spChg>
        <pc:spChg chg="add mod">
          <ac:chgData name="JUAN MANUEL LOZANO GIL" userId="618ed11e-cb2c-4b03-8ac9-a8cf52f924c9" providerId="ADAL" clId="{386DC46B-41D5-40B2-A6A2-885422854031}" dt="2022-10-20T14:00:25.512" v="112" actId="164"/>
          <ac:spMkLst>
            <pc:docMk/>
            <pc:sldMk cId="3278798907" sldId="256"/>
            <ac:spMk id="244" creationId="{870F9BB4-5E94-83CC-2FBF-D612747F3FF6}"/>
          </ac:spMkLst>
        </pc:spChg>
        <pc:spChg chg="add mod">
          <ac:chgData name="JUAN MANUEL LOZANO GIL" userId="618ed11e-cb2c-4b03-8ac9-a8cf52f924c9" providerId="ADAL" clId="{386DC46B-41D5-40B2-A6A2-885422854031}" dt="2022-10-20T14:00:43.272" v="117" actId="164"/>
          <ac:spMkLst>
            <pc:docMk/>
            <pc:sldMk cId="3278798907" sldId="256"/>
            <ac:spMk id="247" creationId="{9EEFF06B-53DF-E558-78A1-3CA16349A03D}"/>
          </ac:spMkLst>
        </pc:spChg>
        <pc:spChg chg="add mod">
          <ac:chgData name="JUAN MANUEL LOZANO GIL" userId="618ed11e-cb2c-4b03-8ac9-a8cf52f924c9" providerId="ADAL" clId="{386DC46B-41D5-40B2-A6A2-885422854031}" dt="2022-10-20T14:23:53.133" v="327" actId="1076"/>
          <ac:spMkLst>
            <pc:docMk/>
            <pc:sldMk cId="3278798907" sldId="256"/>
            <ac:spMk id="250" creationId="{7AA6AC05-9DD5-D083-63F3-9B40C1DA53F2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6" creationId="{E4AAB65D-28F3-7387-E46C-AC718116A4F8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7" creationId="{A78334C1-347E-48A5-D9B5-2E29FE69F1AD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8" creationId="{303F0DA0-E982-90D3-821F-36CC752D532A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9" creationId="{CD1D3C08-86C8-2ABF-8E87-74B9D152F1E1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60" creationId="{E902CA14-68A4-48CE-1B2D-A3D65A140A8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2" creationId="{61619F8F-3148-3FB1-A992-42C52C26E6D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3" creationId="{83497D59-873D-B5EF-13DC-DE7578E1B815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4" creationId="{6476E2A8-777C-3F20-1FFC-2A345EB173E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5" creationId="{8FF2B169-E400-A10F-C71A-EA26D4458792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6" creationId="{42628301-73F9-EDDA-03EA-60856626D61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7" creationId="{B5786838-D9DE-DB01-6B82-56697112CD6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8" creationId="{956DED26-4DF7-EFA5-9DA1-4E833350B141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9" creationId="{57180217-E868-B289-86B8-DED2CA48CA67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0" creationId="{0E6DF3B9-2C17-94F4-1CC3-FA14E40A6C34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1" creationId="{F45A74E9-7C7D-2FC2-AD03-B6FAD86BBB96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2" creationId="{1E2CA450-A78A-2B73-8762-4FEF2EF539D5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3" creationId="{EB804E63-8E46-77FB-A36C-06EDC167C2C6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4" creationId="{13AAFE3B-F8BF-9DE7-AC2E-20F8EB375353}"/>
          </ac:spMkLst>
        </pc:spChg>
        <pc:spChg chg="add mod">
          <ac:chgData name="JUAN MANUEL LOZANO GIL" userId="618ed11e-cb2c-4b03-8ac9-a8cf52f924c9" providerId="ADAL" clId="{386DC46B-41D5-40B2-A6A2-885422854031}" dt="2022-10-24T11:17:45.782" v="377" actId="1076"/>
          <ac:spMkLst>
            <pc:docMk/>
            <pc:sldMk cId="3278798907" sldId="256"/>
            <ac:spMk id="330" creationId="{3B65D7B5-A3E2-577C-C8DD-AA8F8F51F348}"/>
          </ac:spMkLst>
        </pc:spChg>
        <pc:grpChg chg="add mod">
          <ac:chgData name="JUAN MANUEL LOZANO GIL" userId="618ed11e-cb2c-4b03-8ac9-a8cf52f924c9" providerId="ADAL" clId="{386DC46B-41D5-40B2-A6A2-885422854031}" dt="2022-10-20T14:21:40.427" v="239" actId="1076"/>
          <ac:grpSpMkLst>
            <pc:docMk/>
            <pc:sldMk cId="3278798907" sldId="256"/>
            <ac:grpSpMk id="5" creationId="{30313194-4B88-D4FC-5F98-5FAD5B936A2E}"/>
          </ac:grpSpMkLst>
        </pc:grpChg>
        <pc:grpChg chg="mod">
          <ac:chgData name="JUAN MANUEL LOZANO GIL" userId="618ed11e-cb2c-4b03-8ac9-a8cf52f924c9" providerId="ADAL" clId="{386DC46B-41D5-40B2-A6A2-885422854031}" dt="2022-10-24T11:17:51.384" v="378" actId="1076"/>
          <ac:grpSpMkLst>
            <pc:docMk/>
            <pc:sldMk cId="3278798907" sldId="256"/>
            <ac:grpSpMk id="12" creationId="{FD2B8B51-4257-7A31-F5BD-6F4E817CE3D7}"/>
          </ac:grpSpMkLst>
        </pc:grpChg>
        <pc:grpChg chg="mod">
          <ac:chgData name="JUAN MANUEL LOZANO GIL" userId="618ed11e-cb2c-4b03-8ac9-a8cf52f924c9" providerId="ADAL" clId="{386DC46B-41D5-40B2-A6A2-885422854031}" dt="2022-10-24T11:17:51.384" v="378" actId="1076"/>
          <ac:grpSpMkLst>
            <pc:docMk/>
            <pc:sldMk cId="3278798907" sldId="256"/>
            <ac:grpSpMk id="14" creationId="{A3B00373-ECCE-3F0D-9077-8FAD8A5CD4E7}"/>
          </ac:grpSpMkLst>
        </pc:grpChg>
        <pc:grpChg chg="mod">
          <ac:chgData name="JUAN MANUEL LOZANO GIL" userId="618ed11e-cb2c-4b03-8ac9-a8cf52f924c9" providerId="ADAL" clId="{386DC46B-41D5-40B2-A6A2-885422854031}" dt="2022-10-24T11:17:51.384" v="378" actId="1076"/>
          <ac:grpSpMkLst>
            <pc:docMk/>
            <pc:sldMk cId="3278798907" sldId="256"/>
            <ac:grpSpMk id="23" creationId="{C689D05A-6159-D3DD-CE48-3B7FF27422C9}"/>
          </ac:grpSpMkLst>
        </pc:grpChg>
        <pc:grpChg chg="del mod topLvl">
          <ac:chgData name="JUAN MANUEL LOZANO GIL" userId="618ed11e-cb2c-4b03-8ac9-a8cf52f924c9" providerId="ADAL" clId="{386DC46B-41D5-40B2-A6A2-885422854031}" dt="2022-10-20T14:20:25.661" v="193" actId="478"/>
          <ac:grpSpMkLst>
            <pc:docMk/>
            <pc:sldMk cId="3278798907" sldId="256"/>
            <ac:grpSpMk id="23" creationId="{D913594C-D5D2-96BB-0977-AEA9E8447F49}"/>
          </ac:grpSpMkLst>
        </pc:grpChg>
        <pc:grpChg chg="mod topLvl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27" creationId="{C3D67D48-DBD6-F3C7-14EA-203AA1CEB286}"/>
          </ac:grpSpMkLst>
        </pc:grpChg>
        <pc:grpChg chg="mod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35" creationId="{5121F8BE-6AAD-93AE-7F46-DD245EED2E35}"/>
          </ac:grpSpMkLst>
        </pc:grpChg>
        <pc:grpChg chg="del mod topLvl">
          <ac:chgData name="JUAN MANUEL LOZANO GIL" userId="618ed11e-cb2c-4b03-8ac9-a8cf52f924c9" providerId="ADAL" clId="{386DC46B-41D5-40B2-A6A2-885422854031}" dt="2022-10-20T13:58:44.030" v="73" actId="165"/>
          <ac:grpSpMkLst>
            <pc:docMk/>
            <pc:sldMk cId="3278798907" sldId="256"/>
            <ac:grpSpMk id="121" creationId="{F93A7FC7-CC95-ECF6-E412-C4F69ED982DD}"/>
          </ac:grpSpMkLst>
        </pc:grpChg>
        <pc:grpChg chg="del mod">
          <ac:chgData name="JUAN MANUEL LOZANO GIL" userId="618ed11e-cb2c-4b03-8ac9-a8cf52f924c9" providerId="ADAL" clId="{386DC46B-41D5-40B2-A6A2-885422854031}" dt="2022-10-20T13:58:40.031" v="72" actId="165"/>
          <ac:grpSpMkLst>
            <pc:docMk/>
            <pc:sldMk cId="3278798907" sldId="256"/>
            <ac:grpSpMk id="125" creationId="{6B270B21-628C-F453-CA11-87D6C789E830}"/>
          </ac:grpSpMkLst>
        </pc:grpChg>
        <pc:grpChg chg="add del mod">
          <ac:chgData name="JUAN MANUEL LOZANO GIL" userId="618ed11e-cb2c-4b03-8ac9-a8cf52f924c9" providerId="ADAL" clId="{386DC46B-41D5-40B2-A6A2-885422854031}" dt="2022-10-20T13:59:29.367" v="88" actId="165"/>
          <ac:grpSpMkLst>
            <pc:docMk/>
            <pc:sldMk cId="3278798907" sldId="256"/>
            <ac:grpSpMk id="155" creationId="{A8ECDDAC-C8E6-16F1-C87B-DDB1461588F5}"/>
          </ac:grpSpMkLst>
        </pc:grpChg>
        <pc:grpChg chg="add mod">
          <ac:chgData name="JUAN MANUEL LOZANO GIL" userId="618ed11e-cb2c-4b03-8ac9-a8cf52f924c9" providerId="ADAL" clId="{386DC46B-41D5-40B2-A6A2-885422854031}" dt="2022-10-20T14:00:25.512" v="112" actId="164"/>
          <ac:grpSpMkLst>
            <pc:docMk/>
            <pc:sldMk cId="3278798907" sldId="256"/>
            <ac:grpSpMk id="156" creationId="{5C677AC8-3C01-91C1-D0CD-E62852EA011B}"/>
          </ac:grpSpMkLst>
        </pc:grpChg>
        <pc:grpChg chg="add mod">
          <ac:chgData name="JUAN MANUEL LOZANO GIL" userId="618ed11e-cb2c-4b03-8ac9-a8cf52f924c9" providerId="ADAL" clId="{386DC46B-41D5-40B2-A6A2-885422854031}" dt="2022-10-20T14:00:25.512" v="112" actId="164"/>
          <ac:grpSpMkLst>
            <pc:docMk/>
            <pc:sldMk cId="3278798907" sldId="256"/>
            <ac:grpSpMk id="157" creationId="{330B89BA-FF7E-0FA7-8141-B09FAFB82709}"/>
          </ac:grpSpMkLst>
        </pc:grpChg>
        <pc:grpChg chg="add mod">
          <ac:chgData name="JUAN MANUEL LOZANO GIL" userId="618ed11e-cb2c-4b03-8ac9-a8cf52f924c9" providerId="ADAL" clId="{386DC46B-41D5-40B2-A6A2-885422854031}" dt="2022-10-20T14:00:43.272" v="117" actId="164"/>
          <ac:grpSpMkLst>
            <pc:docMk/>
            <pc:sldMk cId="3278798907" sldId="256"/>
            <ac:grpSpMk id="185" creationId="{E6ACA5C0-119B-E861-E208-AC553AF53043}"/>
          </ac:grpSpMkLst>
        </pc:grpChg>
        <pc:grpChg chg="add mod">
          <ac:chgData name="JUAN MANUEL LOZANO GIL" userId="618ed11e-cb2c-4b03-8ac9-a8cf52f924c9" providerId="ADAL" clId="{386DC46B-41D5-40B2-A6A2-885422854031}" dt="2022-10-20T14:22:54.029" v="270" actId="14100"/>
          <ac:grpSpMkLst>
            <pc:docMk/>
            <pc:sldMk cId="3278798907" sldId="256"/>
            <ac:grpSpMk id="187" creationId="{B8A5B354-0C3C-948B-7552-8852D6F4978E}"/>
          </ac:grpSpMkLst>
        </pc:grpChg>
        <pc:grpChg chg="add del mod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188" creationId="{7A594213-BB89-0C86-54DC-251C0B1ECDF2}"/>
          </ac:grpSpMkLst>
        </pc:grpChg>
        <pc:grpChg chg="add mod">
          <ac:chgData name="JUAN MANUEL LOZANO GIL" userId="618ed11e-cb2c-4b03-8ac9-a8cf52f924c9" providerId="ADAL" clId="{386DC46B-41D5-40B2-A6A2-885422854031}" dt="2022-10-20T14:21:35.566" v="238" actId="164"/>
          <ac:grpSpMkLst>
            <pc:docMk/>
            <pc:sldMk cId="3278798907" sldId="256"/>
            <ac:grpSpMk id="189" creationId="{8ACC7B1E-E575-A5C9-001D-648B9DED9431}"/>
          </ac:grpSpMkLst>
        </pc:grpChg>
        <pc:grpChg chg="add del mod">
          <ac:chgData name="JUAN MANUEL LOZANO GIL" userId="618ed11e-cb2c-4b03-8ac9-a8cf52f924c9" providerId="ADAL" clId="{386DC46B-41D5-40B2-A6A2-885422854031}" dt="2022-10-20T14:19:29.165" v="148" actId="165"/>
          <ac:grpSpMkLst>
            <pc:docMk/>
            <pc:sldMk cId="3278798907" sldId="256"/>
            <ac:grpSpMk id="193" creationId="{3B65F110-4230-C43A-D519-8EBD9734CAF7}"/>
          </ac:grpSpMkLst>
        </pc:grpChg>
        <pc:grpChg chg="mod topLvl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199" creationId="{A5E5CDB5-C751-0E14-2CF2-8CD6EEB4673D}"/>
          </ac:grpSpMkLst>
        </pc:grpChg>
        <pc:grpChg chg="add mod">
          <ac:chgData name="JUAN MANUEL LOZANO GIL" userId="618ed11e-cb2c-4b03-8ac9-a8cf52f924c9" providerId="ADAL" clId="{386DC46B-41D5-40B2-A6A2-885422854031}" dt="2022-10-20T14:23:34.238" v="321" actId="1038"/>
          <ac:grpSpMkLst>
            <pc:docMk/>
            <pc:sldMk cId="3278798907" sldId="256"/>
            <ac:grpSpMk id="234" creationId="{0698EFBC-52C6-C31A-D27C-3FE0C28EFB1B}"/>
          </ac:grpSpMkLst>
        </pc:grpChg>
        <pc:grpChg chg="mod">
          <ac:chgData name="JUAN MANUEL LOZANO GIL" userId="618ed11e-cb2c-4b03-8ac9-a8cf52f924c9" providerId="ADAL" clId="{386DC46B-41D5-40B2-A6A2-885422854031}" dt="2022-10-20T14:23:01.313" v="272"/>
          <ac:grpSpMkLst>
            <pc:docMk/>
            <pc:sldMk cId="3278798907" sldId="256"/>
            <ac:grpSpMk id="236" creationId="{BF6763EE-8ADD-24AF-582E-13C132599002}"/>
          </ac:grpSpMkLst>
        </pc:grpChg>
        <pc:grpChg chg="add mod topLvl">
          <ac:chgData name="JUAN MANUEL LOZANO GIL" userId="618ed11e-cb2c-4b03-8ac9-a8cf52f924c9" providerId="ADAL" clId="{386DC46B-41D5-40B2-A6A2-885422854031}" dt="2022-10-20T13:59:45.783" v="92" actId="164"/>
          <ac:grpSpMkLst>
            <pc:docMk/>
            <pc:sldMk cId="3278798907" sldId="256"/>
            <ac:grpSpMk id="249" creationId="{903C2705-575E-59AC-7710-E1AFF7D9FE1F}"/>
          </ac:grpSpMkLst>
        </pc:grpChg>
        <pc:grpChg chg="mod">
          <ac:chgData name="JUAN MANUEL LOZANO GIL" userId="618ed11e-cb2c-4b03-8ac9-a8cf52f924c9" providerId="ADAL" clId="{386DC46B-41D5-40B2-A6A2-885422854031}" dt="2022-10-20T13:59:59.378" v="96"/>
          <ac:grpSpMkLst>
            <pc:docMk/>
            <pc:sldMk cId="3278798907" sldId="256"/>
            <ac:grpSpMk id="261" creationId="{01225E6C-879A-320D-15DA-4148DCB0AC30}"/>
          </ac:grpSpMkLst>
        </pc:grpChg>
        <pc:grpChg chg="mod">
          <ac:chgData name="JUAN MANUEL LOZANO GIL" userId="618ed11e-cb2c-4b03-8ac9-a8cf52f924c9" providerId="ADAL" clId="{386DC46B-41D5-40B2-A6A2-885422854031}" dt="2022-10-20T14:23:44.196" v="325" actId="1076"/>
          <ac:grpSpMkLst>
            <pc:docMk/>
            <pc:sldMk cId="3278798907" sldId="256"/>
            <ac:grpSpMk id="327" creationId="{C885E84B-C0CD-1058-8235-F7DBF41CF74E}"/>
          </ac:grpSpMkLst>
        </pc:grpChg>
        <pc:picChg chg="add mod modCrop">
          <ac:chgData name="JUAN MANUEL LOZANO GIL" userId="618ed11e-cb2c-4b03-8ac9-a8cf52f924c9" providerId="ADAL" clId="{386DC46B-41D5-40B2-A6A2-885422854031}" dt="2022-10-20T14:22:18.260" v="262" actId="208"/>
          <ac:picMkLst>
            <pc:docMk/>
            <pc:sldMk cId="3278798907" sldId="256"/>
            <ac:picMk id="4" creationId="{79CCC012-5C18-36BB-7BFB-CDF561A3F513}"/>
          </ac:picMkLst>
        </pc:picChg>
        <pc:picChg chg="mod topLvl">
          <ac:chgData name="JUAN MANUEL LOZANO GIL" userId="618ed11e-cb2c-4b03-8ac9-a8cf52f924c9" providerId="ADAL" clId="{386DC46B-41D5-40B2-A6A2-885422854031}" dt="2022-10-20T14:18:45.871" v="137" actId="165"/>
          <ac:picMkLst>
            <pc:docMk/>
            <pc:sldMk cId="3278798907" sldId="256"/>
            <ac:picMk id="8" creationId="{A3918CB1-7E0E-12FB-DEA9-93F0D716FC59}"/>
          </ac:picMkLst>
        </pc:picChg>
        <pc:picChg chg="mod modCrop">
          <ac:chgData name="JUAN MANUEL LOZANO GIL" userId="618ed11e-cb2c-4b03-8ac9-a8cf52f924c9" providerId="ADAL" clId="{386DC46B-41D5-40B2-A6A2-885422854031}" dt="2022-10-24T11:16:35.886" v="330" actId="1076"/>
          <ac:picMkLst>
            <pc:docMk/>
            <pc:sldMk cId="3278798907" sldId="256"/>
            <ac:picMk id="10" creationId="{07693468-5B9E-FA8D-8054-DC6892E7AA73}"/>
          </ac:picMkLst>
        </pc:picChg>
        <pc:picChg chg="del mod topLvl">
          <ac:chgData name="JUAN MANUEL LOZANO GIL" userId="618ed11e-cb2c-4b03-8ac9-a8cf52f924c9" providerId="ADAL" clId="{386DC46B-41D5-40B2-A6A2-885422854031}" dt="2022-10-20T14:20:24.299" v="192" actId="478"/>
          <ac:picMkLst>
            <pc:docMk/>
            <pc:sldMk cId="3278798907" sldId="256"/>
            <ac:picMk id="22" creationId="{A22DB6EA-1F9E-E42A-7BCC-7E3F6849E1E6}"/>
          </ac:picMkLst>
        </pc:picChg>
        <pc:picChg chg="add mod topLvl modCrop">
          <ac:chgData name="JUAN MANUEL LOZANO GIL" userId="618ed11e-cb2c-4b03-8ac9-a8cf52f924c9" providerId="ADAL" clId="{386DC46B-41D5-40B2-A6A2-885422854031}" dt="2022-10-20T13:59:45.783" v="92" actId="164"/>
          <ac:picMkLst>
            <pc:docMk/>
            <pc:sldMk cId="3278798907" sldId="256"/>
            <ac:picMk id="141" creationId="{1673B805-7289-9CBC-0B85-F86E9AD16D75}"/>
          </ac:picMkLst>
        </pc:picChg>
        <pc:picChg chg="add del mod modCrop">
          <ac:chgData name="JUAN MANUEL LOZANO GIL" userId="618ed11e-cb2c-4b03-8ac9-a8cf52f924c9" providerId="ADAL" clId="{386DC46B-41D5-40B2-A6A2-885422854031}" dt="2022-10-20T13:58:56.263" v="76" actId="478"/>
          <ac:picMkLst>
            <pc:docMk/>
            <pc:sldMk cId="3278798907" sldId="256"/>
            <ac:picMk id="143" creationId="{C60DE01D-1D51-EFAF-5485-D4F0761E65B1}"/>
          </ac:picMkLst>
        </pc:picChg>
        <pc:picChg chg="add del mod modCrop">
          <ac:chgData name="JUAN MANUEL LOZANO GIL" userId="618ed11e-cb2c-4b03-8ac9-a8cf52f924c9" providerId="ADAL" clId="{386DC46B-41D5-40B2-A6A2-885422854031}" dt="2022-10-20T14:20:22.297" v="191" actId="478"/>
          <ac:picMkLst>
            <pc:docMk/>
            <pc:sldMk cId="3278798907" sldId="256"/>
            <ac:picMk id="190" creationId="{4E17EBA7-C687-5A50-499B-7F7362422C3C}"/>
          </ac:picMkLst>
        </pc:picChg>
        <pc:picChg chg="add del mod modCrop">
          <ac:chgData name="JUAN MANUEL LOZANO GIL" userId="618ed11e-cb2c-4b03-8ac9-a8cf52f924c9" providerId="ADAL" clId="{386DC46B-41D5-40B2-A6A2-885422854031}" dt="2022-10-20T14:19:57.053" v="185" actId="478"/>
          <ac:picMkLst>
            <pc:docMk/>
            <pc:sldMk cId="3278798907" sldId="256"/>
            <ac:picMk id="192" creationId="{8818FEEF-C691-BAA6-B7C2-545A691C844D}"/>
          </ac:picMkLst>
        </pc:picChg>
        <pc:picChg chg="add del mod">
          <ac:chgData name="JUAN MANUEL LOZANO GIL" userId="618ed11e-cb2c-4b03-8ac9-a8cf52f924c9" providerId="ADAL" clId="{386DC46B-41D5-40B2-A6A2-885422854031}" dt="2022-10-20T14:20:50.717" v="203" actId="478"/>
          <ac:picMkLst>
            <pc:docMk/>
            <pc:sldMk cId="3278798907" sldId="256"/>
            <ac:picMk id="216" creationId="{FADE502A-C796-80C4-8B2F-A25267386B5C}"/>
          </ac:picMkLst>
        </pc:picChg>
        <pc:picChg chg="add mod modCrop">
          <ac:chgData name="JUAN MANUEL LOZANO GIL" userId="618ed11e-cb2c-4b03-8ac9-a8cf52f924c9" providerId="ADAL" clId="{386DC46B-41D5-40B2-A6A2-885422854031}" dt="2022-10-20T14:23:30.651" v="319" actId="14100"/>
          <ac:picMkLst>
            <pc:docMk/>
            <pc:sldMk cId="3278798907" sldId="256"/>
            <ac:picMk id="232" creationId="{7BC3BC16-7FDE-9D23-EB8A-C1AA2A61F864}"/>
          </ac:picMkLst>
        </pc:pic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9" creationId="{129E63B4-C489-BEB8-4402-11F892A8CF0B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1" creationId="{2BD03A2C-A553-B425-123C-509BB86E89A9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4" creationId="{B64A0862-3398-A01B-21DE-6E3E5F4799EF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4" creationId="{E9A25BB7-3C06-F81F-C768-BB81B8DBCCCA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5" creationId="{78C4AB6F-D797-1CFE-3B4A-E15CBF255F8B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5" creationId="{A4080079-AD9E-5200-A6BF-09E2A2964522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6" creationId="{8ED8A38E-CC84-360C-366C-FA96E46AE39E}"/>
          </ac:cxnSpMkLst>
        </pc:cxnChg>
        <pc:cxnChg chg="mod topLvl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138" creationId="{8839E733-E7A2-2B25-2A5F-F486A05DED28}"/>
          </ac:cxnSpMkLst>
        </pc:cxnChg>
        <pc:cxnChg chg="del">
          <ac:chgData name="JUAN MANUEL LOZANO GIL" userId="618ed11e-cb2c-4b03-8ac9-a8cf52f924c9" providerId="ADAL" clId="{386DC46B-41D5-40B2-A6A2-885422854031}" dt="2022-10-24T11:16:44.388" v="332" actId="478"/>
          <ac:cxnSpMkLst>
            <pc:docMk/>
            <pc:sldMk cId="3278798907" sldId="256"/>
            <ac:cxnSpMk id="148" creationId="{5E930379-6189-979C-5E84-A530AF605BD7}"/>
          </ac:cxnSpMkLst>
        </pc:cxnChg>
        <pc:cxnChg chg="del">
          <ac:chgData name="JUAN MANUEL LOZANO GIL" userId="618ed11e-cb2c-4b03-8ac9-a8cf52f924c9" providerId="ADAL" clId="{386DC46B-41D5-40B2-A6A2-885422854031}" dt="2022-10-24T11:16:48.839" v="333" actId="478"/>
          <ac:cxnSpMkLst>
            <pc:docMk/>
            <pc:sldMk cId="3278798907" sldId="256"/>
            <ac:cxnSpMk id="149" creationId="{8AB3ECD2-8851-D907-CED5-8BD60E743663}"/>
          </ac:cxnSpMkLst>
        </pc:cxnChg>
        <pc:cxnChg chg="mod">
          <ac:chgData name="JUAN MANUEL LOZANO GIL" userId="618ed11e-cb2c-4b03-8ac9-a8cf52f924c9" providerId="ADAL" clId="{386DC46B-41D5-40B2-A6A2-885422854031}" dt="2022-10-20T14:20:28.053" v="194"/>
          <ac:cxnSpMkLst>
            <pc:docMk/>
            <pc:sldMk cId="3278798907" sldId="256"/>
            <ac:cxnSpMk id="192" creationId="{740BA44F-D247-349E-363F-65A0FDBE4E40}"/>
          </ac:cxnSpMkLst>
        </pc:cxnChg>
        <pc:cxnChg chg="del mod topLvl">
          <ac:chgData name="JUAN MANUEL LOZANO GIL" userId="618ed11e-cb2c-4b03-8ac9-a8cf52f924c9" providerId="ADAL" clId="{386DC46B-41D5-40B2-A6A2-885422854031}" dt="2022-10-20T14:20:02.262" v="187" actId="478"/>
          <ac:cxnSpMkLst>
            <pc:docMk/>
            <pc:sldMk cId="3278798907" sldId="256"/>
            <ac:cxnSpMk id="194" creationId="{A6B1F438-7625-EA37-EBAA-78AB3CD935A7}"/>
          </ac:cxnSpMkLst>
        </pc:cxnChg>
        <pc:cxnChg chg="mod">
          <ac:chgData name="JUAN MANUEL LOZANO GIL" userId="618ed11e-cb2c-4b03-8ac9-a8cf52f924c9" providerId="ADAL" clId="{386DC46B-41D5-40B2-A6A2-885422854031}" dt="2022-10-20T14:20:28.053" v="194"/>
          <ac:cxnSpMkLst>
            <pc:docMk/>
            <pc:sldMk cId="3278798907" sldId="256"/>
            <ac:cxnSpMk id="195" creationId="{7078B968-C719-5F90-98A2-8D1838D02E9A}"/>
          </ac:cxnSpMkLst>
        </pc:cxnChg>
        <pc:cxnChg chg="del mod topLvl">
          <ac:chgData name="JUAN MANUEL LOZANO GIL" userId="618ed11e-cb2c-4b03-8ac9-a8cf52f924c9" providerId="ADAL" clId="{386DC46B-41D5-40B2-A6A2-885422854031}" dt="2022-10-20T14:20:13.054" v="188" actId="478"/>
          <ac:cxnSpMkLst>
            <pc:docMk/>
            <pc:sldMk cId="3278798907" sldId="256"/>
            <ac:cxnSpMk id="195" creationId="{B4DE5BC2-C833-4E73-E519-D684AF91B74E}"/>
          </ac:cxnSpMkLst>
        </pc:cxnChg>
        <pc:cxnChg chg="del mod topLvl">
          <ac:chgData name="JUAN MANUEL LOZANO GIL" userId="618ed11e-cb2c-4b03-8ac9-a8cf52f924c9" providerId="ADAL" clId="{386DC46B-41D5-40B2-A6A2-885422854031}" dt="2022-10-20T14:20:25.661" v="193" actId="478"/>
          <ac:cxnSpMkLst>
            <pc:docMk/>
            <pc:sldMk cId="3278798907" sldId="256"/>
            <ac:cxnSpMk id="196" creationId="{8D65A4A8-5958-C746-4B6B-D66D3DB6637A}"/>
          </ac:cxnSpMkLst>
        </pc:cxnChg>
        <pc:cxnChg chg="del mod topLvl">
          <ac:chgData name="JUAN MANUEL LOZANO GIL" userId="618ed11e-cb2c-4b03-8ac9-a8cf52f924c9" providerId="ADAL" clId="{386DC46B-41D5-40B2-A6A2-885422854031}" dt="2022-10-20T14:20:25.661" v="193" actId="478"/>
          <ac:cxnSpMkLst>
            <pc:docMk/>
            <pc:sldMk cId="3278798907" sldId="256"/>
            <ac:cxnSpMk id="197" creationId="{F0A4E756-499D-65B5-68E6-FFADEEA7B231}"/>
          </ac:cxnSpMkLst>
        </pc:cxnChg>
        <pc:cxnChg chg="mod">
          <ac:chgData name="JUAN MANUEL LOZANO GIL" userId="618ed11e-cb2c-4b03-8ac9-a8cf52f924c9" providerId="ADAL" clId="{386DC46B-41D5-40B2-A6A2-885422854031}" dt="2022-10-20T14:20:28.053" v="194"/>
          <ac:cxnSpMkLst>
            <pc:docMk/>
            <pc:sldMk cId="3278798907" sldId="256"/>
            <ac:cxnSpMk id="198" creationId="{4EBF6361-0149-0467-B190-B5CD93833555}"/>
          </ac:cxnSpMkLst>
        </pc:cxnChg>
        <pc:cxnChg chg="add del mod topLvl">
          <ac:chgData name="JUAN MANUEL LOZANO GIL" userId="618ed11e-cb2c-4b03-8ac9-a8cf52f924c9" providerId="ADAL" clId="{386DC46B-41D5-40B2-A6A2-885422854031}" dt="2022-10-20T14:20:25.661" v="193" actId="478"/>
          <ac:cxnSpMkLst>
            <pc:docMk/>
            <pc:sldMk cId="3278798907" sldId="256"/>
            <ac:cxnSpMk id="198" creationId="{4FCD0DE1-E132-B1A4-BC6E-F5DBCB42F827}"/>
          </ac:cxnSpMkLst>
        </pc:cxnChg>
        <pc:cxnChg chg="mod">
          <ac:chgData name="JUAN MANUEL LOZANO GIL" userId="618ed11e-cb2c-4b03-8ac9-a8cf52f924c9" providerId="ADAL" clId="{386DC46B-41D5-40B2-A6A2-885422854031}" dt="2022-10-20T14:21:16.947" v="231" actId="1036"/>
          <ac:cxnSpMkLst>
            <pc:docMk/>
            <pc:sldMk cId="3278798907" sldId="256"/>
            <ac:cxnSpMk id="200" creationId="{9EF16A84-0776-03ED-FF8A-4557944FE18D}"/>
          </ac:cxnSpMkLst>
        </pc:cxnChg>
        <pc:cxnChg chg="del mod">
          <ac:chgData name="JUAN MANUEL LOZANO GIL" userId="618ed11e-cb2c-4b03-8ac9-a8cf52f924c9" providerId="ADAL" clId="{386DC46B-41D5-40B2-A6A2-885422854031}" dt="2022-10-20T14:21:24.027" v="235" actId="478"/>
          <ac:cxnSpMkLst>
            <pc:docMk/>
            <pc:sldMk cId="3278798907" sldId="256"/>
            <ac:cxnSpMk id="209" creationId="{9592F787-88C9-B5B5-5C55-D64A77394EBB}"/>
          </ac:cxnSpMkLst>
        </pc:cxnChg>
        <pc:cxnChg chg="del mod">
          <ac:chgData name="JUAN MANUEL LOZANO GIL" userId="618ed11e-cb2c-4b03-8ac9-a8cf52f924c9" providerId="ADAL" clId="{386DC46B-41D5-40B2-A6A2-885422854031}" dt="2022-10-20T14:23:38.259" v="323" actId="478"/>
          <ac:cxnSpMkLst>
            <pc:docMk/>
            <pc:sldMk cId="3278798907" sldId="256"/>
            <ac:cxnSpMk id="230" creationId="{4CCB1181-6F37-6FD6-7A50-5CE1DC5D2253}"/>
          </ac:cxnSpMkLst>
        </pc:cxnChg>
        <pc:cxnChg chg="add mod">
          <ac:chgData name="JUAN MANUEL LOZANO GIL" userId="618ed11e-cb2c-4b03-8ac9-a8cf52f924c9" providerId="ADAL" clId="{386DC46B-41D5-40B2-A6A2-885422854031}" dt="2022-10-20T14:00:25.512" v="112" actId="164"/>
          <ac:cxnSpMkLst>
            <pc:docMk/>
            <pc:sldMk cId="3278798907" sldId="256"/>
            <ac:cxnSpMk id="243" creationId="{26892D6D-7238-9454-402A-4E8F4570AED3}"/>
          </ac:cxnSpMkLst>
        </pc:cxnChg>
        <pc:cxnChg chg="mod">
          <ac:chgData name="JUAN MANUEL LOZANO GIL" userId="618ed11e-cb2c-4b03-8ac9-a8cf52f924c9" providerId="ADAL" clId="{386DC46B-41D5-40B2-A6A2-885422854031}" dt="2022-10-20T14:23:01.313" v="272"/>
          <ac:cxnSpMkLst>
            <pc:docMk/>
            <pc:sldMk cId="3278798907" sldId="256"/>
            <ac:cxnSpMk id="245" creationId="{9F798C0C-085F-8D3B-9973-0DFBC15AF3C1}"/>
          </ac:cxnSpMkLst>
        </pc:cxnChg>
        <pc:cxnChg chg="mod">
          <ac:chgData name="JUAN MANUEL LOZANO GIL" userId="618ed11e-cb2c-4b03-8ac9-a8cf52f924c9" providerId="ADAL" clId="{386DC46B-41D5-40B2-A6A2-885422854031}" dt="2022-10-20T14:23:01.313" v="272"/>
          <ac:cxnSpMkLst>
            <pc:docMk/>
            <pc:sldMk cId="3278798907" sldId="256"/>
            <ac:cxnSpMk id="246" creationId="{C5E3D796-EBC5-4C7E-5166-143FFDE1E54A}"/>
          </ac:cxnSpMkLst>
        </pc:cxnChg>
        <pc:cxnChg chg="mod">
          <ac:chgData name="JUAN MANUEL LOZANO GIL" userId="618ed11e-cb2c-4b03-8ac9-a8cf52f924c9" providerId="ADAL" clId="{386DC46B-41D5-40B2-A6A2-885422854031}" dt="2022-10-20T14:23:01.313" v="272"/>
          <ac:cxnSpMkLst>
            <pc:docMk/>
            <pc:sldMk cId="3278798907" sldId="256"/>
            <ac:cxnSpMk id="248" creationId="{D8F2E568-C835-B0D9-E410-6601636066DE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1" creationId="{610CCD66-D71C-AB67-0FBA-32853F4BD5BC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2" creationId="{FC3D38EF-0FDA-08E4-9171-BA04F555060C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3" creationId="{E4CEA6A9-4A46-3009-7332-E8ECD66177FD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4" creationId="{5E930379-6189-979C-5E84-A530AF605BD7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5" creationId="{8AB3ECD2-8851-D907-CED5-8BD60E743663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65751-9B9B-43A8-8312-F0499DA98BA6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06C5EC-28AC-4C1D-A4C5-CB6449FE3E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19351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06C5EC-28AC-4C1D-A4C5-CB6449FE3EF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6088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06C5EC-28AC-4C1D-A4C5-CB6449FE3EF8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84789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5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8480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7231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3963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1954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4350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2965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9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9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5490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7544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3839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3576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8390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3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8211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DA79CEE9-4154-4345-0082-E0FDD816AC9F}"/>
              </a:ext>
            </a:extLst>
          </p:cNvPr>
          <p:cNvGrpSpPr/>
          <p:nvPr/>
        </p:nvGrpSpPr>
        <p:grpSpPr>
          <a:xfrm>
            <a:off x="2934418" y="782119"/>
            <a:ext cx="1928419" cy="681598"/>
            <a:chOff x="4163523" y="606588"/>
            <a:chExt cx="1845291" cy="681598"/>
          </a:xfrm>
        </p:grpSpPr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2449F1DD-CECE-3598-AF4C-0848DDC690F8}"/>
                </a:ext>
              </a:extLst>
            </p:cNvPr>
            <p:cNvSpPr txBox="1"/>
            <p:nvPr/>
          </p:nvSpPr>
          <p:spPr>
            <a:xfrm rot="16200000">
              <a:off x="4394746" y="858132"/>
              <a:ext cx="5831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/>
                <a:t>Empty</a:t>
              </a:r>
              <a:endParaRPr lang="es-ES" sz="1200" dirty="0"/>
            </a:p>
          </p:txBody>
        </p: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1FB04A87-AF0E-0D46-4E69-1951635CAFCE}"/>
                </a:ext>
              </a:extLst>
            </p:cNvPr>
            <p:cNvSpPr txBox="1"/>
            <p:nvPr/>
          </p:nvSpPr>
          <p:spPr>
            <a:xfrm rot="16200000">
              <a:off x="4006910" y="842578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/>
                <a:t>NLRP1</a:t>
              </a:r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4576F8D6-3239-5101-0049-56FEB64BC72E}"/>
                </a:ext>
              </a:extLst>
            </p:cNvPr>
            <p:cNvSpPr txBox="1"/>
            <p:nvPr/>
          </p:nvSpPr>
          <p:spPr>
            <a:xfrm rot="16200000">
              <a:off x="4858518" y="751180"/>
              <a:ext cx="61908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/>
                <a:t>NLRP1 </a:t>
              </a:r>
            </a:p>
            <a:p>
              <a:r>
                <a:rPr lang="es-ES" sz="1100" dirty="0"/>
                <a:t>S1213A</a:t>
              </a: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2BE4D7E7-4A36-82CA-F6A2-9DB24E5F032A}"/>
                </a:ext>
              </a:extLst>
            </p:cNvPr>
            <p:cNvSpPr txBox="1"/>
            <p:nvPr/>
          </p:nvSpPr>
          <p:spPr>
            <a:xfrm rot="16200000">
              <a:off x="5367933" y="647305"/>
              <a:ext cx="68159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dirty="0"/>
                <a:t>NLRP1 </a:t>
              </a:r>
            </a:p>
            <a:p>
              <a:r>
                <a:rPr lang="es-ES" sz="1100" dirty="0" err="1"/>
                <a:t>delCARD</a:t>
              </a:r>
              <a:endParaRPr lang="es-ES" sz="1100" dirty="0"/>
            </a:p>
            <a:p>
              <a:r>
                <a:rPr lang="es-ES" sz="1100" dirty="0" err="1"/>
                <a:t>delPYD</a:t>
              </a:r>
              <a:endParaRPr lang="es-ES" sz="1100" dirty="0"/>
            </a:p>
          </p:txBody>
        </p:sp>
      </p:grpSp>
      <p:pic>
        <p:nvPicPr>
          <p:cNvPr id="10" name="Imagen 9" descr="Interfaz de usuario gráfica, Aplicación&#10;&#10;Descripción generada automáticamente">
            <a:extLst>
              <a:ext uri="{FF2B5EF4-FFF2-40B4-BE49-F238E27FC236}">
                <a16:creationId xmlns:a16="http://schemas.microsoft.com/office/drawing/2014/main" id="{5C61654F-30BF-8BC9-C723-0517D33C19C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24" r="36664"/>
          <a:stretch/>
        </p:blipFill>
        <p:spPr>
          <a:xfrm>
            <a:off x="2684716" y="1463717"/>
            <a:ext cx="2178122" cy="4257675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1" name="Grupo 10">
            <a:extLst>
              <a:ext uri="{FF2B5EF4-FFF2-40B4-BE49-F238E27FC236}">
                <a16:creationId xmlns:a16="http://schemas.microsoft.com/office/drawing/2014/main" id="{C11BA16E-4008-DBF6-8E1B-61B0AAEB43C3}"/>
              </a:ext>
            </a:extLst>
          </p:cNvPr>
          <p:cNvGrpSpPr/>
          <p:nvPr/>
        </p:nvGrpSpPr>
        <p:grpSpPr>
          <a:xfrm>
            <a:off x="1017173" y="2460264"/>
            <a:ext cx="1520873" cy="1902266"/>
            <a:chOff x="4546510" y="3245884"/>
            <a:chExt cx="724737" cy="958650"/>
          </a:xfrm>
        </p:grpSpPr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4318F879-FA0F-8A3C-E63B-6E1BB93BD855}"/>
                </a:ext>
              </a:extLst>
            </p:cNvPr>
            <p:cNvGrpSpPr/>
            <p:nvPr/>
          </p:nvGrpSpPr>
          <p:grpSpPr>
            <a:xfrm>
              <a:off x="4999647" y="3336556"/>
              <a:ext cx="271600" cy="794833"/>
              <a:chOff x="4999647" y="3336556"/>
              <a:chExt cx="271600" cy="794833"/>
            </a:xfrm>
          </p:grpSpPr>
          <p:cxnSp>
            <p:nvCxnSpPr>
              <p:cNvPr id="28" name="Conector recto 27">
                <a:extLst>
                  <a:ext uri="{FF2B5EF4-FFF2-40B4-BE49-F238E27FC236}">
                    <a16:creationId xmlns:a16="http://schemas.microsoft.com/office/drawing/2014/main" id="{43262B23-BAF6-51EE-5C06-DBC0D42267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3655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ector recto 30">
                <a:extLst>
                  <a:ext uri="{FF2B5EF4-FFF2-40B4-BE49-F238E27FC236}">
                    <a16:creationId xmlns:a16="http://schemas.microsoft.com/office/drawing/2014/main" id="{97980C53-1FC6-BD12-B589-389F629DF5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ector recto 32">
                <a:extLst>
                  <a:ext uri="{FF2B5EF4-FFF2-40B4-BE49-F238E27FC236}">
                    <a16:creationId xmlns:a16="http://schemas.microsoft.com/office/drawing/2014/main" id="{E22E2640-9D8C-7063-0358-6C20D61715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ector recto 33">
                <a:extLst>
                  <a:ext uri="{FF2B5EF4-FFF2-40B4-BE49-F238E27FC236}">
                    <a16:creationId xmlns:a16="http://schemas.microsoft.com/office/drawing/2014/main" id="{69D1E20C-8247-0918-11B1-B305D97927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35" name="Conector recto 34">
                <a:extLst>
                  <a:ext uri="{FF2B5EF4-FFF2-40B4-BE49-F238E27FC236}">
                    <a16:creationId xmlns:a16="http://schemas.microsoft.com/office/drawing/2014/main" id="{B398A1FB-251C-09C3-C802-10BB3834E73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ector recto 35">
                <a:extLst>
                  <a:ext uri="{FF2B5EF4-FFF2-40B4-BE49-F238E27FC236}">
                    <a16:creationId xmlns:a16="http://schemas.microsoft.com/office/drawing/2014/main" id="{F5DA832A-91F2-CDEF-DBAA-415440F53E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47BD6571-2757-D96F-6834-65C8E84335E6}"/>
                </a:ext>
              </a:extLst>
            </p:cNvPr>
            <p:cNvSpPr txBox="1"/>
            <p:nvPr/>
          </p:nvSpPr>
          <p:spPr>
            <a:xfrm>
              <a:off x="4546510" y="3245884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82kDa</a:t>
              </a: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588D2D9C-C17A-09EB-F3DC-5A5790C5C1F6}"/>
                </a:ext>
              </a:extLst>
            </p:cNvPr>
            <p:cNvSpPr txBox="1"/>
            <p:nvPr/>
          </p:nvSpPr>
          <p:spPr>
            <a:xfrm>
              <a:off x="4546510" y="3419650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16kDa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60378545-1721-7E35-DBE1-510F713F4B33}"/>
                </a:ext>
              </a:extLst>
            </p:cNvPr>
            <p:cNvSpPr txBox="1"/>
            <p:nvPr/>
          </p:nvSpPr>
          <p:spPr>
            <a:xfrm>
              <a:off x="4594771" y="355911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00026D50-AB2B-CBB2-166B-AEC4F5271D20}"/>
                </a:ext>
              </a:extLst>
            </p:cNvPr>
            <p:cNvSpPr txBox="1"/>
            <p:nvPr/>
          </p:nvSpPr>
          <p:spPr>
            <a:xfrm>
              <a:off x="4595360" y="371931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6BE43327-C2C8-B486-E4B2-04A2AC0CA231}"/>
                </a:ext>
              </a:extLst>
            </p:cNvPr>
            <p:cNvSpPr txBox="1"/>
            <p:nvPr/>
          </p:nvSpPr>
          <p:spPr>
            <a:xfrm>
              <a:off x="4594769" y="3853888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139A7994-DF7F-AFB9-FA6A-A8D0B054E40B}"/>
                </a:ext>
              </a:extLst>
            </p:cNvPr>
            <p:cNvSpPr txBox="1"/>
            <p:nvPr/>
          </p:nvSpPr>
          <p:spPr>
            <a:xfrm>
              <a:off x="4595360" y="401387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</p:grpSp>
      <p:pic>
        <p:nvPicPr>
          <p:cNvPr id="39" name="Imagen 38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E8B83790-B132-40A1-2C16-C45DD1B212E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56" r="27231"/>
          <a:stretch/>
        </p:blipFill>
        <p:spPr>
          <a:xfrm>
            <a:off x="2669996" y="6012947"/>
            <a:ext cx="2178122" cy="4725515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44" name="Grupo 43">
            <a:extLst>
              <a:ext uri="{FF2B5EF4-FFF2-40B4-BE49-F238E27FC236}">
                <a16:creationId xmlns:a16="http://schemas.microsoft.com/office/drawing/2014/main" id="{A9D05679-6A73-8700-4564-4570AB89C06A}"/>
              </a:ext>
            </a:extLst>
          </p:cNvPr>
          <p:cNvGrpSpPr/>
          <p:nvPr/>
        </p:nvGrpSpPr>
        <p:grpSpPr>
          <a:xfrm>
            <a:off x="1129347" y="6966740"/>
            <a:ext cx="1520873" cy="1902266"/>
            <a:chOff x="4546510" y="3245884"/>
            <a:chExt cx="724737" cy="958650"/>
          </a:xfrm>
        </p:grpSpPr>
        <p:grpSp>
          <p:nvGrpSpPr>
            <p:cNvPr id="47" name="Grupo 46">
              <a:extLst>
                <a:ext uri="{FF2B5EF4-FFF2-40B4-BE49-F238E27FC236}">
                  <a16:creationId xmlns:a16="http://schemas.microsoft.com/office/drawing/2014/main" id="{7D63D47F-D66B-0966-D19E-11C108B2B7CE}"/>
                </a:ext>
              </a:extLst>
            </p:cNvPr>
            <p:cNvGrpSpPr/>
            <p:nvPr/>
          </p:nvGrpSpPr>
          <p:grpSpPr>
            <a:xfrm>
              <a:off x="4999647" y="3336556"/>
              <a:ext cx="271600" cy="794833"/>
              <a:chOff x="4999647" y="3336556"/>
              <a:chExt cx="271600" cy="794833"/>
            </a:xfrm>
          </p:grpSpPr>
          <p:cxnSp>
            <p:nvCxnSpPr>
              <p:cNvPr id="60" name="Conector recto 59">
                <a:extLst>
                  <a:ext uri="{FF2B5EF4-FFF2-40B4-BE49-F238E27FC236}">
                    <a16:creationId xmlns:a16="http://schemas.microsoft.com/office/drawing/2014/main" id="{FE7CE5E2-37FE-E845-F95A-CFDFDDD8F7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3655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ector recto 60">
                <a:extLst>
                  <a:ext uri="{FF2B5EF4-FFF2-40B4-BE49-F238E27FC236}">
                    <a16:creationId xmlns:a16="http://schemas.microsoft.com/office/drawing/2014/main" id="{28B656FE-E2BC-A269-FDDB-2C22180E7E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ector recto 61">
                <a:extLst>
                  <a:ext uri="{FF2B5EF4-FFF2-40B4-BE49-F238E27FC236}">
                    <a16:creationId xmlns:a16="http://schemas.microsoft.com/office/drawing/2014/main" id="{ABA294BD-FEAB-8FFD-F477-36193F97B2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ector recto 62">
                <a:extLst>
                  <a:ext uri="{FF2B5EF4-FFF2-40B4-BE49-F238E27FC236}">
                    <a16:creationId xmlns:a16="http://schemas.microsoft.com/office/drawing/2014/main" id="{B2164A84-3EB7-528D-C5B6-62C0F8A2E9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64" name="Conector recto 63">
                <a:extLst>
                  <a:ext uri="{FF2B5EF4-FFF2-40B4-BE49-F238E27FC236}">
                    <a16:creationId xmlns:a16="http://schemas.microsoft.com/office/drawing/2014/main" id="{13E73494-4E2E-D764-798B-A4C8C0A8F1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ector recto 65">
                <a:extLst>
                  <a:ext uri="{FF2B5EF4-FFF2-40B4-BE49-F238E27FC236}">
                    <a16:creationId xmlns:a16="http://schemas.microsoft.com/office/drawing/2014/main" id="{67EB34F5-EB20-22B9-08CB-096816D4AC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5D51998A-8FAF-CEE2-A74A-368C8EF9265B}"/>
                </a:ext>
              </a:extLst>
            </p:cNvPr>
            <p:cNvSpPr txBox="1"/>
            <p:nvPr/>
          </p:nvSpPr>
          <p:spPr>
            <a:xfrm>
              <a:off x="4546510" y="3245884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82kDa</a:t>
              </a:r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99F7541D-9967-ED2B-09DC-E2DAA8B05FC5}"/>
                </a:ext>
              </a:extLst>
            </p:cNvPr>
            <p:cNvSpPr txBox="1"/>
            <p:nvPr/>
          </p:nvSpPr>
          <p:spPr>
            <a:xfrm>
              <a:off x="4546510" y="3419650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16kDa</a:t>
              </a:r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D18CCFD7-E3E3-0C50-C6E9-0B0D1095284E}"/>
                </a:ext>
              </a:extLst>
            </p:cNvPr>
            <p:cNvSpPr txBox="1"/>
            <p:nvPr/>
          </p:nvSpPr>
          <p:spPr>
            <a:xfrm>
              <a:off x="4594771" y="355911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E702AD9D-EE90-AE7D-F771-EA6B46729DF9}"/>
                </a:ext>
              </a:extLst>
            </p:cNvPr>
            <p:cNvSpPr txBox="1"/>
            <p:nvPr/>
          </p:nvSpPr>
          <p:spPr>
            <a:xfrm>
              <a:off x="4595360" y="371931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A96EDE9E-A0F9-6EAE-0196-CD461473CB31}"/>
                </a:ext>
              </a:extLst>
            </p:cNvPr>
            <p:cNvSpPr txBox="1"/>
            <p:nvPr/>
          </p:nvSpPr>
          <p:spPr>
            <a:xfrm>
              <a:off x="4594769" y="3853888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C10F2C02-E4CB-FA78-A1AE-B5E3AA26FE86}"/>
                </a:ext>
              </a:extLst>
            </p:cNvPr>
            <p:cNvSpPr txBox="1"/>
            <p:nvPr/>
          </p:nvSpPr>
          <p:spPr>
            <a:xfrm>
              <a:off x="4595360" y="401387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</p:grpSp>
      <p:sp>
        <p:nvSpPr>
          <p:cNvPr id="67" name="CuadroTexto 66">
            <a:extLst>
              <a:ext uri="{FF2B5EF4-FFF2-40B4-BE49-F238E27FC236}">
                <a16:creationId xmlns:a16="http://schemas.microsoft.com/office/drawing/2014/main" id="{9F4214D0-BC19-637D-2C47-40F6FE1592AF}"/>
              </a:ext>
            </a:extLst>
          </p:cNvPr>
          <p:cNvSpPr txBox="1"/>
          <p:nvPr/>
        </p:nvSpPr>
        <p:spPr>
          <a:xfrm>
            <a:off x="4937202" y="3270980"/>
            <a:ext cx="1039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NLRP1 (FLAG)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BEAB7F0B-25D9-0ADB-6C9A-95DD5C1EA3A5}"/>
              </a:ext>
            </a:extLst>
          </p:cNvPr>
          <p:cNvSpPr txBox="1"/>
          <p:nvPr/>
        </p:nvSpPr>
        <p:spPr>
          <a:xfrm>
            <a:off x="4937202" y="7896214"/>
            <a:ext cx="68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LRRFIP1</a:t>
            </a: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6D478024-2D28-33B7-F3AA-225E5E6E2820}"/>
              </a:ext>
            </a:extLst>
          </p:cNvPr>
          <p:cNvSpPr txBox="1"/>
          <p:nvPr/>
        </p:nvSpPr>
        <p:spPr>
          <a:xfrm>
            <a:off x="3336006" y="219722"/>
            <a:ext cx="973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IP FLAG:</a:t>
            </a: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D58F52B1-25D4-4FD1-9952-03F0C4AE1DA0}"/>
              </a:ext>
            </a:extLst>
          </p:cNvPr>
          <p:cNvSpPr/>
          <p:nvPr/>
        </p:nvSpPr>
        <p:spPr>
          <a:xfrm>
            <a:off x="2660872" y="2326359"/>
            <a:ext cx="2178122" cy="94462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B29970A1-692B-1C31-9F2A-493FC1B48498}"/>
              </a:ext>
            </a:extLst>
          </p:cNvPr>
          <p:cNvSpPr/>
          <p:nvPr/>
        </p:nvSpPr>
        <p:spPr>
          <a:xfrm>
            <a:off x="2674756" y="6683597"/>
            <a:ext cx="2178122" cy="94462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8798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DA79CEE9-4154-4345-0082-E0FDD816AC9F}"/>
              </a:ext>
            </a:extLst>
          </p:cNvPr>
          <p:cNvGrpSpPr/>
          <p:nvPr/>
        </p:nvGrpSpPr>
        <p:grpSpPr>
          <a:xfrm>
            <a:off x="2849890" y="253265"/>
            <a:ext cx="1928419" cy="681598"/>
            <a:chOff x="4163523" y="606588"/>
            <a:chExt cx="1845291" cy="681598"/>
          </a:xfrm>
        </p:grpSpPr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2449F1DD-CECE-3598-AF4C-0848DDC690F8}"/>
                </a:ext>
              </a:extLst>
            </p:cNvPr>
            <p:cNvSpPr txBox="1"/>
            <p:nvPr/>
          </p:nvSpPr>
          <p:spPr>
            <a:xfrm rot="16200000">
              <a:off x="4394746" y="858132"/>
              <a:ext cx="5831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/>
                <a:t>Empty</a:t>
              </a:r>
              <a:endParaRPr lang="es-ES" sz="1200" dirty="0"/>
            </a:p>
          </p:txBody>
        </p: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1FB04A87-AF0E-0D46-4E69-1951635CAFCE}"/>
                </a:ext>
              </a:extLst>
            </p:cNvPr>
            <p:cNvSpPr txBox="1"/>
            <p:nvPr/>
          </p:nvSpPr>
          <p:spPr>
            <a:xfrm rot="16200000">
              <a:off x="4006910" y="842578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/>
                <a:t>NLRP1</a:t>
              </a:r>
            </a:p>
          </p:txBody>
        </p:sp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4576F8D6-3239-5101-0049-56FEB64BC72E}"/>
                </a:ext>
              </a:extLst>
            </p:cNvPr>
            <p:cNvSpPr txBox="1"/>
            <p:nvPr/>
          </p:nvSpPr>
          <p:spPr>
            <a:xfrm rot="16200000">
              <a:off x="4858518" y="751180"/>
              <a:ext cx="61908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/>
                <a:t>NLRP1 </a:t>
              </a:r>
            </a:p>
            <a:p>
              <a:r>
                <a:rPr lang="es-ES" sz="1100" dirty="0"/>
                <a:t>S1213A</a:t>
              </a: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2BE4D7E7-4A36-82CA-F6A2-9DB24E5F032A}"/>
                </a:ext>
              </a:extLst>
            </p:cNvPr>
            <p:cNvSpPr txBox="1"/>
            <p:nvPr/>
          </p:nvSpPr>
          <p:spPr>
            <a:xfrm rot="16200000">
              <a:off x="5367933" y="647305"/>
              <a:ext cx="68159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dirty="0"/>
                <a:t>NLRP1 </a:t>
              </a:r>
            </a:p>
            <a:p>
              <a:r>
                <a:rPr lang="es-ES" sz="1100" dirty="0" err="1"/>
                <a:t>delCARD</a:t>
              </a:r>
              <a:endParaRPr lang="es-ES" sz="1100" dirty="0"/>
            </a:p>
            <a:p>
              <a:r>
                <a:rPr lang="es-ES" sz="1100" dirty="0" err="1"/>
                <a:t>delPYD</a:t>
              </a:r>
              <a:endParaRPr lang="es-ES" sz="1100" dirty="0"/>
            </a:p>
          </p:txBody>
        </p:sp>
      </p:grpSp>
      <p:grpSp>
        <p:nvGrpSpPr>
          <p:cNvPr id="11" name="Grupo 10">
            <a:extLst>
              <a:ext uri="{FF2B5EF4-FFF2-40B4-BE49-F238E27FC236}">
                <a16:creationId xmlns:a16="http://schemas.microsoft.com/office/drawing/2014/main" id="{C11BA16E-4008-DBF6-8E1B-61B0AAEB43C3}"/>
              </a:ext>
            </a:extLst>
          </p:cNvPr>
          <p:cNvGrpSpPr/>
          <p:nvPr/>
        </p:nvGrpSpPr>
        <p:grpSpPr>
          <a:xfrm>
            <a:off x="932645" y="1931410"/>
            <a:ext cx="1520873" cy="1902266"/>
            <a:chOff x="4546510" y="3245884"/>
            <a:chExt cx="724737" cy="958650"/>
          </a:xfrm>
        </p:grpSpPr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4318F879-FA0F-8A3C-E63B-6E1BB93BD855}"/>
                </a:ext>
              </a:extLst>
            </p:cNvPr>
            <p:cNvGrpSpPr/>
            <p:nvPr/>
          </p:nvGrpSpPr>
          <p:grpSpPr>
            <a:xfrm>
              <a:off x="4999647" y="3336556"/>
              <a:ext cx="271600" cy="794833"/>
              <a:chOff x="4999647" y="3336556"/>
              <a:chExt cx="271600" cy="794833"/>
            </a:xfrm>
          </p:grpSpPr>
          <p:cxnSp>
            <p:nvCxnSpPr>
              <p:cNvPr id="28" name="Conector recto 27">
                <a:extLst>
                  <a:ext uri="{FF2B5EF4-FFF2-40B4-BE49-F238E27FC236}">
                    <a16:creationId xmlns:a16="http://schemas.microsoft.com/office/drawing/2014/main" id="{43262B23-BAF6-51EE-5C06-DBC0D42267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3655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ector recto 30">
                <a:extLst>
                  <a:ext uri="{FF2B5EF4-FFF2-40B4-BE49-F238E27FC236}">
                    <a16:creationId xmlns:a16="http://schemas.microsoft.com/office/drawing/2014/main" id="{97980C53-1FC6-BD12-B589-389F629DF5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ector recto 32">
                <a:extLst>
                  <a:ext uri="{FF2B5EF4-FFF2-40B4-BE49-F238E27FC236}">
                    <a16:creationId xmlns:a16="http://schemas.microsoft.com/office/drawing/2014/main" id="{E22E2640-9D8C-7063-0358-6C20D61715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ector recto 33">
                <a:extLst>
                  <a:ext uri="{FF2B5EF4-FFF2-40B4-BE49-F238E27FC236}">
                    <a16:creationId xmlns:a16="http://schemas.microsoft.com/office/drawing/2014/main" id="{69D1E20C-8247-0918-11B1-B305D97927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35" name="Conector recto 34">
                <a:extLst>
                  <a:ext uri="{FF2B5EF4-FFF2-40B4-BE49-F238E27FC236}">
                    <a16:creationId xmlns:a16="http://schemas.microsoft.com/office/drawing/2014/main" id="{B398A1FB-251C-09C3-C802-10BB3834E73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ector recto 35">
                <a:extLst>
                  <a:ext uri="{FF2B5EF4-FFF2-40B4-BE49-F238E27FC236}">
                    <a16:creationId xmlns:a16="http://schemas.microsoft.com/office/drawing/2014/main" id="{F5DA832A-91F2-CDEF-DBAA-415440F53E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47BD6571-2757-D96F-6834-65C8E84335E6}"/>
                </a:ext>
              </a:extLst>
            </p:cNvPr>
            <p:cNvSpPr txBox="1"/>
            <p:nvPr/>
          </p:nvSpPr>
          <p:spPr>
            <a:xfrm>
              <a:off x="4546510" y="3245884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82kDa</a:t>
              </a: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588D2D9C-C17A-09EB-F3DC-5A5790C5C1F6}"/>
                </a:ext>
              </a:extLst>
            </p:cNvPr>
            <p:cNvSpPr txBox="1"/>
            <p:nvPr/>
          </p:nvSpPr>
          <p:spPr>
            <a:xfrm>
              <a:off x="4546510" y="3419650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16kDa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60378545-1721-7E35-DBE1-510F713F4B33}"/>
                </a:ext>
              </a:extLst>
            </p:cNvPr>
            <p:cNvSpPr txBox="1"/>
            <p:nvPr/>
          </p:nvSpPr>
          <p:spPr>
            <a:xfrm>
              <a:off x="4594771" y="355911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00026D50-AB2B-CBB2-166B-AEC4F5271D20}"/>
                </a:ext>
              </a:extLst>
            </p:cNvPr>
            <p:cNvSpPr txBox="1"/>
            <p:nvPr/>
          </p:nvSpPr>
          <p:spPr>
            <a:xfrm>
              <a:off x="4595360" y="371931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6BE43327-C2C8-B486-E4B2-04A2AC0CA231}"/>
                </a:ext>
              </a:extLst>
            </p:cNvPr>
            <p:cNvSpPr txBox="1"/>
            <p:nvPr/>
          </p:nvSpPr>
          <p:spPr>
            <a:xfrm>
              <a:off x="4594769" y="3853888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139A7994-DF7F-AFB9-FA6A-A8D0B054E40B}"/>
                </a:ext>
              </a:extLst>
            </p:cNvPr>
            <p:cNvSpPr txBox="1"/>
            <p:nvPr/>
          </p:nvSpPr>
          <p:spPr>
            <a:xfrm>
              <a:off x="4595360" y="401387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</p:grpSp>
      <p:grpSp>
        <p:nvGrpSpPr>
          <p:cNvPr id="44" name="Grupo 43">
            <a:extLst>
              <a:ext uri="{FF2B5EF4-FFF2-40B4-BE49-F238E27FC236}">
                <a16:creationId xmlns:a16="http://schemas.microsoft.com/office/drawing/2014/main" id="{A9D05679-6A73-8700-4564-4570AB89C06A}"/>
              </a:ext>
            </a:extLst>
          </p:cNvPr>
          <p:cNvGrpSpPr/>
          <p:nvPr/>
        </p:nvGrpSpPr>
        <p:grpSpPr>
          <a:xfrm>
            <a:off x="1044819" y="6077073"/>
            <a:ext cx="1520873" cy="1902266"/>
            <a:chOff x="4546510" y="3245884"/>
            <a:chExt cx="724737" cy="958650"/>
          </a:xfrm>
        </p:grpSpPr>
        <p:grpSp>
          <p:nvGrpSpPr>
            <p:cNvPr id="47" name="Grupo 46">
              <a:extLst>
                <a:ext uri="{FF2B5EF4-FFF2-40B4-BE49-F238E27FC236}">
                  <a16:creationId xmlns:a16="http://schemas.microsoft.com/office/drawing/2014/main" id="{7D63D47F-D66B-0966-D19E-11C108B2B7CE}"/>
                </a:ext>
              </a:extLst>
            </p:cNvPr>
            <p:cNvGrpSpPr/>
            <p:nvPr/>
          </p:nvGrpSpPr>
          <p:grpSpPr>
            <a:xfrm>
              <a:off x="4999647" y="3336556"/>
              <a:ext cx="271600" cy="794833"/>
              <a:chOff x="4999647" y="3336556"/>
              <a:chExt cx="271600" cy="794833"/>
            </a:xfrm>
          </p:grpSpPr>
          <p:cxnSp>
            <p:nvCxnSpPr>
              <p:cNvPr id="60" name="Conector recto 59">
                <a:extLst>
                  <a:ext uri="{FF2B5EF4-FFF2-40B4-BE49-F238E27FC236}">
                    <a16:creationId xmlns:a16="http://schemas.microsoft.com/office/drawing/2014/main" id="{FE7CE5E2-37FE-E845-F95A-CFDFDDD8F7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3655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ector recto 60">
                <a:extLst>
                  <a:ext uri="{FF2B5EF4-FFF2-40B4-BE49-F238E27FC236}">
                    <a16:creationId xmlns:a16="http://schemas.microsoft.com/office/drawing/2014/main" id="{28B656FE-E2BC-A269-FDDB-2C22180E7E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ector recto 61">
                <a:extLst>
                  <a:ext uri="{FF2B5EF4-FFF2-40B4-BE49-F238E27FC236}">
                    <a16:creationId xmlns:a16="http://schemas.microsoft.com/office/drawing/2014/main" id="{ABA294BD-FEAB-8FFD-F477-36193F97B2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ector recto 62">
                <a:extLst>
                  <a:ext uri="{FF2B5EF4-FFF2-40B4-BE49-F238E27FC236}">
                    <a16:creationId xmlns:a16="http://schemas.microsoft.com/office/drawing/2014/main" id="{B2164A84-3EB7-528D-C5B6-62C0F8A2E9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64" name="Conector recto 63">
                <a:extLst>
                  <a:ext uri="{FF2B5EF4-FFF2-40B4-BE49-F238E27FC236}">
                    <a16:creationId xmlns:a16="http://schemas.microsoft.com/office/drawing/2014/main" id="{13E73494-4E2E-D764-798B-A4C8C0A8F1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ector recto 65">
                <a:extLst>
                  <a:ext uri="{FF2B5EF4-FFF2-40B4-BE49-F238E27FC236}">
                    <a16:creationId xmlns:a16="http://schemas.microsoft.com/office/drawing/2014/main" id="{67EB34F5-EB20-22B9-08CB-096816D4AC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5D51998A-8FAF-CEE2-A74A-368C8EF9265B}"/>
                </a:ext>
              </a:extLst>
            </p:cNvPr>
            <p:cNvSpPr txBox="1"/>
            <p:nvPr/>
          </p:nvSpPr>
          <p:spPr>
            <a:xfrm>
              <a:off x="4546510" y="3245884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82kDa</a:t>
              </a:r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99F7541D-9967-ED2B-09DC-E2DAA8B05FC5}"/>
                </a:ext>
              </a:extLst>
            </p:cNvPr>
            <p:cNvSpPr txBox="1"/>
            <p:nvPr/>
          </p:nvSpPr>
          <p:spPr>
            <a:xfrm>
              <a:off x="4546510" y="3419650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16kDa</a:t>
              </a:r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D18CCFD7-E3E3-0C50-C6E9-0B0D1095284E}"/>
                </a:ext>
              </a:extLst>
            </p:cNvPr>
            <p:cNvSpPr txBox="1"/>
            <p:nvPr/>
          </p:nvSpPr>
          <p:spPr>
            <a:xfrm>
              <a:off x="4594771" y="355911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E702AD9D-EE90-AE7D-F771-EA6B46729DF9}"/>
                </a:ext>
              </a:extLst>
            </p:cNvPr>
            <p:cNvSpPr txBox="1"/>
            <p:nvPr/>
          </p:nvSpPr>
          <p:spPr>
            <a:xfrm>
              <a:off x="4595360" y="371931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A96EDE9E-A0F9-6EAE-0196-CD461473CB31}"/>
                </a:ext>
              </a:extLst>
            </p:cNvPr>
            <p:cNvSpPr txBox="1"/>
            <p:nvPr/>
          </p:nvSpPr>
          <p:spPr>
            <a:xfrm>
              <a:off x="4594769" y="3853888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C10F2C02-E4CB-FA78-A1AE-B5E3AA26FE86}"/>
                </a:ext>
              </a:extLst>
            </p:cNvPr>
            <p:cNvSpPr txBox="1"/>
            <p:nvPr/>
          </p:nvSpPr>
          <p:spPr>
            <a:xfrm>
              <a:off x="4595360" y="401387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</p:grpSp>
      <p:sp>
        <p:nvSpPr>
          <p:cNvPr id="67" name="CuadroTexto 66">
            <a:extLst>
              <a:ext uri="{FF2B5EF4-FFF2-40B4-BE49-F238E27FC236}">
                <a16:creationId xmlns:a16="http://schemas.microsoft.com/office/drawing/2014/main" id="{9F4214D0-BC19-637D-2C47-40F6FE1592AF}"/>
              </a:ext>
            </a:extLst>
          </p:cNvPr>
          <p:cNvSpPr txBox="1"/>
          <p:nvPr/>
        </p:nvSpPr>
        <p:spPr>
          <a:xfrm>
            <a:off x="4852674" y="2742126"/>
            <a:ext cx="1039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NLRP1 (FLAG)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BEAB7F0B-25D9-0ADB-6C9A-95DD5C1EA3A5}"/>
              </a:ext>
            </a:extLst>
          </p:cNvPr>
          <p:cNvSpPr txBox="1"/>
          <p:nvPr/>
        </p:nvSpPr>
        <p:spPr>
          <a:xfrm>
            <a:off x="4852674" y="7006547"/>
            <a:ext cx="68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LRRFIP1</a:t>
            </a: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6D478024-2D28-33B7-F3AA-225E5E6E2820}"/>
              </a:ext>
            </a:extLst>
          </p:cNvPr>
          <p:cNvSpPr txBox="1"/>
          <p:nvPr/>
        </p:nvSpPr>
        <p:spPr>
          <a:xfrm>
            <a:off x="3401917" y="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INPUT</a:t>
            </a:r>
          </a:p>
        </p:txBody>
      </p:sp>
      <p:pic>
        <p:nvPicPr>
          <p:cNvPr id="8" name="Imagen 7" descr="Imagen que contiene Gráfico&#10;&#10;Descripción generada automáticamente">
            <a:extLst>
              <a:ext uri="{FF2B5EF4-FFF2-40B4-BE49-F238E27FC236}">
                <a16:creationId xmlns:a16="http://schemas.microsoft.com/office/drawing/2014/main" id="{6CD42F57-D85A-3418-84F4-E4C2E275FE2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82" t="9934" r="41138"/>
          <a:stretch/>
        </p:blipFill>
        <p:spPr>
          <a:xfrm>
            <a:off x="2600188" y="5414834"/>
            <a:ext cx="2252486" cy="42007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Imagen 12" descr="Imagen que contiene Diagrama&#10;&#10;Descripción generada automáticamente">
            <a:extLst>
              <a:ext uri="{FF2B5EF4-FFF2-40B4-BE49-F238E27FC236}">
                <a16:creationId xmlns:a16="http://schemas.microsoft.com/office/drawing/2014/main" id="{FAF2C1DA-ABEC-7D7E-DB00-41F0798A037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36" r="23059"/>
          <a:stretch/>
        </p:blipFill>
        <p:spPr>
          <a:xfrm>
            <a:off x="2697737" y="1009045"/>
            <a:ext cx="2080573" cy="42576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id="{4DE8302F-A29C-1C6F-7B39-B1A46263E36A}"/>
              </a:ext>
            </a:extLst>
          </p:cNvPr>
          <p:cNvSpPr/>
          <p:nvPr/>
        </p:nvSpPr>
        <p:spPr>
          <a:xfrm>
            <a:off x="2633768" y="1931410"/>
            <a:ext cx="2178122" cy="15848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756BD238-0BB0-8F35-B8FE-CFB8CA92B50B}"/>
              </a:ext>
            </a:extLst>
          </p:cNvPr>
          <p:cNvSpPr/>
          <p:nvPr/>
        </p:nvSpPr>
        <p:spPr>
          <a:xfrm>
            <a:off x="2692037" y="6030814"/>
            <a:ext cx="2178122" cy="66780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16" name="Imagen 15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D32079AA-14D2-706C-D158-6701211CC9F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540" t="28248" r="42017" b="24444"/>
          <a:stretch/>
        </p:blipFill>
        <p:spPr>
          <a:xfrm>
            <a:off x="2600188" y="9710310"/>
            <a:ext cx="2324802" cy="248169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7" name="Grupo 16">
            <a:extLst>
              <a:ext uri="{FF2B5EF4-FFF2-40B4-BE49-F238E27FC236}">
                <a16:creationId xmlns:a16="http://schemas.microsoft.com/office/drawing/2014/main" id="{BCF028EB-DAFC-EFC1-3DBF-27FE8C91643E}"/>
              </a:ext>
            </a:extLst>
          </p:cNvPr>
          <p:cNvGrpSpPr/>
          <p:nvPr/>
        </p:nvGrpSpPr>
        <p:grpSpPr>
          <a:xfrm>
            <a:off x="1150959" y="9733702"/>
            <a:ext cx="1419599" cy="1839571"/>
            <a:chOff x="4594769" y="3559114"/>
            <a:chExt cx="676477" cy="645420"/>
          </a:xfrm>
        </p:grpSpPr>
        <p:grpSp>
          <p:nvGrpSpPr>
            <p:cNvPr id="18" name="Grupo 17">
              <a:extLst>
                <a:ext uri="{FF2B5EF4-FFF2-40B4-BE49-F238E27FC236}">
                  <a16:creationId xmlns:a16="http://schemas.microsoft.com/office/drawing/2014/main" id="{6910A6F7-196C-EE88-5573-A0BEF8D58392}"/>
                </a:ext>
              </a:extLst>
            </p:cNvPr>
            <p:cNvGrpSpPr/>
            <p:nvPr/>
          </p:nvGrpSpPr>
          <p:grpSpPr>
            <a:xfrm>
              <a:off x="4999647" y="3649513"/>
              <a:ext cx="271599" cy="481876"/>
              <a:chOff x="4999647" y="3649513"/>
              <a:chExt cx="271599" cy="481876"/>
            </a:xfrm>
          </p:grpSpPr>
          <p:cxnSp>
            <p:nvCxnSpPr>
              <p:cNvPr id="38" name="Conector recto 37">
                <a:extLst>
                  <a:ext uri="{FF2B5EF4-FFF2-40B4-BE49-F238E27FC236}">
                    <a16:creationId xmlns:a16="http://schemas.microsoft.com/office/drawing/2014/main" id="{AF70B35C-4EE0-E8F9-D671-5868EF7C2A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ector recto 38">
                <a:extLst>
                  <a:ext uri="{FF2B5EF4-FFF2-40B4-BE49-F238E27FC236}">
                    <a16:creationId xmlns:a16="http://schemas.microsoft.com/office/drawing/2014/main" id="{09C1BE32-BAEC-A6E8-7E03-1663659CC8F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40" name="Conector recto 39">
                <a:extLst>
                  <a:ext uri="{FF2B5EF4-FFF2-40B4-BE49-F238E27FC236}">
                    <a16:creationId xmlns:a16="http://schemas.microsoft.com/office/drawing/2014/main" id="{11360832-570B-4FA9-4B9E-ED21D5414C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ector recto 40">
                <a:extLst>
                  <a:ext uri="{FF2B5EF4-FFF2-40B4-BE49-F238E27FC236}">
                    <a16:creationId xmlns:a16="http://schemas.microsoft.com/office/drawing/2014/main" id="{4FE8D7A6-9148-23E1-3FD4-6053848A3B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726F36D2-5E65-7FB6-60AC-137176448A07}"/>
                </a:ext>
              </a:extLst>
            </p:cNvPr>
            <p:cNvSpPr txBox="1"/>
            <p:nvPr/>
          </p:nvSpPr>
          <p:spPr>
            <a:xfrm>
              <a:off x="4594771" y="355911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B34A3CFC-6781-AD69-46D1-863FBEC0A5AF}"/>
                </a:ext>
              </a:extLst>
            </p:cNvPr>
            <p:cNvSpPr txBox="1"/>
            <p:nvPr/>
          </p:nvSpPr>
          <p:spPr>
            <a:xfrm>
              <a:off x="4595360" y="371931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56253F1E-0ABE-4ABA-D75E-BF16764FAA6C}"/>
                </a:ext>
              </a:extLst>
            </p:cNvPr>
            <p:cNvSpPr txBox="1"/>
            <p:nvPr/>
          </p:nvSpPr>
          <p:spPr>
            <a:xfrm>
              <a:off x="4594769" y="3853888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22B5B19C-86D7-D88E-5B91-EF93FEF5B546}"/>
                </a:ext>
              </a:extLst>
            </p:cNvPr>
            <p:cNvSpPr txBox="1"/>
            <p:nvPr/>
          </p:nvSpPr>
          <p:spPr>
            <a:xfrm>
              <a:off x="4595360" y="401387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</p:grpSp>
      <p:sp>
        <p:nvSpPr>
          <p:cNvPr id="42" name="CuadroTexto 41">
            <a:extLst>
              <a:ext uri="{FF2B5EF4-FFF2-40B4-BE49-F238E27FC236}">
                <a16:creationId xmlns:a16="http://schemas.microsoft.com/office/drawing/2014/main" id="{3E6FE829-1637-7C47-6CF3-0A31830D65E7}"/>
              </a:ext>
            </a:extLst>
          </p:cNvPr>
          <p:cNvSpPr txBox="1"/>
          <p:nvPr/>
        </p:nvSpPr>
        <p:spPr>
          <a:xfrm>
            <a:off x="5011323" y="11024561"/>
            <a:ext cx="5145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ACTB</a:t>
            </a:r>
          </a:p>
        </p:txBody>
      </p:sp>
      <p:sp>
        <p:nvSpPr>
          <p:cNvPr id="43" name="Rectángulo 42">
            <a:extLst>
              <a:ext uri="{FF2B5EF4-FFF2-40B4-BE49-F238E27FC236}">
                <a16:creationId xmlns:a16="http://schemas.microsoft.com/office/drawing/2014/main" id="{E12D15C7-7A9B-5896-94E4-6BE71DD7360F}"/>
              </a:ext>
            </a:extLst>
          </p:cNvPr>
          <p:cNvSpPr/>
          <p:nvPr/>
        </p:nvSpPr>
        <p:spPr>
          <a:xfrm>
            <a:off x="2633768" y="10733720"/>
            <a:ext cx="2178122" cy="66780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5007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1</TotalTime>
  <Words>59</Words>
  <Application>Microsoft Office PowerPoint</Application>
  <PresentationFormat>Panorámica</PresentationFormat>
  <Paragraphs>51</Paragraphs>
  <Slides>2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NUEL LOZANO GIL</dc:creator>
  <cp:lastModifiedBy>JUAN MANUEL LOZANO GIL</cp:lastModifiedBy>
  <cp:revision>1</cp:revision>
  <dcterms:created xsi:type="dcterms:W3CDTF">2022-10-20T13:34:47Z</dcterms:created>
  <dcterms:modified xsi:type="dcterms:W3CDTF">2023-07-19T16:19:35Z</dcterms:modified>
</cp:coreProperties>
</file>